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emf" ContentType="image/x-emf"/>
  <Default Extension="wdp" ContentType="image/vnd.ms-photo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92" r:id="rId3"/>
  </p:sldIdLst>
  <p:sldSz cx="6858000" cy="9906000" type="A4"/>
  <p:notesSz cx="6797675" cy="9925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50" userDrawn="1">
          <p15:clr>
            <a:srgbClr val="A4A3A4"/>
          </p15:clr>
        </p15:guide>
        <p15:guide id="3" pos="1178" userDrawn="1">
          <p15:clr>
            <a:srgbClr val="A4A3A4"/>
          </p15:clr>
        </p15:guide>
        <p15:guide id="5" pos="4221" userDrawn="1">
          <p15:clr>
            <a:srgbClr val="A4A3A4"/>
          </p15:clr>
        </p15:guide>
        <p15:guide id="6" orient="horz" pos="5956" userDrawn="1">
          <p15:clr>
            <a:srgbClr val="A4A3A4"/>
          </p15:clr>
        </p15:guide>
        <p15:guide id="7" pos="164" userDrawn="1">
          <p15:clr>
            <a:srgbClr val="A4A3A4"/>
          </p15:clr>
        </p15:guide>
        <p15:guide id="8" pos="41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6600"/>
    <a:srgbClr val="EECCF9"/>
    <a:srgbClr val="CCF9E8"/>
    <a:srgbClr val="FFFFFF"/>
    <a:srgbClr val="FFE0E0"/>
    <a:srgbClr val="EAE8E9"/>
    <a:srgbClr val="151515"/>
    <a:srgbClr val="FFFF00"/>
    <a:srgbClr val="FFC9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450" autoAdjust="0"/>
    <p:restoredTop sz="92781" autoAdjust="0"/>
  </p:normalViewPr>
  <p:slideViewPr>
    <p:cSldViewPr snapToGrid="0" showGuides="1">
      <p:cViewPr varScale="1">
        <p:scale>
          <a:sx n="71" d="100"/>
          <a:sy n="71" d="100"/>
        </p:scale>
        <p:origin x="3210" y="60"/>
      </p:cViewPr>
      <p:guideLst>
        <p:guide orient="horz" pos="1850"/>
        <p:guide pos="1178"/>
        <p:guide pos="4221"/>
        <p:guide orient="horz" pos="5956"/>
        <p:guide pos="164"/>
        <p:guide pos="41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9" Type="http://schemas.openxmlformats.org/officeDocument/2006/relationships/image" Target="../media/image31.emf"/><Relationship Id="rId8" Type="http://schemas.openxmlformats.org/officeDocument/2006/relationships/image" Target="../media/image24.emf"/><Relationship Id="rId7" Type="http://schemas.openxmlformats.org/officeDocument/2006/relationships/image" Target="../media/image12.emf"/><Relationship Id="rId6" Type="http://schemas.openxmlformats.org/officeDocument/2006/relationships/image" Target="../media/image11.emf"/><Relationship Id="rId5" Type="http://schemas.openxmlformats.org/officeDocument/2006/relationships/image" Target="../media/image5.emf"/><Relationship Id="rId4" Type="http://schemas.openxmlformats.org/officeDocument/2006/relationships/image" Target="../media/image4.emf"/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2" Type="http://schemas.openxmlformats.org/officeDocument/2006/relationships/image" Target="../media/image34.emf"/><Relationship Id="rId11" Type="http://schemas.openxmlformats.org/officeDocument/2006/relationships/image" Target="../media/image33.emf"/><Relationship Id="rId10" Type="http://schemas.openxmlformats.org/officeDocument/2006/relationships/image" Target="../media/image3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680AB3-A715-4D44-B0FF-8262B61BB38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2E9BA4-A05B-4E19-9F95-99BFD87B324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72E9BA4-A05B-4E19-9F95-99BFD87B324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D0B63-93A9-4F6D-9424-323C1571F09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A8BAC-F9FA-4C12-BF8E-665FF48517D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oleObject" Target="../embeddings/oleObject5.bin"/><Relationship Id="rId8" Type="http://schemas.openxmlformats.org/officeDocument/2006/relationships/image" Target="../media/image4.emf"/><Relationship Id="rId7" Type="http://schemas.openxmlformats.org/officeDocument/2006/relationships/oleObject" Target="../embeddings/oleObject4.bin"/><Relationship Id="rId6" Type="http://schemas.openxmlformats.org/officeDocument/2006/relationships/image" Target="../media/image3.emf"/><Relationship Id="rId5" Type="http://schemas.openxmlformats.org/officeDocument/2006/relationships/oleObject" Target="../embeddings/oleObject3.bin"/><Relationship Id="rId49" Type="http://schemas.openxmlformats.org/officeDocument/2006/relationships/notesSlide" Target="../notesSlides/notesSlide1.xml"/><Relationship Id="rId48" Type="http://schemas.openxmlformats.org/officeDocument/2006/relationships/vmlDrawing" Target="../drawings/vmlDrawing1.vml"/><Relationship Id="rId47" Type="http://schemas.openxmlformats.org/officeDocument/2006/relationships/slideLayout" Target="../slideLayouts/slideLayout7.xml"/><Relationship Id="rId46" Type="http://schemas.openxmlformats.org/officeDocument/2006/relationships/image" Target="../media/image34.emf"/><Relationship Id="rId45" Type="http://schemas.openxmlformats.org/officeDocument/2006/relationships/oleObject" Target="../embeddings/oleObject12.bin"/><Relationship Id="rId44" Type="http://schemas.openxmlformats.org/officeDocument/2006/relationships/image" Target="../media/image33.emf"/><Relationship Id="rId43" Type="http://schemas.openxmlformats.org/officeDocument/2006/relationships/oleObject" Target="../embeddings/oleObject11.bin"/><Relationship Id="rId42" Type="http://schemas.openxmlformats.org/officeDocument/2006/relationships/image" Target="../media/image32.emf"/><Relationship Id="rId41" Type="http://schemas.openxmlformats.org/officeDocument/2006/relationships/oleObject" Target="../embeddings/oleObject10.bin"/><Relationship Id="rId40" Type="http://schemas.openxmlformats.org/officeDocument/2006/relationships/image" Target="../media/image31.emf"/><Relationship Id="rId4" Type="http://schemas.openxmlformats.org/officeDocument/2006/relationships/image" Target="../media/image2.emf"/><Relationship Id="rId39" Type="http://schemas.openxmlformats.org/officeDocument/2006/relationships/oleObject" Target="../embeddings/oleObject9.bin"/><Relationship Id="rId38" Type="http://schemas.openxmlformats.org/officeDocument/2006/relationships/image" Target="../media/image30.jpeg"/><Relationship Id="rId37" Type="http://schemas.microsoft.com/office/2007/relationships/hdphoto" Target="../media/image29.wdp"/><Relationship Id="rId36" Type="http://schemas.openxmlformats.org/officeDocument/2006/relationships/image" Target="../media/image28.png"/><Relationship Id="rId35" Type="http://schemas.microsoft.com/office/2007/relationships/hdphoto" Target="../media/image27.wdp"/><Relationship Id="rId34" Type="http://schemas.openxmlformats.org/officeDocument/2006/relationships/image" Target="../media/image26.png"/><Relationship Id="rId33" Type="http://schemas.openxmlformats.org/officeDocument/2006/relationships/image" Target="../media/image25.jpeg"/><Relationship Id="rId32" Type="http://schemas.openxmlformats.org/officeDocument/2006/relationships/image" Target="../media/image24.emf"/><Relationship Id="rId31" Type="http://schemas.openxmlformats.org/officeDocument/2006/relationships/oleObject" Target="../embeddings/oleObject8.bin"/><Relationship Id="rId30" Type="http://schemas.openxmlformats.org/officeDocument/2006/relationships/image" Target="../media/image23.tiff"/><Relationship Id="rId3" Type="http://schemas.openxmlformats.org/officeDocument/2006/relationships/oleObject" Target="../embeddings/oleObject2.bin"/><Relationship Id="rId29" Type="http://schemas.microsoft.com/office/2007/relationships/hdphoto" Target="../media/image22.wdp"/><Relationship Id="rId28" Type="http://schemas.openxmlformats.org/officeDocument/2006/relationships/image" Target="../media/image21.png"/><Relationship Id="rId27" Type="http://schemas.microsoft.com/office/2007/relationships/hdphoto" Target="../media/image20.wdp"/><Relationship Id="rId26" Type="http://schemas.openxmlformats.org/officeDocument/2006/relationships/image" Target="../media/image19.png"/><Relationship Id="rId25" Type="http://schemas.microsoft.com/office/2007/relationships/hdphoto" Target="../media/image18.wdp"/><Relationship Id="rId24" Type="http://schemas.openxmlformats.org/officeDocument/2006/relationships/image" Target="../media/image17.png"/><Relationship Id="rId23" Type="http://schemas.microsoft.com/office/2007/relationships/hdphoto" Target="../media/image16.wdp"/><Relationship Id="rId22" Type="http://schemas.openxmlformats.org/officeDocument/2006/relationships/image" Target="../media/image15.png"/><Relationship Id="rId21" Type="http://schemas.openxmlformats.org/officeDocument/2006/relationships/image" Target="../media/image14.tiff"/><Relationship Id="rId20" Type="http://schemas.openxmlformats.org/officeDocument/2006/relationships/image" Target="../media/image13.tiff"/><Relationship Id="rId2" Type="http://schemas.openxmlformats.org/officeDocument/2006/relationships/image" Target="../media/image1.emf"/><Relationship Id="rId19" Type="http://schemas.openxmlformats.org/officeDocument/2006/relationships/image" Target="../media/image12.emf"/><Relationship Id="rId18" Type="http://schemas.openxmlformats.org/officeDocument/2006/relationships/oleObject" Target="../embeddings/oleObject7.bin"/><Relationship Id="rId17" Type="http://schemas.openxmlformats.org/officeDocument/2006/relationships/image" Target="../media/image11.emf"/><Relationship Id="rId16" Type="http://schemas.openxmlformats.org/officeDocument/2006/relationships/oleObject" Target="../embeddings/oleObject6.bin"/><Relationship Id="rId15" Type="http://schemas.microsoft.com/office/2007/relationships/hdphoto" Target="../media/image10.wdp"/><Relationship Id="rId14" Type="http://schemas.openxmlformats.org/officeDocument/2006/relationships/image" Target="../media/image9.png"/><Relationship Id="rId13" Type="http://schemas.microsoft.com/office/2007/relationships/hdphoto" Target="../media/image8.wdp"/><Relationship Id="rId12" Type="http://schemas.openxmlformats.org/officeDocument/2006/relationships/image" Target="../media/image7.png"/><Relationship Id="rId11" Type="http://schemas.openxmlformats.org/officeDocument/2006/relationships/image" Target="../media/image6.emf"/><Relationship Id="rId10" Type="http://schemas.openxmlformats.org/officeDocument/2006/relationships/image" Target="../media/image5.emf"/><Relationship Id="rId1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对象 22"/>
          <p:cNvGraphicFramePr/>
          <p:nvPr/>
        </p:nvGraphicFramePr>
        <p:xfrm>
          <a:off x="1717675" y="1546225"/>
          <a:ext cx="1204913" cy="1055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" name="Prism 7" r:id="rId1" imgW="1409700" imgH="1219200" progId="Prism7.Document">
                  <p:embed/>
                </p:oleObj>
              </mc:Choice>
              <mc:Fallback>
                <p:oleObj name="Prism 7" r:id="rId1" imgW="1409700" imgH="1219200" progId="Prism7.Document">
                  <p:embed/>
                  <p:pic>
                    <p:nvPicPr>
                      <p:cNvPr id="0" name="对象 22"/>
                      <p:cNvPicPr/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1717675" y="1546225"/>
                        <a:ext cx="1204913" cy="1055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/>
          <p:cNvGraphicFramePr/>
          <p:nvPr/>
        </p:nvGraphicFramePr>
        <p:xfrm>
          <a:off x="2800350" y="1547813"/>
          <a:ext cx="1203325" cy="1055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" name="Prism 7" r:id="rId3" imgW="1409700" imgH="1219200" progId="Prism7.Document">
                  <p:embed/>
                </p:oleObj>
              </mc:Choice>
              <mc:Fallback>
                <p:oleObj name="Prism 7" r:id="rId3" imgW="1409700" imgH="1219200" progId="Prism7.Document">
                  <p:embed/>
                  <p:pic>
                    <p:nvPicPr>
                      <p:cNvPr id="0" name="对象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00350" y="1547813"/>
                        <a:ext cx="1203325" cy="1055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本框 4"/>
          <p:cNvSpPr txBox="1"/>
          <p:nvPr/>
        </p:nvSpPr>
        <p:spPr>
          <a:xfrm rot="16200000">
            <a:off x="2601547" y="186442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200" b="0" i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NCOA4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/β-actin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</p:txBody>
      </p:sp>
      <p:graphicFrame>
        <p:nvGraphicFramePr>
          <p:cNvPr id="6" name="对象 5"/>
          <p:cNvGraphicFramePr/>
          <p:nvPr/>
        </p:nvGraphicFramePr>
        <p:xfrm>
          <a:off x="465138" y="1552575"/>
          <a:ext cx="1203325" cy="1058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" name="Prism 7" r:id="rId5" imgW="1409700" imgH="1219200" progId="Prism7.Document">
                  <p:embed/>
                </p:oleObj>
              </mc:Choice>
              <mc:Fallback>
                <p:oleObj name="Prism 7" r:id="rId5" imgW="1409700" imgH="1219200" progId="Prism7.Document">
                  <p:embed/>
                  <p:pic>
                    <p:nvPicPr>
                      <p:cNvPr id="0" name="对象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5138" y="1552575"/>
                        <a:ext cx="1203325" cy="1058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本框 7"/>
          <p:cNvSpPr txBox="1"/>
          <p:nvPr/>
        </p:nvSpPr>
        <p:spPr>
          <a:xfrm>
            <a:off x="379815" y="1090656"/>
            <a:ext cx="6014532" cy="2771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 S4 Huaier Induces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erritinophagy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in NSCLC Cells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16200000">
            <a:off x="1475576" y="1855916"/>
            <a:ext cx="481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200" b="0" i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FTH1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/β-actin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 rot="16200000">
            <a:off x="184183" y="185171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200" b="0" i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NCOA4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/β-actin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49009" y="1420435"/>
            <a:ext cx="222681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593322" y="1420435"/>
            <a:ext cx="222681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868617" y="1774140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75578" y="2346317"/>
            <a:ext cx="7537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(mg/ml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/>
          <p:cNvGrpSpPr/>
          <p:nvPr/>
        </p:nvGrpSpPr>
        <p:grpSpPr>
          <a:xfrm>
            <a:off x="881058" y="1887082"/>
            <a:ext cx="185001" cy="36000"/>
            <a:chOff x="5133996" y="3642301"/>
            <a:chExt cx="194874" cy="35014"/>
          </a:xfrm>
        </p:grpSpPr>
        <p:cxnSp>
          <p:nvCxnSpPr>
            <p:cNvPr id="16" name="直接连接符 15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直接连接符 17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" name="文本框 18"/>
          <p:cNvSpPr txBox="1"/>
          <p:nvPr/>
        </p:nvSpPr>
        <p:spPr>
          <a:xfrm>
            <a:off x="940016" y="1658871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组合 19"/>
          <p:cNvGrpSpPr/>
          <p:nvPr/>
        </p:nvGrpSpPr>
        <p:grpSpPr>
          <a:xfrm>
            <a:off x="883810" y="1770881"/>
            <a:ext cx="360000" cy="36000"/>
            <a:chOff x="5133996" y="3642301"/>
            <a:chExt cx="194874" cy="35014"/>
          </a:xfrm>
        </p:grpSpPr>
        <p:cxnSp>
          <p:nvCxnSpPr>
            <p:cNvPr id="21" name="直接连接符 20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直接连接符 21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接连接符 23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5" name="文本框 24"/>
          <p:cNvSpPr txBox="1"/>
          <p:nvPr/>
        </p:nvSpPr>
        <p:spPr>
          <a:xfrm>
            <a:off x="2120482" y="1755398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414432" y="2341562"/>
            <a:ext cx="7537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(mg/ml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2132923" y="1868340"/>
            <a:ext cx="185001" cy="36000"/>
            <a:chOff x="5133996" y="3642301"/>
            <a:chExt cx="194874" cy="35014"/>
          </a:xfrm>
        </p:grpSpPr>
        <p:cxnSp>
          <p:nvCxnSpPr>
            <p:cNvPr id="28" name="直接连接符 27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直接连接符 28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直接连接符 29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1" name="文本框 30"/>
          <p:cNvSpPr txBox="1"/>
          <p:nvPr/>
        </p:nvSpPr>
        <p:spPr>
          <a:xfrm>
            <a:off x="2142205" y="1650283"/>
            <a:ext cx="41900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组合 31"/>
          <p:cNvGrpSpPr/>
          <p:nvPr/>
        </p:nvGrpSpPr>
        <p:grpSpPr>
          <a:xfrm>
            <a:off x="2135675" y="1761663"/>
            <a:ext cx="360000" cy="36000"/>
            <a:chOff x="5133996" y="3642301"/>
            <a:chExt cx="194874" cy="35014"/>
          </a:xfrm>
        </p:grpSpPr>
        <p:cxnSp>
          <p:nvCxnSpPr>
            <p:cNvPr id="33" name="直接连接符 32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直接连接符 34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6" name="文本框 35"/>
          <p:cNvSpPr txBox="1"/>
          <p:nvPr/>
        </p:nvSpPr>
        <p:spPr>
          <a:xfrm>
            <a:off x="3228387" y="1585235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2795591" y="2345599"/>
            <a:ext cx="4235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组合 37"/>
          <p:cNvGrpSpPr/>
          <p:nvPr/>
        </p:nvGrpSpPr>
        <p:grpSpPr>
          <a:xfrm>
            <a:off x="3186092" y="2073463"/>
            <a:ext cx="144000" cy="36000"/>
            <a:chOff x="5133996" y="3642301"/>
            <a:chExt cx="194874" cy="35014"/>
          </a:xfrm>
        </p:grpSpPr>
        <p:cxnSp>
          <p:nvCxnSpPr>
            <p:cNvPr id="39" name="直接连接符 38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直接连接符 39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直接连接符 40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2" name="文本框 41"/>
          <p:cNvSpPr txBox="1"/>
          <p:nvPr/>
        </p:nvSpPr>
        <p:spPr>
          <a:xfrm>
            <a:off x="3132236" y="1963791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组合 42"/>
          <p:cNvGrpSpPr/>
          <p:nvPr/>
        </p:nvGrpSpPr>
        <p:grpSpPr>
          <a:xfrm>
            <a:off x="3178359" y="1706375"/>
            <a:ext cx="432000" cy="36000"/>
            <a:chOff x="5133996" y="3642301"/>
            <a:chExt cx="194874" cy="35014"/>
          </a:xfrm>
        </p:grpSpPr>
        <p:cxnSp>
          <p:nvCxnSpPr>
            <p:cNvPr id="44" name="直接连接符 43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7" name="文本框 46"/>
          <p:cNvSpPr txBox="1"/>
          <p:nvPr/>
        </p:nvSpPr>
        <p:spPr>
          <a:xfrm>
            <a:off x="3195026" y="1674140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8" name="组合 47"/>
          <p:cNvGrpSpPr/>
          <p:nvPr/>
        </p:nvGrpSpPr>
        <p:grpSpPr>
          <a:xfrm>
            <a:off x="3181473" y="1795690"/>
            <a:ext cx="288000" cy="36000"/>
            <a:chOff x="5133996" y="3642301"/>
            <a:chExt cx="194874" cy="35014"/>
          </a:xfrm>
        </p:grpSpPr>
        <p:cxnSp>
          <p:nvCxnSpPr>
            <p:cNvPr id="49" name="直接连接符 48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直接连接符 49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aphicFrame>
        <p:nvGraphicFramePr>
          <p:cNvPr id="52" name="对象 51"/>
          <p:cNvGraphicFramePr/>
          <p:nvPr/>
        </p:nvGraphicFramePr>
        <p:xfrm>
          <a:off x="3983038" y="1546225"/>
          <a:ext cx="1204912" cy="1058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" name="Prism 7" r:id="rId7" imgW="1409700" imgH="1219200" progId="Prism7.Document">
                  <p:embed/>
                </p:oleObj>
              </mc:Choice>
              <mc:Fallback>
                <p:oleObj name="Prism 7" r:id="rId7" imgW="1409700" imgH="1219200" progId="Prism7.Document">
                  <p:embed/>
                  <p:pic>
                    <p:nvPicPr>
                      <p:cNvPr id="0" name="对象 50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983038" y="1546225"/>
                        <a:ext cx="1204912" cy="1058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文本框 53"/>
          <p:cNvSpPr txBox="1"/>
          <p:nvPr/>
        </p:nvSpPr>
        <p:spPr>
          <a:xfrm rot="16200000">
            <a:off x="3713415" y="1846743"/>
            <a:ext cx="481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200" b="0" i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FTH1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/β-actin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</p:txBody>
      </p:sp>
      <p:grpSp>
        <p:nvGrpSpPr>
          <p:cNvPr id="55" name="组合 54"/>
          <p:cNvGrpSpPr/>
          <p:nvPr/>
        </p:nvGrpSpPr>
        <p:grpSpPr>
          <a:xfrm>
            <a:off x="4369706" y="1850134"/>
            <a:ext cx="144000" cy="36000"/>
            <a:chOff x="5133996" y="3642301"/>
            <a:chExt cx="194874" cy="35014"/>
          </a:xfrm>
        </p:grpSpPr>
        <p:cxnSp>
          <p:nvCxnSpPr>
            <p:cNvPr id="56" name="直接连接符 55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直接连接符 56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直接连接符 57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9" name="文本框 58"/>
          <p:cNvSpPr txBox="1"/>
          <p:nvPr/>
        </p:nvSpPr>
        <p:spPr>
          <a:xfrm>
            <a:off x="4315850" y="1740462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4409894" y="1551149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1" name="组合 60"/>
          <p:cNvGrpSpPr/>
          <p:nvPr/>
        </p:nvGrpSpPr>
        <p:grpSpPr>
          <a:xfrm>
            <a:off x="4359866" y="1672289"/>
            <a:ext cx="432000" cy="36000"/>
            <a:chOff x="5133996" y="3642301"/>
            <a:chExt cx="194874" cy="35014"/>
          </a:xfrm>
        </p:grpSpPr>
        <p:cxnSp>
          <p:nvCxnSpPr>
            <p:cNvPr id="62" name="直接连接符 61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直接连接符 62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直接连接符 63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5" name="文本框 64"/>
          <p:cNvSpPr txBox="1"/>
          <p:nvPr/>
        </p:nvSpPr>
        <p:spPr>
          <a:xfrm>
            <a:off x="4337117" y="1639051"/>
            <a:ext cx="4212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6" name="组合 65"/>
          <p:cNvGrpSpPr/>
          <p:nvPr/>
        </p:nvGrpSpPr>
        <p:grpSpPr>
          <a:xfrm>
            <a:off x="4362980" y="1761604"/>
            <a:ext cx="288000" cy="36000"/>
            <a:chOff x="5133996" y="3642301"/>
            <a:chExt cx="194874" cy="35014"/>
          </a:xfrm>
        </p:grpSpPr>
        <p:cxnSp>
          <p:nvCxnSpPr>
            <p:cNvPr id="67" name="直接连接符 66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直接连接符 67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直接连接符 68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0" name="文本框 69"/>
          <p:cNvSpPr txBox="1"/>
          <p:nvPr/>
        </p:nvSpPr>
        <p:spPr>
          <a:xfrm>
            <a:off x="3988300" y="2342476"/>
            <a:ext cx="4235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1" name="对象 70"/>
          <p:cNvGraphicFramePr/>
          <p:nvPr/>
        </p:nvGraphicFramePr>
        <p:xfrm>
          <a:off x="511175" y="2762250"/>
          <a:ext cx="1217613" cy="1028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" name="Prism 7" r:id="rId9" imgW="1409700" imgH="1190625" progId="Prism7.Document">
                  <p:embed/>
                </p:oleObj>
              </mc:Choice>
              <mc:Fallback>
                <p:oleObj name="Prism 7" r:id="rId9" imgW="1409700" imgH="1190625" progId="Prism7.Document">
                  <p:embed/>
                  <p:pic>
                    <p:nvPicPr>
                      <p:cNvPr id="0" name="对象 68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11175" y="2762250"/>
                        <a:ext cx="1217613" cy="1028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73" name="组合 72"/>
          <p:cNvGrpSpPr/>
          <p:nvPr/>
        </p:nvGrpSpPr>
        <p:grpSpPr>
          <a:xfrm>
            <a:off x="4957609" y="1495932"/>
            <a:ext cx="1731839" cy="1116723"/>
            <a:chOff x="430354" y="322714"/>
            <a:chExt cx="1731840" cy="1116723"/>
          </a:xfrm>
        </p:grpSpPr>
        <p:cxnSp>
          <p:nvCxnSpPr>
            <p:cNvPr id="74" name="直接连接符 73"/>
            <p:cNvCxnSpPr/>
            <p:nvPr/>
          </p:nvCxnSpPr>
          <p:spPr>
            <a:xfrm>
              <a:off x="1777153" y="1102488"/>
              <a:ext cx="11186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5" name="直接连接符 74"/>
            <p:cNvCxnSpPr/>
            <p:nvPr/>
          </p:nvCxnSpPr>
          <p:spPr>
            <a:xfrm>
              <a:off x="1773855" y="858648"/>
              <a:ext cx="11186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6" name="直接连接符 75"/>
            <p:cNvCxnSpPr/>
            <p:nvPr/>
          </p:nvCxnSpPr>
          <p:spPr>
            <a:xfrm>
              <a:off x="1773855" y="610429"/>
              <a:ext cx="11186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77" name="组合 76"/>
            <p:cNvGrpSpPr/>
            <p:nvPr/>
          </p:nvGrpSpPr>
          <p:grpSpPr>
            <a:xfrm>
              <a:off x="430354" y="322714"/>
              <a:ext cx="1636565" cy="1116723"/>
              <a:chOff x="5134604" y="793958"/>
              <a:chExt cx="1329067" cy="1208072"/>
            </a:xfrm>
          </p:grpSpPr>
          <p:grpSp>
            <p:nvGrpSpPr>
              <p:cNvPr id="79" name="组合 78"/>
              <p:cNvGrpSpPr/>
              <p:nvPr/>
            </p:nvGrpSpPr>
            <p:grpSpPr>
              <a:xfrm>
                <a:off x="5134604" y="793958"/>
                <a:ext cx="1301201" cy="1021489"/>
                <a:chOff x="986632" y="3391057"/>
                <a:chExt cx="1574457" cy="1075731"/>
              </a:xfrm>
            </p:grpSpPr>
            <p:pic>
              <p:nvPicPr>
                <p:cNvPr id="82" name="图片 81"/>
                <p:cNvPicPr>
                  <a:picLocks noChangeAspect="1"/>
                </p:cNvPicPr>
                <p:nvPr/>
              </p:nvPicPr>
              <p:blipFill rotWithShape="1">
                <a:blip r:embed="rId11">
                  <a:duotone>
                    <a:prstClr val="black"/>
                    <a:schemeClr val="accent3">
                      <a:tint val="45000"/>
                      <a:satMod val="400000"/>
                    </a:schemeClr>
                  </a:duotone>
                </a:blip>
                <a:srcRect l="2359" t="19782" r="10643" b="28757"/>
                <a:stretch>
                  <a:fillRect/>
                </a:stretch>
              </p:blipFill>
              <p:spPr>
                <a:xfrm flipH="1">
                  <a:off x="1430953" y="3892913"/>
                  <a:ext cx="930834" cy="256323"/>
                </a:xfrm>
                <a:prstGeom prst="rect">
                  <a:avLst/>
                </a:prstGeom>
              </p:spPr>
            </p:pic>
            <p:pic>
              <p:nvPicPr>
                <p:cNvPr id="83" name="图片 82"/>
                <p:cNvPicPr>
                  <a:picLocks noChangeAspect="1"/>
                </p:cNvPicPr>
                <p:nvPr/>
              </p:nvPicPr>
              <p:blipFill rotWithShape="1">
                <a:blip r:embed="rId12" cstate="print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0067" t="93287" r="21922" b="1304"/>
                <a:stretch>
                  <a:fillRect/>
                </a:stretch>
              </p:blipFill>
              <p:spPr>
                <a:xfrm>
                  <a:off x="1437612" y="4218796"/>
                  <a:ext cx="931460" cy="247992"/>
                </a:xfrm>
                <a:prstGeom prst="rect">
                  <a:avLst/>
                </a:prstGeom>
              </p:spPr>
            </p:pic>
            <p:grpSp>
              <p:nvGrpSpPr>
                <p:cNvPr id="84" name="组合 83"/>
                <p:cNvGrpSpPr/>
                <p:nvPr/>
              </p:nvGrpSpPr>
              <p:grpSpPr>
                <a:xfrm>
                  <a:off x="986632" y="3391057"/>
                  <a:ext cx="1574457" cy="1071603"/>
                  <a:chOff x="2856091" y="1553236"/>
                  <a:chExt cx="1574457" cy="1071603"/>
                </a:xfrm>
              </p:grpSpPr>
              <p:pic>
                <p:nvPicPr>
                  <p:cNvPr id="85" name="图片 84"/>
                  <p:cNvPicPr>
                    <a:picLocks noChangeAspect="1"/>
                  </p:cNvPicPr>
                  <p:nvPr/>
                </p:nvPicPr>
                <p:blipFill rotWithShape="1">
                  <a:blip r:embed="rId14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5"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9583" t="83953" r="21922" b="8991"/>
                  <a:stretch>
                    <a:fillRect/>
                  </a:stretch>
                </p:blipFill>
                <p:spPr>
                  <a:xfrm>
                    <a:off x="3307694" y="1758836"/>
                    <a:ext cx="925835" cy="261551"/>
                  </a:xfrm>
                  <a:prstGeom prst="rect">
                    <a:avLst/>
                  </a:prstGeom>
                </p:spPr>
              </p:pic>
              <p:sp>
                <p:nvSpPr>
                  <p:cNvPr id="86" name="矩形 85"/>
                  <p:cNvSpPr/>
                  <p:nvPr/>
                </p:nvSpPr>
                <p:spPr>
                  <a:xfrm>
                    <a:off x="3298129" y="1755328"/>
                    <a:ext cx="935400" cy="261551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7" name="文本框 86"/>
                  <p:cNvSpPr txBox="1"/>
                  <p:nvPr/>
                </p:nvSpPr>
                <p:spPr>
                  <a:xfrm>
                    <a:off x="3323346" y="1553236"/>
                    <a:ext cx="1107202" cy="22791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     5       0      5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8" name="文本框 87"/>
                  <p:cNvSpPr txBox="1"/>
                  <p:nvPr/>
                </p:nvSpPr>
                <p:spPr>
                  <a:xfrm>
                    <a:off x="2860663" y="1783255"/>
                    <a:ext cx="483901" cy="22791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COA4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9" name="文本框 88"/>
                  <p:cNvSpPr txBox="1"/>
                  <p:nvPr/>
                </p:nvSpPr>
                <p:spPr>
                  <a:xfrm>
                    <a:off x="2856091" y="2359556"/>
                    <a:ext cx="472874" cy="22791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β-actin 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0" name="矩形 89"/>
                  <p:cNvSpPr/>
                  <p:nvPr/>
                </p:nvSpPr>
                <p:spPr>
                  <a:xfrm>
                    <a:off x="3298129" y="2051584"/>
                    <a:ext cx="935400" cy="256323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1" name="矩形 90"/>
                  <p:cNvSpPr/>
                  <p:nvPr/>
                </p:nvSpPr>
                <p:spPr>
                  <a:xfrm>
                    <a:off x="3298129" y="2363288"/>
                    <a:ext cx="935400" cy="261551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2" name="文本框 91"/>
                  <p:cNvSpPr txBox="1"/>
                  <p:nvPr/>
                </p:nvSpPr>
                <p:spPr>
                  <a:xfrm>
                    <a:off x="2907574" y="2059199"/>
                    <a:ext cx="400415" cy="22791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TH1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80" name="文本框 79"/>
              <p:cNvSpPr txBox="1"/>
              <p:nvPr/>
            </p:nvSpPr>
            <p:spPr>
              <a:xfrm>
                <a:off x="5524483" y="1785610"/>
                <a:ext cx="939188" cy="2164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1975    H358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5171864" y="804393"/>
                <a:ext cx="363465" cy="2164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uaier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8" name="文本框 77"/>
            <p:cNvSpPr txBox="1"/>
            <p:nvPr/>
          </p:nvSpPr>
          <p:spPr>
            <a:xfrm>
              <a:off x="1818743" y="77549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1813025" y="498514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1804404" y="394983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文本框 94"/>
            <p:cNvSpPr txBox="1"/>
            <p:nvPr/>
          </p:nvSpPr>
          <p:spPr>
            <a:xfrm>
              <a:off x="1816598" y="101038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6" name="文本框 95"/>
          <p:cNvSpPr txBox="1"/>
          <p:nvPr/>
        </p:nvSpPr>
        <p:spPr>
          <a:xfrm>
            <a:off x="168008" y="2643635"/>
            <a:ext cx="206507" cy="2755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/>
          <p:cNvSpPr txBox="1"/>
          <p:nvPr/>
        </p:nvSpPr>
        <p:spPr>
          <a:xfrm rot="16200000">
            <a:off x="278368" y="3079858"/>
            <a:ext cx="5180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200" b="0" i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NCOA4 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/β-actin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</p:txBody>
      </p:sp>
      <p:grpSp>
        <p:nvGrpSpPr>
          <p:cNvPr id="98" name="组合 97"/>
          <p:cNvGrpSpPr/>
          <p:nvPr/>
        </p:nvGrpSpPr>
        <p:grpSpPr>
          <a:xfrm>
            <a:off x="900369" y="3090688"/>
            <a:ext cx="108000" cy="36000"/>
            <a:chOff x="5133996" y="3642301"/>
            <a:chExt cx="194874" cy="35014"/>
          </a:xfrm>
        </p:grpSpPr>
        <p:cxnSp>
          <p:nvCxnSpPr>
            <p:cNvPr id="99" name="直接连接符 98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直接连接符 99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直接连接符 100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2" name="文本框 101"/>
          <p:cNvSpPr txBox="1"/>
          <p:nvPr/>
        </p:nvSpPr>
        <p:spPr>
          <a:xfrm>
            <a:off x="823971" y="2970163"/>
            <a:ext cx="3949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/>
          <p:cNvSpPr txBox="1"/>
          <p:nvPr/>
        </p:nvSpPr>
        <p:spPr>
          <a:xfrm rot="16200000">
            <a:off x="1490232" y="3072324"/>
            <a:ext cx="481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200" b="0" i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FTH1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/β-actin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181634" y="3526322"/>
            <a:ext cx="7537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(mg/ml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5" name="组合 104"/>
          <p:cNvGrpSpPr/>
          <p:nvPr/>
        </p:nvGrpSpPr>
        <p:grpSpPr>
          <a:xfrm>
            <a:off x="1234909" y="2989438"/>
            <a:ext cx="108000" cy="36000"/>
            <a:chOff x="5133996" y="3642301"/>
            <a:chExt cx="194874" cy="35014"/>
          </a:xfrm>
        </p:grpSpPr>
        <p:cxnSp>
          <p:nvCxnSpPr>
            <p:cNvPr id="106" name="直接连接符 105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直接连接符 106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" name="直接连接符 107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9" name="文本框 108"/>
          <p:cNvSpPr txBox="1"/>
          <p:nvPr/>
        </p:nvSpPr>
        <p:spPr>
          <a:xfrm>
            <a:off x="1159832" y="2871803"/>
            <a:ext cx="3949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743540" y="2879354"/>
            <a:ext cx="4897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1975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1099958" y="2768826"/>
            <a:ext cx="4897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358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112" name="对象 111"/>
          <p:cNvGraphicFramePr/>
          <p:nvPr/>
        </p:nvGraphicFramePr>
        <p:xfrm>
          <a:off x="1758950" y="2760663"/>
          <a:ext cx="1217613" cy="1030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" name="Prism 7" r:id="rId16" imgW="1409700" imgH="1190625" progId="Prism7.Document">
                  <p:embed/>
                </p:oleObj>
              </mc:Choice>
              <mc:Fallback>
                <p:oleObj name="Prism 7" r:id="rId16" imgW="1409700" imgH="1190625" progId="Prism7.Document">
                  <p:embed/>
                  <p:pic>
                    <p:nvPicPr>
                      <p:cNvPr id="0" name="对象 108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758950" y="2760663"/>
                        <a:ext cx="1217613" cy="1030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14" name="组合 113"/>
          <p:cNvGrpSpPr/>
          <p:nvPr/>
        </p:nvGrpSpPr>
        <p:grpSpPr>
          <a:xfrm>
            <a:off x="2146876" y="3073632"/>
            <a:ext cx="108000" cy="36000"/>
            <a:chOff x="5133996" y="3642301"/>
            <a:chExt cx="194874" cy="35014"/>
          </a:xfrm>
        </p:grpSpPr>
        <p:cxnSp>
          <p:nvCxnSpPr>
            <p:cNvPr id="115" name="直接连接符 114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" name="直接连接符 115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" name="直接连接符 116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18" name="文本框 117"/>
          <p:cNvSpPr txBox="1"/>
          <p:nvPr/>
        </p:nvSpPr>
        <p:spPr>
          <a:xfrm>
            <a:off x="2050523" y="2939876"/>
            <a:ext cx="324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/>
          <p:cNvSpPr txBox="1"/>
          <p:nvPr/>
        </p:nvSpPr>
        <p:spPr>
          <a:xfrm>
            <a:off x="1436059" y="3524922"/>
            <a:ext cx="8680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(mg/ml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0" name="组合 119"/>
          <p:cNvGrpSpPr/>
          <p:nvPr/>
        </p:nvGrpSpPr>
        <p:grpSpPr>
          <a:xfrm>
            <a:off x="2465202" y="3060371"/>
            <a:ext cx="108000" cy="36000"/>
            <a:chOff x="5133996" y="3642301"/>
            <a:chExt cx="194874" cy="35014"/>
          </a:xfrm>
        </p:grpSpPr>
        <p:cxnSp>
          <p:nvCxnSpPr>
            <p:cNvPr id="121" name="直接连接符 120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" name="直接连接符 121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" name="直接连接符 122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4" name="文本框 123"/>
          <p:cNvSpPr txBox="1"/>
          <p:nvPr/>
        </p:nvSpPr>
        <p:spPr>
          <a:xfrm>
            <a:off x="2365324" y="2939876"/>
            <a:ext cx="3949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/>
          <p:cNvSpPr txBox="1"/>
          <p:nvPr/>
        </p:nvSpPr>
        <p:spPr>
          <a:xfrm>
            <a:off x="1973461" y="2856240"/>
            <a:ext cx="4897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1975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6" name="文本框 125"/>
          <p:cNvSpPr txBox="1"/>
          <p:nvPr/>
        </p:nvSpPr>
        <p:spPr>
          <a:xfrm>
            <a:off x="2311864" y="2840240"/>
            <a:ext cx="4897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358</a:t>
            </a:r>
            <a:endParaRPr lang="zh-CN" altLang="en-US" sz="7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7" name="文本框 126"/>
          <p:cNvSpPr txBox="1"/>
          <p:nvPr/>
        </p:nvSpPr>
        <p:spPr>
          <a:xfrm>
            <a:off x="4826457" y="1372236"/>
            <a:ext cx="206507" cy="2755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8" name="组合 127"/>
          <p:cNvGrpSpPr/>
          <p:nvPr/>
        </p:nvGrpSpPr>
        <p:grpSpPr>
          <a:xfrm>
            <a:off x="2720191" y="2655547"/>
            <a:ext cx="4201309" cy="1181441"/>
            <a:chOff x="4660782" y="-1126597"/>
            <a:chExt cx="4201309" cy="1181441"/>
          </a:xfrm>
        </p:grpSpPr>
        <p:graphicFrame>
          <p:nvGraphicFramePr>
            <p:cNvPr id="129" name="对象 128"/>
            <p:cNvGraphicFramePr>
              <a:graphicFrameLocks noChangeAspect="1"/>
            </p:cNvGraphicFramePr>
            <p:nvPr/>
          </p:nvGraphicFramePr>
          <p:xfrm>
            <a:off x="4780629" y="-1113556"/>
            <a:ext cx="4081462" cy="1168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0" name="Prism 7" r:id="rId18" imgW="4114800" imgH="1190625" progId="Prism7.Document">
                    <p:embed/>
                  </p:oleObj>
                </mc:Choice>
                <mc:Fallback>
                  <p:oleObj name="Prism 7" r:id="rId18" imgW="4114800" imgH="1190625" progId="Prism7.Document">
                    <p:embed/>
                    <p:pic>
                      <p:nvPicPr>
                        <p:cNvPr id="0" name="对象 128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4780629" y="-1113556"/>
                          <a:ext cx="4081462" cy="1168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1" name="文本框 130"/>
            <p:cNvSpPr txBox="1"/>
            <p:nvPr/>
          </p:nvSpPr>
          <p:spPr>
            <a:xfrm rot="16200000">
              <a:off x="4355172" y="-678121"/>
              <a:ext cx="9189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elative</a:t>
              </a:r>
              <a:endParaRPr lang="en-US" altLang="zh-C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mRNA level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本框 131"/>
            <p:cNvSpPr txBox="1"/>
            <p:nvPr/>
          </p:nvSpPr>
          <p:spPr>
            <a:xfrm>
              <a:off x="5360229" y="-949552"/>
              <a:ext cx="4721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A549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文本框 132"/>
            <p:cNvSpPr txBox="1"/>
            <p:nvPr/>
          </p:nvSpPr>
          <p:spPr>
            <a:xfrm>
              <a:off x="6513385" y="-1042472"/>
              <a:ext cx="5687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H1975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/>
            <p:cNvSpPr txBox="1"/>
            <p:nvPr/>
          </p:nvSpPr>
          <p:spPr>
            <a:xfrm>
              <a:off x="7649665" y="-1126597"/>
              <a:ext cx="5687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H358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/>
            <p:cNvSpPr txBox="1"/>
            <p:nvPr/>
          </p:nvSpPr>
          <p:spPr>
            <a:xfrm>
              <a:off x="4796095" y="-243073"/>
              <a:ext cx="58499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36" name="直接连接符 135"/>
          <p:cNvCxnSpPr/>
          <p:nvPr/>
        </p:nvCxnSpPr>
        <p:spPr>
          <a:xfrm>
            <a:off x="4396325" y="2904687"/>
            <a:ext cx="10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38" name="组合 137"/>
          <p:cNvGrpSpPr/>
          <p:nvPr/>
        </p:nvGrpSpPr>
        <p:grpSpPr>
          <a:xfrm>
            <a:off x="3294133" y="2725834"/>
            <a:ext cx="967620" cy="204691"/>
            <a:chOff x="5741590" y="166195"/>
            <a:chExt cx="1030793" cy="239562"/>
          </a:xfrm>
        </p:grpSpPr>
        <p:sp>
          <p:nvSpPr>
            <p:cNvPr id="139" name="文本框 138"/>
            <p:cNvSpPr txBox="1"/>
            <p:nvPr/>
          </p:nvSpPr>
          <p:spPr>
            <a:xfrm>
              <a:off x="5791639" y="171620"/>
              <a:ext cx="531816" cy="2341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FTH1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矩形 139"/>
            <p:cNvSpPr/>
            <p:nvPr/>
          </p:nvSpPr>
          <p:spPr>
            <a:xfrm>
              <a:off x="6224468" y="241894"/>
              <a:ext cx="87262" cy="72791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文本框 140"/>
            <p:cNvSpPr txBox="1"/>
            <p:nvPr/>
          </p:nvSpPr>
          <p:spPr>
            <a:xfrm>
              <a:off x="6258707" y="166195"/>
              <a:ext cx="513676" cy="2341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FTL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矩形 141"/>
            <p:cNvSpPr/>
            <p:nvPr/>
          </p:nvSpPr>
          <p:spPr>
            <a:xfrm>
              <a:off x="5741590" y="249844"/>
              <a:ext cx="100970" cy="70937"/>
            </a:xfrm>
            <a:prstGeom prst="rect">
              <a:avLst/>
            </a:prstGeom>
            <a:solidFill>
              <a:srgbClr val="0F08F7"/>
            </a:solidFill>
            <a:ln>
              <a:solidFill>
                <a:srgbClr val="0F08F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3" name="文本框 142"/>
          <p:cNvSpPr txBox="1"/>
          <p:nvPr/>
        </p:nvSpPr>
        <p:spPr>
          <a:xfrm>
            <a:off x="2601599" y="264291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直接连接符 143"/>
          <p:cNvCxnSpPr/>
          <p:nvPr/>
        </p:nvCxnSpPr>
        <p:spPr>
          <a:xfrm>
            <a:off x="3271850" y="2994441"/>
            <a:ext cx="10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直接连接符 144"/>
          <p:cNvCxnSpPr/>
          <p:nvPr/>
        </p:nvCxnSpPr>
        <p:spPr>
          <a:xfrm>
            <a:off x="5430308" y="2813021"/>
            <a:ext cx="104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46" name="组合 145"/>
          <p:cNvGrpSpPr/>
          <p:nvPr/>
        </p:nvGrpSpPr>
        <p:grpSpPr>
          <a:xfrm>
            <a:off x="166816" y="3810258"/>
            <a:ext cx="2147931" cy="1376725"/>
            <a:chOff x="175333" y="1710568"/>
            <a:chExt cx="2147931" cy="1376725"/>
          </a:xfrm>
        </p:grpSpPr>
        <p:grpSp>
          <p:nvGrpSpPr>
            <p:cNvPr id="147" name="组合 146"/>
            <p:cNvGrpSpPr/>
            <p:nvPr/>
          </p:nvGrpSpPr>
          <p:grpSpPr>
            <a:xfrm>
              <a:off x="228471" y="1808679"/>
              <a:ext cx="2094793" cy="1278614"/>
              <a:chOff x="2338314" y="1762807"/>
              <a:chExt cx="2094793" cy="1278614"/>
            </a:xfrm>
          </p:grpSpPr>
          <p:grpSp>
            <p:nvGrpSpPr>
              <p:cNvPr id="149" name="组合 148"/>
              <p:cNvGrpSpPr/>
              <p:nvPr/>
            </p:nvGrpSpPr>
            <p:grpSpPr>
              <a:xfrm>
                <a:off x="2338314" y="1762807"/>
                <a:ext cx="2094793" cy="1278614"/>
                <a:chOff x="2288784" y="1762807"/>
                <a:chExt cx="2094793" cy="1278614"/>
              </a:xfrm>
            </p:grpSpPr>
            <p:grpSp>
              <p:nvGrpSpPr>
                <p:cNvPr id="153" name="组合 152"/>
                <p:cNvGrpSpPr/>
                <p:nvPr/>
              </p:nvGrpSpPr>
              <p:grpSpPr>
                <a:xfrm>
                  <a:off x="2470210" y="1762807"/>
                  <a:ext cx="1913367" cy="1278614"/>
                  <a:chOff x="528102" y="1563798"/>
                  <a:chExt cx="2801360" cy="1872018"/>
                </a:xfrm>
              </p:grpSpPr>
              <p:pic>
                <p:nvPicPr>
                  <p:cNvPr id="157" name="图片 156"/>
                  <p:cNvPicPr>
                    <a:picLocks noChangeAspect="1"/>
                  </p:cNvPicPr>
                  <p:nvPr/>
                </p:nvPicPr>
                <p:blipFill rotWithShape="1">
                  <a:blip r:embed="rId20"/>
                  <a:srcRect l="5337"/>
                  <a:stretch>
                    <a:fillRect/>
                  </a:stretch>
                </p:blipFill>
                <p:spPr>
                  <a:xfrm>
                    <a:off x="528102" y="1786857"/>
                    <a:ext cx="2750588" cy="1648959"/>
                  </a:xfrm>
                  <a:prstGeom prst="rect">
                    <a:avLst/>
                  </a:prstGeom>
                </p:spPr>
              </p:pic>
              <p:sp>
                <p:nvSpPr>
                  <p:cNvPr id="158" name="矩形 157"/>
                  <p:cNvSpPr/>
                  <p:nvPr/>
                </p:nvSpPr>
                <p:spPr>
                  <a:xfrm>
                    <a:off x="2514917" y="2193113"/>
                    <a:ext cx="136407" cy="139649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9" name="矩形 158"/>
                  <p:cNvSpPr/>
                  <p:nvPr/>
                </p:nvSpPr>
                <p:spPr>
                  <a:xfrm>
                    <a:off x="1686688" y="2190287"/>
                    <a:ext cx="136407" cy="139649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0" name="矩形 159"/>
                  <p:cNvSpPr/>
                  <p:nvPr/>
                </p:nvSpPr>
                <p:spPr>
                  <a:xfrm>
                    <a:off x="872327" y="2190287"/>
                    <a:ext cx="136407" cy="139649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61" name="直接连接符 160"/>
                  <p:cNvCxnSpPr/>
                  <p:nvPr/>
                </p:nvCxnSpPr>
                <p:spPr>
                  <a:xfrm>
                    <a:off x="2651324" y="2193115"/>
                    <a:ext cx="316201" cy="135077"/>
                  </a:xfrm>
                  <a:prstGeom prst="line">
                    <a:avLst/>
                  </a:prstGeom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2" name="直接连接符 161"/>
                  <p:cNvCxnSpPr/>
                  <p:nvPr/>
                </p:nvCxnSpPr>
                <p:spPr>
                  <a:xfrm>
                    <a:off x="2654088" y="2337918"/>
                    <a:ext cx="286690" cy="207511"/>
                  </a:xfrm>
                  <a:prstGeom prst="line">
                    <a:avLst/>
                  </a:prstGeom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3" name="矩形 162"/>
                  <p:cNvSpPr/>
                  <p:nvPr/>
                </p:nvSpPr>
                <p:spPr>
                  <a:xfrm>
                    <a:off x="2516725" y="3024917"/>
                    <a:ext cx="112734" cy="115414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4" name="矩形 163"/>
                  <p:cNvSpPr/>
                  <p:nvPr/>
                </p:nvSpPr>
                <p:spPr>
                  <a:xfrm>
                    <a:off x="1688497" y="3022089"/>
                    <a:ext cx="112734" cy="115414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5" name="矩形 164"/>
                  <p:cNvSpPr/>
                  <p:nvPr/>
                </p:nvSpPr>
                <p:spPr>
                  <a:xfrm>
                    <a:off x="874136" y="3022089"/>
                    <a:ext cx="112734" cy="115414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66" name="直接连接符 165"/>
                  <p:cNvCxnSpPr/>
                  <p:nvPr/>
                </p:nvCxnSpPr>
                <p:spPr>
                  <a:xfrm>
                    <a:off x="2625809" y="3022088"/>
                    <a:ext cx="335877" cy="78995"/>
                  </a:xfrm>
                  <a:prstGeom prst="line">
                    <a:avLst/>
                  </a:prstGeom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7" name="直接连接符 166"/>
                  <p:cNvCxnSpPr/>
                  <p:nvPr/>
                </p:nvCxnSpPr>
                <p:spPr>
                  <a:xfrm>
                    <a:off x="2625809" y="3151299"/>
                    <a:ext cx="335877" cy="192468"/>
                  </a:xfrm>
                  <a:prstGeom prst="line">
                    <a:avLst/>
                  </a:prstGeom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8" name="文本框 167"/>
                  <p:cNvSpPr txBox="1"/>
                  <p:nvPr/>
                </p:nvSpPr>
                <p:spPr>
                  <a:xfrm>
                    <a:off x="667287" y="1563798"/>
                    <a:ext cx="2662175" cy="2929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TH1              LC3             Merge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54" name="文本框 153"/>
                <p:cNvSpPr txBox="1"/>
                <p:nvPr/>
              </p:nvSpPr>
              <p:spPr>
                <a:xfrm>
                  <a:off x="2408976" y="2289728"/>
                  <a:ext cx="496251" cy="20005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700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 </a:t>
                  </a:r>
                  <a:endParaRPr lang="zh-CN" altLang="en-US" sz="7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文本框 154"/>
                <p:cNvSpPr txBox="1"/>
                <p:nvPr/>
              </p:nvSpPr>
              <p:spPr>
                <a:xfrm>
                  <a:off x="2288784" y="2087502"/>
                  <a:ext cx="22044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6" name="文本框 155"/>
                <p:cNvSpPr txBox="1"/>
                <p:nvPr/>
              </p:nvSpPr>
              <p:spPr>
                <a:xfrm rot="16200000">
                  <a:off x="2019866" y="2494324"/>
                  <a:ext cx="74531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 mg/ml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0" name="组合 149"/>
              <p:cNvGrpSpPr/>
              <p:nvPr/>
            </p:nvGrpSpPr>
            <p:grpSpPr>
              <a:xfrm>
                <a:off x="2465805" y="2822055"/>
                <a:ext cx="362600" cy="169277"/>
                <a:chOff x="2707682" y="2815307"/>
                <a:chExt cx="362600" cy="169277"/>
              </a:xfrm>
            </p:grpSpPr>
            <p:sp>
              <p:nvSpPr>
                <p:cNvPr id="151" name="文本框 150"/>
                <p:cNvSpPr txBox="1"/>
                <p:nvPr/>
              </p:nvSpPr>
              <p:spPr>
                <a:xfrm>
                  <a:off x="2707682" y="2815307"/>
                  <a:ext cx="36260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5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 </a:t>
                  </a:r>
                  <a:r>
                    <a:rPr lang="el-GR" altLang="zh-CN" sz="5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CN" sz="5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CN" altLang="en-US" sz="5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2" name="直接连接符 151"/>
                <p:cNvCxnSpPr/>
                <p:nvPr/>
              </p:nvCxnSpPr>
              <p:spPr>
                <a:xfrm>
                  <a:off x="2815888" y="2953878"/>
                  <a:ext cx="157961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48" name="文本框 147"/>
            <p:cNvSpPr txBox="1"/>
            <p:nvPr/>
          </p:nvSpPr>
          <p:spPr>
            <a:xfrm>
              <a:off x="175333" y="1710568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9" name="组合 168"/>
          <p:cNvGrpSpPr/>
          <p:nvPr/>
        </p:nvGrpSpPr>
        <p:grpSpPr>
          <a:xfrm>
            <a:off x="2330073" y="3769238"/>
            <a:ext cx="2150288" cy="1387414"/>
            <a:chOff x="2313191" y="1669548"/>
            <a:chExt cx="2150288" cy="1387414"/>
          </a:xfrm>
        </p:grpSpPr>
        <p:grpSp>
          <p:nvGrpSpPr>
            <p:cNvPr id="170" name="组合 169"/>
            <p:cNvGrpSpPr/>
            <p:nvPr/>
          </p:nvGrpSpPr>
          <p:grpSpPr>
            <a:xfrm>
              <a:off x="2390834" y="1789712"/>
              <a:ext cx="2072645" cy="1267250"/>
              <a:chOff x="4500677" y="1743840"/>
              <a:chExt cx="2072645" cy="1267250"/>
            </a:xfrm>
          </p:grpSpPr>
          <p:grpSp>
            <p:nvGrpSpPr>
              <p:cNvPr id="172" name="组合 171"/>
              <p:cNvGrpSpPr/>
              <p:nvPr/>
            </p:nvGrpSpPr>
            <p:grpSpPr>
              <a:xfrm>
                <a:off x="4664235" y="1916439"/>
                <a:ext cx="1909087" cy="1094651"/>
                <a:chOff x="4544842" y="4068863"/>
                <a:chExt cx="2243065" cy="1231757"/>
              </a:xfrm>
            </p:grpSpPr>
            <p:pic>
              <p:nvPicPr>
                <p:cNvPr id="180" name="图片 179"/>
                <p:cNvPicPr>
                  <a:picLocks noChangeAspect="1"/>
                </p:cNvPicPr>
                <p:nvPr/>
              </p:nvPicPr>
              <p:blipFill rotWithShape="1">
                <a:blip r:embed="rId21"/>
                <a:srcRect r="3525"/>
                <a:stretch>
                  <a:fillRect/>
                </a:stretch>
              </p:blipFill>
              <p:spPr>
                <a:xfrm>
                  <a:off x="4544842" y="4068863"/>
                  <a:ext cx="2243065" cy="1231757"/>
                </a:xfrm>
                <a:prstGeom prst="rect">
                  <a:avLst/>
                </a:prstGeom>
              </p:spPr>
            </p:pic>
            <p:sp>
              <p:nvSpPr>
                <p:cNvPr id="181" name="矩形 180"/>
                <p:cNvSpPr/>
                <p:nvPr/>
              </p:nvSpPr>
              <p:spPr>
                <a:xfrm>
                  <a:off x="6318713" y="4263745"/>
                  <a:ext cx="90469" cy="88703"/>
                </a:xfrm>
                <a:prstGeom prst="rect">
                  <a:avLst/>
                </a:prstGeom>
                <a:noFill/>
                <a:ln w="3175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2" name="矩形 181"/>
                <p:cNvSpPr/>
                <p:nvPr/>
              </p:nvSpPr>
              <p:spPr>
                <a:xfrm>
                  <a:off x="5654058" y="4261572"/>
                  <a:ext cx="90469" cy="88703"/>
                </a:xfrm>
                <a:prstGeom prst="rect">
                  <a:avLst/>
                </a:prstGeom>
                <a:noFill/>
                <a:ln w="3175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3" name="矩形 182"/>
                <p:cNvSpPr/>
                <p:nvPr/>
              </p:nvSpPr>
              <p:spPr>
                <a:xfrm>
                  <a:off x="5000534" y="4261572"/>
                  <a:ext cx="90469" cy="88703"/>
                </a:xfrm>
                <a:prstGeom prst="rect">
                  <a:avLst/>
                </a:prstGeom>
                <a:noFill/>
                <a:ln w="3175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84" name="直接连接符 183"/>
                <p:cNvCxnSpPr/>
                <p:nvPr/>
              </p:nvCxnSpPr>
              <p:spPr>
                <a:xfrm>
                  <a:off x="6409181" y="4267939"/>
                  <a:ext cx="151972" cy="224692"/>
                </a:xfrm>
                <a:prstGeom prst="line">
                  <a:avLst/>
                </a:prstGeom>
                <a:ln w="3175">
                  <a:solidFill>
                    <a:schemeClr val="bg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5" name="直接连接符 184"/>
                <p:cNvCxnSpPr/>
                <p:nvPr/>
              </p:nvCxnSpPr>
              <p:spPr>
                <a:xfrm>
                  <a:off x="6411400" y="4348822"/>
                  <a:ext cx="149753" cy="315993"/>
                </a:xfrm>
                <a:prstGeom prst="line">
                  <a:avLst/>
                </a:prstGeom>
                <a:ln w="3175">
                  <a:solidFill>
                    <a:schemeClr val="bg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6" name="矩形 185"/>
                <p:cNvSpPr/>
                <p:nvPr/>
              </p:nvSpPr>
              <p:spPr>
                <a:xfrm>
                  <a:off x="6262563" y="5038074"/>
                  <a:ext cx="90469" cy="88703"/>
                </a:xfrm>
                <a:prstGeom prst="rect">
                  <a:avLst/>
                </a:prstGeom>
                <a:noFill/>
                <a:ln w="3175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7" name="矩形 186"/>
                <p:cNvSpPr/>
                <p:nvPr/>
              </p:nvSpPr>
              <p:spPr>
                <a:xfrm>
                  <a:off x="5597907" y="5035901"/>
                  <a:ext cx="90469" cy="88703"/>
                </a:xfrm>
                <a:prstGeom prst="rect">
                  <a:avLst/>
                </a:prstGeom>
                <a:noFill/>
                <a:ln w="3175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8" name="矩形 187"/>
                <p:cNvSpPr/>
                <p:nvPr/>
              </p:nvSpPr>
              <p:spPr>
                <a:xfrm>
                  <a:off x="4944383" y="5035901"/>
                  <a:ext cx="90469" cy="88703"/>
                </a:xfrm>
                <a:prstGeom prst="rect">
                  <a:avLst/>
                </a:prstGeom>
                <a:noFill/>
                <a:ln w="3175"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89" name="直接连接符 188"/>
                <p:cNvCxnSpPr/>
                <p:nvPr/>
              </p:nvCxnSpPr>
              <p:spPr>
                <a:xfrm>
                  <a:off x="6353031" y="5042267"/>
                  <a:ext cx="205971" cy="44381"/>
                </a:xfrm>
                <a:prstGeom prst="line">
                  <a:avLst/>
                </a:prstGeom>
                <a:ln w="3175">
                  <a:solidFill>
                    <a:schemeClr val="bg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0" name="直接连接符 189"/>
                <p:cNvCxnSpPr/>
                <p:nvPr/>
              </p:nvCxnSpPr>
              <p:spPr>
                <a:xfrm>
                  <a:off x="6355251" y="5123151"/>
                  <a:ext cx="203752" cy="150012"/>
                </a:xfrm>
                <a:prstGeom prst="line">
                  <a:avLst/>
                </a:prstGeom>
                <a:ln w="3175">
                  <a:solidFill>
                    <a:schemeClr val="bg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3" name="文本框 172"/>
              <p:cNvSpPr txBox="1"/>
              <p:nvPr/>
            </p:nvSpPr>
            <p:spPr>
              <a:xfrm>
                <a:off x="4753364" y="1743840"/>
                <a:ext cx="180777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TH1             LAMP1           Merge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文本框 173"/>
              <p:cNvSpPr txBox="1"/>
              <p:nvPr/>
            </p:nvSpPr>
            <p:spPr>
              <a:xfrm>
                <a:off x="4609208" y="2283571"/>
                <a:ext cx="496251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7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 </a:t>
                </a:r>
                <a:endParaRPr lang="zh-CN" altLang="en-US" sz="7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文本框 174"/>
              <p:cNvSpPr txBox="1"/>
              <p:nvPr/>
            </p:nvSpPr>
            <p:spPr>
              <a:xfrm>
                <a:off x="4500677" y="2093029"/>
                <a:ext cx="22044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文本框 175"/>
              <p:cNvSpPr txBox="1"/>
              <p:nvPr/>
            </p:nvSpPr>
            <p:spPr>
              <a:xfrm rot="16200000">
                <a:off x="4231759" y="2499851"/>
                <a:ext cx="74531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 mg/m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77" name="组合 176"/>
              <p:cNvGrpSpPr/>
              <p:nvPr/>
            </p:nvGrpSpPr>
            <p:grpSpPr>
              <a:xfrm>
                <a:off x="4639095" y="2813622"/>
                <a:ext cx="362600" cy="169277"/>
                <a:chOff x="2714032" y="2821657"/>
                <a:chExt cx="362600" cy="169277"/>
              </a:xfrm>
            </p:grpSpPr>
            <p:sp>
              <p:nvSpPr>
                <p:cNvPr id="178" name="文本框 177"/>
                <p:cNvSpPr txBox="1"/>
                <p:nvPr/>
              </p:nvSpPr>
              <p:spPr>
                <a:xfrm>
                  <a:off x="2714032" y="2821657"/>
                  <a:ext cx="36260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5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 </a:t>
                  </a:r>
                  <a:r>
                    <a:rPr lang="el-GR" altLang="zh-CN" sz="5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CN" sz="5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CN" altLang="en-US" sz="5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9" name="直接连接符 178"/>
                <p:cNvCxnSpPr/>
                <p:nvPr/>
              </p:nvCxnSpPr>
              <p:spPr>
                <a:xfrm>
                  <a:off x="2815888" y="2953878"/>
                  <a:ext cx="157961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71" name="文本框 170"/>
            <p:cNvSpPr txBox="1"/>
            <p:nvPr/>
          </p:nvSpPr>
          <p:spPr>
            <a:xfrm>
              <a:off x="2313191" y="1669548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1" name="组合 190"/>
          <p:cNvGrpSpPr/>
          <p:nvPr/>
        </p:nvGrpSpPr>
        <p:grpSpPr>
          <a:xfrm>
            <a:off x="4408641" y="3773949"/>
            <a:ext cx="2178721" cy="1392916"/>
            <a:chOff x="4417158" y="1674260"/>
            <a:chExt cx="2178721" cy="1392916"/>
          </a:xfrm>
        </p:grpSpPr>
        <p:grpSp>
          <p:nvGrpSpPr>
            <p:cNvPr id="192" name="组合 191"/>
            <p:cNvGrpSpPr/>
            <p:nvPr/>
          </p:nvGrpSpPr>
          <p:grpSpPr>
            <a:xfrm>
              <a:off x="4590301" y="1787630"/>
              <a:ext cx="2005578" cy="1279546"/>
              <a:chOff x="237532" y="1749849"/>
              <a:chExt cx="2005578" cy="1279546"/>
            </a:xfrm>
          </p:grpSpPr>
          <p:sp>
            <p:nvSpPr>
              <p:cNvPr id="194" name="文本框 193"/>
              <p:cNvSpPr txBox="1"/>
              <p:nvPr/>
            </p:nvSpPr>
            <p:spPr>
              <a:xfrm>
                <a:off x="462868" y="1749849"/>
                <a:ext cx="159567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C3              NCOA4         Merge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5" name="组合 194"/>
              <p:cNvGrpSpPr/>
              <p:nvPr/>
            </p:nvGrpSpPr>
            <p:grpSpPr>
              <a:xfrm>
                <a:off x="237532" y="1934361"/>
                <a:ext cx="2005578" cy="1095034"/>
                <a:chOff x="843471" y="968185"/>
                <a:chExt cx="3471786" cy="1906769"/>
              </a:xfrm>
            </p:grpSpPr>
            <p:pic>
              <p:nvPicPr>
                <p:cNvPr id="200" name="图片 199"/>
                <p:cNvPicPr>
                  <a:picLocks noChangeAspect="1"/>
                </p:cNvPicPr>
                <p:nvPr/>
              </p:nvPicPr>
              <p:blipFill rotWithShape="1">
                <a:blip r:embed="rId22" cstate="print">
                  <a:extLst>
                    <a:ext uri="{BEBA8EAE-BF5A-486C-A8C5-ECC9F3942E4B}">
                      <a14:imgProps xmlns:a14="http://schemas.microsoft.com/office/drawing/2010/main">
                        <a14:imgLayer r:embed="rId23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643" t="42810" r="60068" b="45924"/>
                <a:stretch>
                  <a:fillRect/>
                </a:stretch>
              </p:blipFill>
              <p:spPr>
                <a:xfrm>
                  <a:off x="1144010" y="968244"/>
                  <a:ext cx="903600" cy="903600"/>
                </a:xfrm>
                <a:prstGeom prst="rect">
                  <a:avLst/>
                </a:prstGeom>
              </p:spPr>
            </p:pic>
            <p:pic>
              <p:nvPicPr>
                <p:cNvPr id="201" name="图片 200"/>
                <p:cNvPicPr>
                  <a:picLocks noChangeAspect="1"/>
                </p:cNvPicPr>
                <p:nvPr/>
              </p:nvPicPr>
              <p:blipFill rotWithShape="1">
                <a:blip r:embed="rId24" cstate="print"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609" t="42810" r="43102" b="45924"/>
                <a:stretch>
                  <a:fillRect/>
                </a:stretch>
              </p:blipFill>
              <p:spPr>
                <a:xfrm>
                  <a:off x="2087170" y="968185"/>
                  <a:ext cx="903600" cy="903600"/>
                </a:xfrm>
                <a:prstGeom prst="rect">
                  <a:avLst/>
                </a:prstGeom>
              </p:spPr>
            </p:pic>
            <p:pic>
              <p:nvPicPr>
                <p:cNvPr id="202" name="图片 201"/>
                <p:cNvPicPr>
                  <a:picLocks noChangeAspect="1"/>
                </p:cNvPicPr>
                <p:nvPr/>
              </p:nvPicPr>
              <p:blipFill rotWithShape="1">
                <a:blip r:embed="rId24" cstate="print"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180" t="42810" r="26529" b="45924"/>
                <a:stretch>
                  <a:fillRect/>
                </a:stretch>
              </p:blipFill>
              <p:spPr>
                <a:xfrm>
                  <a:off x="3037300" y="969298"/>
                  <a:ext cx="903600" cy="903600"/>
                </a:xfrm>
                <a:prstGeom prst="rect">
                  <a:avLst/>
                </a:prstGeom>
              </p:spPr>
            </p:pic>
            <p:pic>
              <p:nvPicPr>
                <p:cNvPr id="203" name="图片 202"/>
                <p:cNvPicPr>
                  <a:picLocks noChangeAspect="1"/>
                </p:cNvPicPr>
                <p:nvPr/>
              </p:nvPicPr>
              <p:blipFill rotWithShape="1">
                <a:blip r:embed="rId26" cstate="print">
                  <a:extLst>
                    <a:ext uri="{BEBA8EAE-BF5A-486C-A8C5-ECC9F3942E4B}">
                      <a14:imgProps xmlns:a14="http://schemas.microsoft.com/office/drawing/2010/main">
                        <a14:imgLayer r:embed="rId27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6116" t="40240" r="18058" b="43348"/>
                <a:stretch>
                  <a:fillRect/>
                </a:stretch>
              </p:blipFill>
              <p:spPr>
                <a:xfrm>
                  <a:off x="3965622" y="968185"/>
                  <a:ext cx="328555" cy="927631"/>
                </a:xfrm>
                <a:prstGeom prst="rect">
                  <a:avLst/>
                </a:prstGeom>
              </p:spPr>
            </p:pic>
            <p:grpSp>
              <p:nvGrpSpPr>
                <p:cNvPr id="204" name="组合 203"/>
                <p:cNvGrpSpPr/>
                <p:nvPr/>
              </p:nvGrpSpPr>
              <p:grpSpPr>
                <a:xfrm>
                  <a:off x="843471" y="1225176"/>
                  <a:ext cx="3471786" cy="1649778"/>
                  <a:chOff x="40726" y="4723733"/>
                  <a:chExt cx="2257073" cy="1070229"/>
                </a:xfrm>
              </p:grpSpPr>
              <p:pic>
                <p:nvPicPr>
                  <p:cNvPr id="205" name="图片 204"/>
                  <p:cNvPicPr>
                    <a:picLocks noChangeAspect="1"/>
                  </p:cNvPicPr>
                  <p:nvPr/>
                </p:nvPicPr>
                <p:blipFill rotWithShape="1">
                  <a:blip r:embed="rId28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29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4472" t="56321" r="17685" b="26188"/>
                  <a:stretch>
                    <a:fillRect/>
                  </a:stretch>
                </p:blipFill>
                <p:spPr>
                  <a:xfrm>
                    <a:off x="176838" y="5152599"/>
                    <a:ext cx="2120961" cy="641363"/>
                  </a:xfrm>
                  <a:prstGeom prst="rect">
                    <a:avLst/>
                  </a:prstGeom>
                </p:spPr>
              </p:pic>
              <p:sp>
                <p:nvSpPr>
                  <p:cNvPr id="206" name="文本框 205"/>
                  <p:cNvSpPr txBox="1"/>
                  <p:nvPr/>
                </p:nvSpPr>
                <p:spPr>
                  <a:xfrm>
                    <a:off x="40726" y="4723733"/>
                    <a:ext cx="248093" cy="22598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7" name="文本框 206"/>
                  <p:cNvSpPr txBox="1"/>
                  <p:nvPr/>
                </p:nvSpPr>
                <p:spPr>
                  <a:xfrm rot="16200000">
                    <a:off x="-263477" y="5183696"/>
                    <a:ext cx="841897" cy="2251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 mg/ml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8" name="矩形 207"/>
                  <p:cNvSpPr/>
                  <p:nvPr/>
                </p:nvSpPr>
                <p:spPr>
                  <a:xfrm>
                    <a:off x="1688447" y="5590212"/>
                    <a:ext cx="82800" cy="83214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9" name="矩形 208"/>
                  <p:cNvSpPr/>
                  <p:nvPr/>
                </p:nvSpPr>
                <p:spPr>
                  <a:xfrm>
                    <a:off x="1072860" y="5590212"/>
                    <a:ext cx="82800" cy="83214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0" name="矩形 209"/>
                  <p:cNvSpPr/>
                  <p:nvPr/>
                </p:nvSpPr>
                <p:spPr>
                  <a:xfrm>
                    <a:off x="457273" y="5590212"/>
                    <a:ext cx="82800" cy="83214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1" name="矩形 210"/>
                  <p:cNvSpPr/>
                  <p:nvPr/>
                </p:nvSpPr>
                <p:spPr>
                  <a:xfrm>
                    <a:off x="1705687" y="4881470"/>
                    <a:ext cx="82800" cy="83214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2" name="矩形 211"/>
                  <p:cNvSpPr/>
                  <p:nvPr/>
                </p:nvSpPr>
                <p:spPr>
                  <a:xfrm>
                    <a:off x="1090100" y="4881470"/>
                    <a:ext cx="82800" cy="83214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3" name="矩形 212"/>
                  <p:cNvSpPr/>
                  <p:nvPr/>
                </p:nvSpPr>
                <p:spPr>
                  <a:xfrm>
                    <a:off x="474513" y="4881470"/>
                    <a:ext cx="82800" cy="83214"/>
                  </a:xfrm>
                  <a:prstGeom prst="rect">
                    <a:avLst/>
                  </a:prstGeom>
                  <a:noFill/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14" name="直接连接符 213"/>
                  <p:cNvCxnSpPr>
                    <a:stCxn id="208" idx="0"/>
                  </p:cNvCxnSpPr>
                  <p:nvPr/>
                </p:nvCxnSpPr>
                <p:spPr>
                  <a:xfrm flipV="1">
                    <a:off x="1729847" y="5568283"/>
                    <a:ext cx="336318" cy="21929"/>
                  </a:xfrm>
                  <a:prstGeom prst="line">
                    <a:avLst/>
                  </a:prstGeom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5" name="直接连接符 214"/>
                  <p:cNvCxnSpPr/>
                  <p:nvPr/>
                </p:nvCxnSpPr>
                <p:spPr>
                  <a:xfrm>
                    <a:off x="1774595" y="5673426"/>
                    <a:ext cx="291570" cy="81373"/>
                  </a:xfrm>
                  <a:prstGeom prst="line">
                    <a:avLst/>
                  </a:prstGeom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6" name="直接连接符 215"/>
                  <p:cNvCxnSpPr/>
                  <p:nvPr/>
                </p:nvCxnSpPr>
                <p:spPr>
                  <a:xfrm>
                    <a:off x="1788487" y="4887836"/>
                    <a:ext cx="289537" cy="74459"/>
                  </a:xfrm>
                  <a:prstGeom prst="line">
                    <a:avLst/>
                  </a:prstGeom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7" name="直接连接符 216"/>
                  <p:cNvCxnSpPr/>
                  <p:nvPr/>
                </p:nvCxnSpPr>
                <p:spPr>
                  <a:xfrm>
                    <a:off x="1795561" y="4971050"/>
                    <a:ext cx="277269" cy="165602"/>
                  </a:xfrm>
                  <a:prstGeom prst="line">
                    <a:avLst/>
                  </a:prstGeom>
                  <a:ln w="3175">
                    <a:solidFill>
                      <a:schemeClr val="bg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96" name="文本框 195"/>
              <p:cNvSpPr txBox="1"/>
              <p:nvPr/>
            </p:nvSpPr>
            <p:spPr>
              <a:xfrm>
                <a:off x="313387" y="2289529"/>
                <a:ext cx="496251" cy="20005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7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 </a:t>
                </a:r>
                <a:endParaRPr lang="zh-CN" altLang="en-US" sz="7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7" name="组合 196"/>
              <p:cNvGrpSpPr/>
              <p:nvPr/>
            </p:nvGrpSpPr>
            <p:grpSpPr>
              <a:xfrm>
                <a:off x="322213" y="2829037"/>
                <a:ext cx="362600" cy="169277"/>
                <a:chOff x="2707682" y="2831817"/>
                <a:chExt cx="362600" cy="169277"/>
              </a:xfrm>
            </p:grpSpPr>
            <p:sp>
              <p:nvSpPr>
                <p:cNvPr id="198" name="文本框 197"/>
                <p:cNvSpPr txBox="1"/>
                <p:nvPr/>
              </p:nvSpPr>
              <p:spPr>
                <a:xfrm>
                  <a:off x="2707682" y="2831817"/>
                  <a:ext cx="36260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5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0 </a:t>
                  </a:r>
                  <a:r>
                    <a:rPr lang="el-GR" altLang="zh-CN" sz="5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altLang="zh-CN" sz="5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zh-CN" altLang="en-US" sz="5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9" name="直接连接符 198"/>
                <p:cNvCxnSpPr/>
                <p:nvPr/>
              </p:nvCxnSpPr>
              <p:spPr>
                <a:xfrm>
                  <a:off x="2815888" y="2964038"/>
                  <a:ext cx="157961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93" name="文本框 192"/>
            <p:cNvSpPr txBox="1"/>
            <p:nvPr/>
          </p:nvSpPr>
          <p:spPr>
            <a:xfrm>
              <a:off x="4417158" y="1674260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8" name="组合 217"/>
          <p:cNvGrpSpPr/>
          <p:nvPr/>
        </p:nvGrpSpPr>
        <p:grpSpPr>
          <a:xfrm>
            <a:off x="239082" y="5412327"/>
            <a:ext cx="2695302" cy="1674198"/>
            <a:chOff x="279989" y="3349225"/>
            <a:chExt cx="1962037" cy="1218806"/>
          </a:xfrm>
        </p:grpSpPr>
        <p:grpSp>
          <p:nvGrpSpPr>
            <p:cNvPr id="219" name="组合 218"/>
            <p:cNvGrpSpPr/>
            <p:nvPr/>
          </p:nvGrpSpPr>
          <p:grpSpPr>
            <a:xfrm>
              <a:off x="279989" y="3349225"/>
              <a:ext cx="1962037" cy="1218806"/>
              <a:chOff x="3416221" y="5355366"/>
              <a:chExt cx="3374627" cy="2514095"/>
            </a:xfrm>
          </p:grpSpPr>
          <p:grpSp>
            <p:nvGrpSpPr>
              <p:cNvPr id="222" name="组合 221"/>
              <p:cNvGrpSpPr/>
              <p:nvPr/>
            </p:nvGrpSpPr>
            <p:grpSpPr>
              <a:xfrm>
                <a:off x="3416221" y="5355366"/>
                <a:ext cx="3374627" cy="2514095"/>
                <a:chOff x="184785" y="2066180"/>
                <a:chExt cx="3891831" cy="2514092"/>
              </a:xfrm>
            </p:grpSpPr>
            <p:pic>
              <p:nvPicPr>
                <p:cNvPr id="227" name="图片 226"/>
                <p:cNvPicPr>
                  <a:picLocks noChangeAspect="1"/>
                </p:cNvPicPr>
                <p:nvPr/>
              </p:nvPicPr>
              <p:blipFill rotWithShape="1">
                <a:blip r:embed="rId3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20620"/>
                <a:stretch>
                  <a:fillRect/>
                </a:stretch>
              </p:blipFill>
              <p:spPr>
                <a:xfrm>
                  <a:off x="388278" y="2257071"/>
                  <a:ext cx="3688338" cy="2323201"/>
                </a:xfrm>
                <a:prstGeom prst="rect">
                  <a:avLst/>
                </a:prstGeom>
                <a:ln w="9525">
                  <a:noFill/>
                </a:ln>
              </p:spPr>
            </p:pic>
            <p:sp>
              <p:nvSpPr>
                <p:cNvPr id="228" name="文本框 227"/>
                <p:cNvSpPr txBox="1"/>
                <p:nvPr/>
              </p:nvSpPr>
              <p:spPr>
                <a:xfrm>
                  <a:off x="483493" y="2066180"/>
                  <a:ext cx="3329415" cy="30041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erroOrange</a:t>
                  </a: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</a:t>
                  </a:r>
                  <a:r>
                    <a:rPr lang="en-US" altLang="zh-CN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LysoTracker</a:t>
                  </a: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    Merge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9" name="文本框 228"/>
                <p:cNvSpPr txBox="1"/>
                <p:nvPr/>
              </p:nvSpPr>
              <p:spPr>
                <a:xfrm rot="16200000">
                  <a:off x="-236245" y="3622258"/>
                  <a:ext cx="1154838" cy="2888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 mg/ml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0" name="文本框 229"/>
                <p:cNvSpPr txBox="1"/>
                <p:nvPr/>
              </p:nvSpPr>
              <p:spPr>
                <a:xfrm>
                  <a:off x="184785" y="2716414"/>
                  <a:ext cx="338400" cy="30041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1" name="任意多边形: 形状 230"/>
                <p:cNvSpPr/>
                <p:nvPr/>
              </p:nvSpPr>
              <p:spPr>
                <a:xfrm>
                  <a:off x="633057" y="3996394"/>
                  <a:ext cx="212568" cy="247643"/>
                </a:xfrm>
                <a:custGeom>
                  <a:avLst/>
                  <a:gdLst>
                    <a:gd name="connsiteX0" fmla="*/ 46282 w 212568"/>
                    <a:gd name="connsiteY0" fmla="*/ 212555 h 247643"/>
                    <a:gd name="connsiteX1" fmla="*/ 13897 w 212568"/>
                    <a:gd name="connsiteY1" fmla="*/ 164930 h 247643"/>
                    <a:gd name="connsiteX2" fmla="*/ 562 w 212568"/>
                    <a:gd name="connsiteY2" fmla="*/ 96350 h 247643"/>
                    <a:gd name="connsiteX3" fmla="*/ 31042 w 212568"/>
                    <a:gd name="connsiteY3" fmla="*/ 31580 h 247643"/>
                    <a:gd name="connsiteX4" fmla="*/ 76762 w 212568"/>
                    <a:gd name="connsiteY4" fmla="*/ 3005 h 247643"/>
                    <a:gd name="connsiteX5" fmla="*/ 122482 w 212568"/>
                    <a:gd name="connsiteY5" fmla="*/ 3005 h 247643"/>
                    <a:gd name="connsiteX6" fmla="*/ 160582 w 212568"/>
                    <a:gd name="connsiteY6" fmla="*/ 22055 h 247643"/>
                    <a:gd name="connsiteX7" fmla="*/ 204397 w 212568"/>
                    <a:gd name="connsiteY7" fmla="*/ 81110 h 247643"/>
                    <a:gd name="connsiteX8" fmla="*/ 212017 w 212568"/>
                    <a:gd name="connsiteY8" fmla="*/ 134450 h 247643"/>
                    <a:gd name="connsiteX9" fmla="*/ 196777 w 212568"/>
                    <a:gd name="connsiteY9" fmla="*/ 199220 h 247643"/>
                    <a:gd name="connsiteX10" fmla="*/ 124387 w 212568"/>
                    <a:gd name="connsiteY10" fmla="*/ 246845 h 247643"/>
                    <a:gd name="connsiteX11" fmla="*/ 46282 w 212568"/>
                    <a:gd name="connsiteY11" fmla="*/ 212555 h 24764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</a:cxnLst>
                  <a:rect l="l" t="t" r="r" b="b"/>
                  <a:pathLst>
                    <a:path w="212568" h="247643">
                      <a:moveTo>
                        <a:pt x="46282" y="212555"/>
                      </a:moveTo>
                      <a:cubicBezTo>
                        <a:pt x="27867" y="198903"/>
                        <a:pt x="21517" y="184297"/>
                        <a:pt x="13897" y="164930"/>
                      </a:cubicBezTo>
                      <a:cubicBezTo>
                        <a:pt x="6277" y="145562"/>
                        <a:pt x="-2295" y="118575"/>
                        <a:pt x="562" y="96350"/>
                      </a:cubicBezTo>
                      <a:cubicBezTo>
                        <a:pt x="3419" y="74125"/>
                        <a:pt x="18342" y="47137"/>
                        <a:pt x="31042" y="31580"/>
                      </a:cubicBezTo>
                      <a:cubicBezTo>
                        <a:pt x="43742" y="16023"/>
                        <a:pt x="61522" y="7767"/>
                        <a:pt x="76762" y="3005"/>
                      </a:cubicBezTo>
                      <a:cubicBezTo>
                        <a:pt x="92002" y="-1757"/>
                        <a:pt x="108512" y="-170"/>
                        <a:pt x="122482" y="3005"/>
                      </a:cubicBezTo>
                      <a:cubicBezTo>
                        <a:pt x="136452" y="6180"/>
                        <a:pt x="146930" y="9038"/>
                        <a:pt x="160582" y="22055"/>
                      </a:cubicBezTo>
                      <a:cubicBezTo>
                        <a:pt x="174234" y="35072"/>
                        <a:pt x="195825" y="62378"/>
                        <a:pt x="204397" y="81110"/>
                      </a:cubicBezTo>
                      <a:cubicBezTo>
                        <a:pt x="212969" y="99842"/>
                        <a:pt x="213287" y="114765"/>
                        <a:pt x="212017" y="134450"/>
                      </a:cubicBezTo>
                      <a:cubicBezTo>
                        <a:pt x="210747" y="154135"/>
                        <a:pt x="211382" y="180488"/>
                        <a:pt x="196777" y="199220"/>
                      </a:cubicBezTo>
                      <a:cubicBezTo>
                        <a:pt x="182172" y="217952"/>
                        <a:pt x="145342" y="241130"/>
                        <a:pt x="124387" y="246845"/>
                      </a:cubicBezTo>
                      <a:cubicBezTo>
                        <a:pt x="103432" y="252560"/>
                        <a:pt x="64697" y="226207"/>
                        <a:pt x="46282" y="212555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2" name="文本框 231"/>
                <p:cNvSpPr txBox="1"/>
                <p:nvPr/>
              </p:nvSpPr>
              <p:spPr>
                <a:xfrm>
                  <a:off x="511516" y="3956557"/>
                  <a:ext cx="430985" cy="254198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500" dirty="0" err="1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uc</a:t>
                  </a:r>
                  <a:endParaRPr lang="zh-CN" altLang="en-US" sz="5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3" name="任意多边形: 形状 232"/>
                <p:cNvSpPr/>
                <p:nvPr/>
              </p:nvSpPr>
              <p:spPr>
                <a:xfrm>
                  <a:off x="684335" y="3189971"/>
                  <a:ext cx="225942" cy="195690"/>
                </a:xfrm>
                <a:custGeom>
                  <a:avLst/>
                  <a:gdLst>
                    <a:gd name="connsiteX0" fmla="*/ 85286 w 225942"/>
                    <a:gd name="connsiteY0" fmla="*/ 110 h 195690"/>
                    <a:gd name="connsiteX1" fmla="*/ 29406 w 225942"/>
                    <a:gd name="connsiteY1" fmla="*/ 10270 h 195690"/>
                    <a:gd name="connsiteX2" fmla="*/ 19246 w 225942"/>
                    <a:gd name="connsiteY2" fmla="*/ 25510 h 195690"/>
                    <a:gd name="connsiteX3" fmla="*/ 9086 w 225942"/>
                    <a:gd name="connsiteY3" fmla="*/ 40750 h 195690"/>
                    <a:gd name="connsiteX4" fmla="*/ 1466 w 225942"/>
                    <a:gd name="connsiteY4" fmla="*/ 66150 h 195690"/>
                    <a:gd name="connsiteX5" fmla="*/ 1466 w 225942"/>
                    <a:gd name="connsiteY5" fmla="*/ 89010 h 195690"/>
                    <a:gd name="connsiteX6" fmla="*/ 16706 w 225942"/>
                    <a:gd name="connsiteY6" fmla="*/ 116950 h 195690"/>
                    <a:gd name="connsiteX7" fmla="*/ 39566 w 225942"/>
                    <a:gd name="connsiteY7" fmla="*/ 149970 h 195690"/>
                    <a:gd name="connsiteX8" fmla="*/ 85286 w 225942"/>
                    <a:gd name="connsiteY8" fmla="*/ 180450 h 195690"/>
                    <a:gd name="connsiteX9" fmla="*/ 136086 w 225942"/>
                    <a:gd name="connsiteY9" fmla="*/ 195690 h 195690"/>
                    <a:gd name="connsiteX10" fmla="*/ 179266 w 225942"/>
                    <a:gd name="connsiteY10" fmla="*/ 180450 h 195690"/>
                    <a:gd name="connsiteX11" fmla="*/ 207206 w 225942"/>
                    <a:gd name="connsiteY11" fmla="*/ 147430 h 195690"/>
                    <a:gd name="connsiteX12" fmla="*/ 224986 w 225942"/>
                    <a:gd name="connsiteY12" fmla="*/ 119490 h 195690"/>
                    <a:gd name="connsiteX13" fmla="*/ 219906 w 225942"/>
                    <a:gd name="connsiteY13" fmla="*/ 73770 h 195690"/>
                    <a:gd name="connsiteX14" fmla="*/ 189426 w 225942"/>
                    <a:gd name="connsiteY14" fmla="*/ 35670 h 195690"/>
                    <a:gd name="connsiteX15" fmla="*/ 161486 w 225942"/>
                    <a:gd name="connsiteY15" fmla="*/ 12810 h 195690"/>
                    <a:gd name="connsiteX16" fmla="*/ 136086 w 225942"/>
                    <a:gd name="connsiteY16" fmla="*/ 5190 h 195690"/>
                    <a:gd name="connsiteX17" fmla="*/ 85286 w 225942"/>
                    <a:gd name="connsiteY17" fmla="*/ 110 h 1956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</a:cxnLst>
                  <a:rect l="l" t="t" r="r" b="b"/>
                  <a:pathLst>
                    <a:path w="225942" h="195690">
                      <a:moveTo>
                        <a:pt x="85286" y="110"/>
                      </a:moveTo>
                      <a:cubicBezTo>
                        <a:pt x="67506" y="957"/>
                        <a:pt x="40413" y="6037"/>
                        <a:pt x="29406" y="10270"/>
                      </a:cubicBezTo>
                      <a:cubicBezTo>
                        <a:pt x="18399" y="14503"/>
                        <a:pt x="22633" y="20430"/>
                        <a:pt x="19246" y="25510"/>
                      </a:cubicBezTo>
                      <a:cubicBezTo>
                        <a:pt x="15859" y="30590"/>
                        <a:pt x="12049" y="33977"/>
                        <a:pt x="9086" y="40750"/>
                      </a:cubicBezTo>
                      <a:cubicBezTo>
                        <a:pt x="6123" y="47523"/>
                        <a:pt x="2736" y="58107"/>
                        <a:pt x="1466" y="66150"/>
                      </a:cubicBezTo>
                      <a:cubicBezTo>
                        <a:pt x="196" y="74193"/>
                        <a:pt x="-1074" y="80543"/>
                        <a:pt x="1466" y="89010"/>
                      </a:cubicBezTo>
                      <a:cubicBezTo>
                        <a:pt x="4006" y="97477"/>
                        <a:pt x="10356" y="106790"/>
                        <a:pt x="16706" y="116950"/>
                      </a:cubicBezTo>
                      <a:cubicBezTo>
                        <a:pt x="23056" y="127110"/>
                        <a:pt x="28136" y="139387"/>
                        <a:pt x="39566" y="149970"/>
                      </a:cubicBezTo>
                      <a:cubicBezTo>
                        <a:pt x="50996" y="160553"/>
                        <a:pt x="69199" y="172830"/>
                        <a:pt x="85286" y="180450"/>
                      </a:cubicBezTo>
                      <a:cubicBezTo>
                        <a:pt x="101373" y="188070"/>
                        <a:pt x="120423" y="195690"/>
                        <a:pt x="136086" y="195690"/>
                      </a:cubicBezTo>
                      <a:cubicBezTo>
                        <a:pt x="151749" y="195690"/>
                        <a:pt x="167413" y="188493"/>
                        <a:pt x="179266" y="180450"/>
                      </a:cubicBezTo>
                      <a:cubicBezTo>
                        <a:pt x="191119" y="172407"/>
                        <a:pt x="199586" y="157590"/>
                        <a:pt x="207206" y="147430"/>
                      </a:cubicBezTo>
                      <a:cubicBezTo>
                        <a:pt x="214826" y="137270"/>
                        <a:pt x="222869" y="131767"/>
                        <a:pt x="224986" y="119490"/>
                      </a:cubicBezTo>
                      <a:cubicBezTo>
                        <a:pt x="227103" y="107213"/>
                        <a:pt x="225833" y="87740"/>
                        <a:pt x="219906" y="73770"/>
                      </a:cubicBezTo>
                      <a:cubicBezTo>
                        <a:pt x="213979" y="59800"/>
                        <a:pt x="199163" y="45830"/>
                        <a:pt x="189426" y="35670"/>
                      </a:cubicBezTo>
                      <a:cubicBezTo>
                        <a:pt x="179689" y="25510"/>
                        <a:pt x="170376" y="17890"/>
                        <a:pt x="161486" y="12810"/>
                      </a:cubicBezTo>
                      <a:cubicBezTo>
                        <a:pt x="152596" y="7730"/>
                        <a:pt x="143283" y="6883"/>
                        <a:pt x="136086" y="5190"/>
                      </a:cubicBezTo>
                      <a:cubicBezTo>
                        <a:pt x="128889" y="3497"/>
                        <a:pt x="103066" y="-737"/>
                        <a:pt x="85286" y="110"/>
                      </a:cubicBezTo>
                      <a:close/>
                    </a:path>
                  </a:pathLst>
                </a:custGeom>
                <a:noFill/>
                <a:ln w="317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4" name="文本框 233"/>
                <p:cNvSpPr txBox="1"/>
                <p:nvPr/>
              </p:nvSpPr>
              <p:spPr>
                <a:xfrm>
                  <a:off x="947314" y="2706877"/>
                  <a:ext cx="430985" cy="25419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500" dirty="0" err="1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uc</a:t>
                  </a:r>
                  <a:endParaRPr lang="zh-CN" altLang="en-US" sz="5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5" name="任意多边形: 形状 234"/>
                <p:cNvSpPr/>
                <p:nvPr/>
              </p:nvSpPr>
              <p:spPr>
                <a:xfrm>
                  <a:off x="1065105" y="2710497"/>
                  <a:ext cx="238269" cy="288290"/>
                </a:xfrm>
                <a:custGeom>
                  <a:avLst/>
                  <a:gdLst>
                    <a:gd name="connsiteX0" fmla="*/ 106470 w 238267"/>
                    <a:gd name="connsiteY0" fmla="*/ 159 h 288290"/>
                    <a:gd name="connsiteX1" fmla="*/ 34080 w 238267"/>
                    <a:gd name="connsiteY1" fmla="*/ 40164 h 288290"/>
                    <a:gd name="connsiteX2" fmla="*/ 20745 w 238267"/>
                    <a:gd name="connsiteY2" fmla="*/ 68739 h 288290"/>
                    <a:gd name="connsiteX3" fmla="*/ 15030 w 238267"/>
                    <a:gd name="connsiteY3" fmla="*/ 83979 h 288290"/>
                    <a:gd name="connsiteX4" fmla="*/ 3600 w 238267"/>
                    <a:gd name="connsiteY4" fmla="*/ 131604 h 288290"/>
                    <a:gd name="connsiteX5" fmla="*/ 1695 w 238267"/>
                    <a:gd name="connsiteY5" fmla="*/ 181134 h 288290"/>
                    <a:gd name="connsiteX6" fmla="*/ 26460 w 238267"/>
                    <a:gd name="connsiteY6" fmla="*/ 245904 h 288290"/>
                    <a:gd name="connsiteX7" fmla="*/ 64560 w 238267"/>
                    <a:gd name="connsiteY7" fmla="*/ 276384 h 288290"/>
                    <a:gd name="connsiteX8" fmla="*/ 98850 w 238267"/>
                    <a:gd name="connsiteY8" fmla="*/ 287814 h 288290"/>
                    <a:gd name="connsiteX9" fmla="*/ 136950 w 238267"/>
                    <a:gd name="connsiteY9" fmla="*/ 284004 h 288290"/>
                    <a:gd name="connsiteX10" fmla="*/ 178860 w 238267"/>
                    <a:gd name="connsiteY10" fmla="*/ 264954 h 288290"/>
                    <a:gd name="connsiteX11" fmla="*/ 224580 w 238267"/>
                    <a:gd name="connsiteY11" fmla="*/ 203994 h 288290"/>
                    <a:gd name="connsiteX12" fmla="*/ 237915 w 238267"/>
                    <a:gd name="connsiteY12" fmla="*/ 143034 h 288290"/>
                    <a:gd name="connsiteX13" fmla="*/ 232200 w 238267"/>
                    <a:gd name="connsiteY13" fmla="*/ 87789 h 288290"/>
                    <a:gd name="connsiteX14" fmla="*/ 209340 w 238267"/>
                    <a:gd name="connsiteY14" fmla="*/ 55404 h 288290"/>
                    <a:gd name="connsiteX15" fmla="*/ 178860 w 238267"/>
                    <a:gd name="connsiteY15" fmla="*/ 26829 h 288290"/>
                    <a:gd name="connsiteX16" fmla="*/ 106470 w 238267"/>
                    <a:gd name="connsiteY16" fmla="*/ 159 h 2882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</a:cxnLst>
                  <a:rect l="l" t="t" r="r" b="b"/>
                  <a:pathLst>
                    <a:path w="238267" h="288290">
                      <a:moveTo>
                        <a:pt x="106470" y="159"/>
                      </a:moveTo>
                      <a:cubicBezTo>
                        <a:pt x="82340" y="2381"/>
                        <a:pt x="48368" y="28734"/>
                        <a:pt x="34080" y="40164"/>
                      </a:cubicBezTo>
                      <a:cubicBezTo>
                        <a:pt x="19792" y="51594"/>
                        <a:pt x="23920" y="61437"/>
                        <a:pt x="20745" y="68739"/>
                      </a:cubicBezTo>
                      <a:cubicBezTo>
                        <a:pt x="17570" y="76042"/>
                        <a:pt x="17887" y="73502"/>
                        <a:pt x="15030" y="83979"/>
                      </a:cubicBezTo>
                      <a:cubicBezTo>
                        <a:pt x="12172" y="94457"/>
                        <a:pt x="5822" y="115412"/>
                        <a:pt x="3600" y="131604"/>
                      </a:cubicBezTo>
                      <a:cubicBezTo>
                        <a:pt x="1378" y="147796"/>
                        <a:pt x="-2115" y="162084"/>
                        <a:pt x="1695" y="181134"/>
                      </a:cubicBezTo>
                      <a:cubicBezTo>
                        <a:pt x="5505" y="200184"/>
                        <a:pt x="15983" y="230029"/>
                        <a:pt x="26460" y="245904"/>
                      </a:cubicBezTo>
                      <a:cubicBezTo>
                        <a:pt x="36937" y="261779"/>
                        <a:pt x="52495" y="269399"/>
                        <a:pt x="64560" y="276384"/>
                      </a:cubicBezTo>
                      <a:cubicBezTo>
                        <a:pt x="76625" y="283369"/>
                        <a:pt x="86785" y="286544"/>
                        <a:pt x="98850" y="287814"/>
                      </a:cubicBezTo>
                      <a:cubicBezTo>
                        <a:pt x="110915" y="289084"/>
                        <a:pt x="123615" y="287814"/>
                        <a:pt x="136950" y="284004"/>
                      </a:cubicBezTo>
                      <a:cubicBezTo>
                        <a:pt x="150285" y="280194"/>
                        <a:pt x="164255" y="278289"/>
                        <a:pt x="178860" y="264954"/>
                      </a:cubicBezTo>
                      <a:cubicBezTo>
                        <a:pt x="193465" y="251619"/>
                        <a:pt x="214737" y="224314"/>
                        <a:pt x="224580" y="203994"/>
                      </a:cubicBezTo>
                      <a:cubicBezTo>
                        <a:pt x="234423" y="183674"/>
                        <a:pt x="236645" y="162402"/>
                        <a:pt x="237915" y="143034"/>
                      </a:cubicBezTo>
                      <a:cubicBezTo>
                        <a:pt x="239185" y="123667"/>
                        <a:pt x="236963" y="102394"/>
                        <a:pt x="232200" y="87789"/>
                      </a:cubicBezTo>
                      <a:cubicBezTo>
                        <a:pt x="227438" y="73184"/>
                        <a:pt x="218230" y="65564"/>
                        <a:pt x="209340" y="55404"/>
                      </a:cubicBezTo>
                      <a:cubicBezTo>
                        <a:pt x="200450" y="45244"/>
                        <a:pt x="189020" y="34131"/>
                        <a:pt x="178860" y="26829"/>
                      </a:cubicBezTo>
                      <a:cubicBezTo>
                        <a:pt x="168700" y="19527"/>
                        <a:pt x="130600" y="-2063"/>
                        <a:pt x="106470" y="159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6" name="任意多边形: 形状 235"/>
                <p:cNvSpPr/>
                <p:nvPr/>
              </p:nvSpPr>
              <p:spPr>
                <a:xfrm>
                  <a:off x="678931" y="2393784"/>
                  <a:ext cx="160165" cy="233197"/>
                </a:xfrm>
                <a:custGeom>
                  <a:avLst/>
                  <a:gdLst>
                    <a:gd name="connsiteX0" fmla="*/ 41161 w 160165"/>
                    <a:gd name="connsiteY0" fmla="*/ 208288 h 233197"/>
                    <a:gd name="connsiteX1" fmla="*/ 1156 w 160165"/>
                    <a:gd name="connsiteY1" fmla="*/ 118753 h 233197"/>
                    <a:gd name="connsiteX2" fmla="*/ 14491 w 160165"/>
                    <a:gd name="connsiteY2" fmla="*/ 55888 h 233197"/>
                    <a:gd name="connsiteX3" fmla="*/ 52591 w 160165"/>
                    <a:gd name="connsiteY3" fmla="*/ 17788 h 233197"/>
                    <a:gd name="connsiteX4" fmla="*/ 104026 w 160165"/>
                    <a:gd name="connsiteY4" fmla="*/ 643 h 233197"/>
                    <a:gd name="connsiteX5" fmla="*/ 142126 w 160165"/>
                    <a:gd name="connsiteY5" fmla="*/ 38743 h 233197"/>
                    <a:gd name="connsiteX6" fmla="*/ 157366 w 160165"/>
                    <a:gd name="connsiteY6" fmla="*/ 90178 h 233197"/>
                    <a:gd name="connsiteX7" fmla="*/ 157366 w 160165"/>
                    <a:gd name="connsiteY7" fmla="*/ 147328 h 233197"/>
                    <a:gd name="connsiteX8" fmla="*/ 128791 w 160165"/>
                    <a:gd name="connsiteY8" fmla="*/ 194953 h 233197"/>
                    <a:gd name="connsiteX9" fmla="*/ 107836 w 160165"/>
                    <a:gd name="connsiteY9" fmla="*/ 225433 h 233197"/>
                    <a:gd name="connsiteX10" fmla="*/ 98311 w 160165"/>
                    <a:gd name="connsiteY10" fmla="*/ 233053 h 233197"/>
                    <a:gd name="connsiteX11" fmla="*/ 41161 w 160165"/>
                    <a:gd name="connsiteY11" fmla="*/ 208288 h 23319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</a:cxnLst>
                  <a:rect l="l" t="t" r="r" b="b"/>
                  <a:pathLst>
                    <a:path w="160165" h="233197">
                      <a:moveTo>
                        <a:pt x="41161" y="208288"/>
                      </a:moveTo>
                      <a:cubicBezTo>
                        <a:pt x="24969" y="189238"/>
                        <a:pt x="5601" y="144153"/>
                        <a:pt x="1156" y="118753"/>
                      </a:cubicBezTo>
                      <a:cubicBezTo>
                        <a:pt x="-3289" y="93353"/>
                        <a:pt x="5919" y="72715"/>
                        <a:pt x="14491" y="55888"/>
                      </a:cubicBezTo>
                      <a:cubicBezTo>
                        <a:pt x="23063" y="39061"/>
                        <a:pt x="37669" y="26995"/>
                        <a:pt x="52591" y="17788"/>
                      </a:cubicBezTo>
                      <a:cubicBezTo>
                        <a:pt x="67513" y="8581"/>
                        <a:pt x="89104" y="-2850"/>
                        <a:pt x="104026" y="643"/>
                      </a:cubicBezTo>
                      <a:cubicBezTo>
                        <a:pt x="118949" y="4135"/>
                        <a:pt x="133236" y="23820"/>
                        <a:pt x="142126" y="38743"/>
                      </a:cubicBezTo>
                      <a:cubicBezTo>
                        <a:pt x="151016" y="53665"/>
                        <a:pt x="154826" y="72081"/>
                        <a:pt x="157366" y="90178"/>
                      </a:cubicBezTo>
                      <a:cubicBezTo>
                        <a:pt x="159906" y="108275"/>
                        <a:pt x="162129" y="129865"/>
                        <a:pt x="157366" y="147328"/>
                      </a:cubicBezTo>
                      <a:cubicBezTo>
                        <a:pt x="152603" y="164791"/>
                        <a:pt x="137046" y="181935"/>
                        <a:pt x="128791" y="194953"/>
                      </a:cubicBezTo>
                      <a:cubicBezTo>
                        <a:pt x="120536" y="207971"/>
                        <a:pt x="112916" y="219083"/>
                        <a:pt x="107836" y="225433"/>
                      </a:cubicBezTo>
                      <a:cubicBezTo>
                        <a:pt x="102756" y="231783"/>
                        <a:pt x="107836" y="231783"/>
                        <a:pt x="98311" y="233053"/>
                      </a:cubicBezTo>
                      <a:cubicBezTo>
                        <a:pt x="88786" y="234323"/>
                        <a:pt x="57353" y="227338"/>
                        <a:pt x="41161" y="208288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37" name="组合 236"/>
                <p:cNvGrpSpPr/>
                <p:nvPr/>
              </p:nvGrpSpPr>
              <p:grpSpPr>
                <a:xfrm>
                  <a:off x="1761253" y="2394261"/>
                  <a:ext cx="624443" cy="991878"/>
                  <a:chOff x="846569" y="2828282"/>
                  <a:chExt cx="624443" cy="991878"/>
                </a:xfrm>
              </p:grpSpPr>
              <p:sp>
                <p:nvSpPr>
                  <p:cNvPr id="253" name="任意多边形: 形状 252"/>
                  <p:cNvSpPr/>
                  <p:nvPr/>
                </p:nvSpPr>
                <p:spPr>
                  <a:xfrm>
                    <a:off x="851974" y="3624470"/>
                    <a:ext cx="225942" cy="195690"/>
                  </a:xfrm>
                  <a:custGeom>
                    <a:avLst/>
                    <a:gdLst>
                      <a:gd name="connsiteX0" fmla="*/ 85286 w 225942"/>
                      <a:gd name="connsiteY0" fmla="*/ 110 h 195690"/>
                      <a:gd name="connsiteX1" fmla="*/ 29406 w 225942"/>
                      <a:gd name="connsiteY1" fmla="*/ 10270 h 195690"/>
                      <a:gd name="connsiteX2" fmla="*/ 19246 w 225942"/>
                      <a:gd name="connsiteY2" fmla="*/ 25510 h 195690"/>
                      <a:gd name="connsiteX3" fmla="*/ 9086 w 225942"/>
                      <a:gd name="connsiteY3" fmla="*/ 40750 h 195690"/>
                      <a:gd name="connsiteX4" fmla="*/ 1466 w 225942"/>
                      <a:gd name="connsiteY4" fmla="*/ 66150 h 195690"/>
                      <a:gd name="connsiteX5" fmla="*/ 1466 w 225942"/>
                      <a:gd name="connsiteY5" fmla="*/ 89010 h 195690"/>
                      <a:gd name="connsiteX6" fmla="*/ 16706 w 225942"/>
                      <a:gd name="connsiteY6" fmla="*/ 116950 h 195690"/>
                      <a:gd name="connsiteX7" fmla="*/ 39566 w 225942"/>
                      <a:gd name="connsiteY7" fmla="*/ 149970 h 195690"/>
                      <a:gd name="connsiteX8" fmla="*/ 85286 w 225942"/>
                      <a:gd name="connsiteY8" fmla="*/ 180450 h 195690"/>
                      <a:gd name="connsiteX9" fmla="*/ 136086 w 225942"/>
                      <a:gd name="connsiteY9" fmla="*/ 195690 h 195690"/>
                      <a:gd name="connsiteX10" fmla="*/ 179266 w 225942"/>
                      <a:gd name="connsiteY10" fmla="*/ 180450 h 195690"/>
                      <a:gd name="connsiteX11" fmla="*/ 207206 w 225942"/>
                      <a:gd name="connsiteY11" fmla="*/ 147430 h 195690"/>
                      <a:gd name="connsiteX12" fmla="*/ 224986 w 225942"/>
                      <a:gd name="connsiteY12" fmla="*/ 119490 h 195690"/>
                      <a:gd name="connsiteX13" fmla="*/ 219906 w 225942"/>
                      <a:gd name="connsiteY13" fmla="*/ 73770 h 195690"/>
                      <a:gd name="connsiteX14" fmla="*/ 189426 w 225942"/>
                      <a:gd name="connsiteY14" fmla="*/ 35670 h 195690"/>
                      <a:gd name="connsiteX15" fmla="*/ 161486 w 225942"/>
                      <a:gd name="connsiteY15" fmla="*/ 12810 h 195690"/>
                      <a:gd name="connsiteX16" fmla="*/ 136086 w 225942"/>
                      <a:gd name="connsiteY16" fmla="*/ 5190 h 195690"/>
                      <a:gd name="connsiteX17" fmla="*/ 85286 w 225942"/>
                      <a:gd name="connsiteY17" fmla="*/ 110 h 19569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</a:cxnLst>
                    <a:rect l="l" t="t" r="r" b="b"/>
                    <a:pathLst>
                      <a:path w="225942" h="195690">
                        <a:moveTo>
                          <a:pt x="85286" y="110"/>
                        </a:moveTo>
                        <a:cubicBezTo>
                          <a:pt x="67506" y="957"/>
                          <a:pt x="40413" y="6037"/>
                          <a:pt x="29406" y="10270"/>
                        </a:cubicBezTo>
                        <a:cubicBezTo>
                          <a:pt x="18399" y="14503"/>
                          <a:pt x="22633" y="20430"/>
                          <a:pt x="19246" y="25510"/>
                        </a:cubicBezTo>
                        <a:cubicBezTo>
                          <a:pt x="15859" y="30590"/>
                          <a:pt x="12049" y="33977"/>
                          <a:pt x="9086" y="40750"/>
                        </a:cubicBezTo>
                        <a:cubicBezTo>
                          <a:pt x="6123" y="47523"/>
                          <a:pt x="2736" y="58107"/>
                          <a:pt x="1466" y="66150"/>
                        </a:cubicBezTo>
                        <a:cubicBezTo>
                          <a:pt x="196" y="74193"/>
                          <a:pt x="-1074" y="80543"/>
                          <a:pt x="1466" y="89010"/>
                        </a:cubicBezTo>
                        <a:cubicBezTo>
                          <a:pt x="4006" y="97477"/>
                          <a:pt x="10356" y="106790"/>
                          <a:pt x="16706" y="116950"/>
                        </a:cubicBezTo>
                        <a:cubicBezTo>
                          <a:pt x="23056" y="127110"/>
                          <a:pt x="28136" y="139387"/>
                          <a:pt x="39566" y="149970"/>
                        </a:cubicBezTo>
                        <a:cubicBezTo>
                          <a:pt x="50996" y="160553"/>
                          <a:pt x="69199" y="172830"/>
                          <a:pt x="85286" y="180450"/>
                        </a:cubicBezTo>
                        <a:cubicBezTo>
                          <a:pt x="101373" y="188070"/>
                          <a:pt x="120423" y="195690"/>
                          <a:pt x="136086" y="195690"/>
                        </a:cubicBezTo>
                        <a:cubicBezTo>
                          <a:pt x="151749" y="195690"/>
                          <a:pt x="167413" y="188493"/>
                          <a:pt x="179266" y="180450"/>
                        </a:cubicBezTo>
                        <a:cubicBezTo>
                          <a:pt x="191119" y="172407"/>
                          <a:pt x="199586" y="157590"/>
                          <a:pt x="207206" y="147430"/>
                        </a:cubicBezTo>
                        <a:cubicBezTo>
                          <a:pt x="214826" y="137270"/>
                          <a:pt x="222869" y="131767"/>
                          <a:pt x="224986" y="119490"/>
                        </a:cubicBezTo>
                        <a:cubicBezTo>
                          <a:pt x="227103" y="107213"/>
                          <a:pt x="225833" y="87740"/>
                          <a:pt x="219906" y="73770"/>
                        </a:cubicBezTo>
                        <a:cubicBezTo>
                          <a:pt x="213979" y="59800"/>
                          <a:pt x="199163" y="45830"/>
                          <a:pt x="189426" y="35670"/>
                        </a:cubicBezTo>
                        <a:cubicBezTo>
                          <a:pt x="179689" y="25510"/>
                          <a:pt x="170376" y="17890"/>
                          <a:pt x="161486" y="12810"/>
                        </a:cubicBezTo>
                        <a:cubicBezTo>
                          <a:pt x="152596" y="7730"/>
                          <a:pt x="143283" y="6883"/>
                          <a:pt x="136086" y="5190"/>
                        </a:cubicBezTo>
                        <a:cubicBezTo>
                          <a:pt x="128889" y="3497"/>
                          <a:pt x="103066" y="-737"/>
                          <a:pt x="85286" y="110"/>
                        </a:cubicBezTo>
                        <a:close/>
                      </a:path>
                    </a:pathLst>
                  </a:custGeom>
                  <a:noFill/>
                  <a:ln w="9525">
                    <a:noFill/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4" name="任意多边形: 形状 253"/>
                  <p:cNvSpPr/>
                  <p:nvPr/>
                </p:nvSpPr>
                <p:spPr>
                  <a:xfrm>
                    <a:off x="1232745" y="3144996"/>
                    <a:ext cx="238267" cy="288290"/>
                  </a:xfrm>
                  <a:custGeom>
                    <a:avLst/>
                    <a:gdLst>
                      <a:gd name="connsiteX0" fmla="*/ 106470 w 238267"/>
                      <a:gd name="connsiteY0" fmla="*/ 159 h 288290"/>
                      <a:gd name="connsiteX1" fmla="*/ 34080 w 238267"/>
                      <a:gd name="connsiteY1" fmla="*/ 40164 h 288290"/>
                      <a:gd name="connsiteX2" fmla="*/ 20745 w 238267"/>
                      <a:gd name="connsiteY2" fmla="*/ 68739 h 288290"/>
                      <a:gd name="connsiteX3" fmla="*/ 15030 w 238267"/>
                      <a:gd name="connsiteY3" fmla="*/ 83979 h 288290"/>
                      <a:gd name="connsiteX4" fmla="*/ 3600 w 238267"/>
                      <a:gd name="connsiteY4" fmla="*/ 131604 h 288290"/>
                      <a:gd name="connsiteX5" fmla="*/ 1695 w 238267"/>
                      <a:gd name="connsiteY5" fmla="*/ 181134 h 288290"/>
                      <a:gd name="connsiteX6" fmla="*/ 26460 w 238267"/>
                      <a:gd name="connsiteY6" fmla="*/ 245904 h 288290"/>
                      <a:gd name="connsiteX7" fmla="*/ 64560 w 238267"/>
                      <a:gd name="connsiteY7" fmla="*/ 276384 h 288290"/>
                      <a:gd name="connsiteX8" fmla="*/ 98850 w 238267"/>
                      <a:gd name="connsiteY8" fmla="*/ 287814 h 288290"/>
                      <a:gd name="connsiteX9" fmla="*/ 136950 w 238267"/>
                      <a:gd name="connsiteY9" fmla="*/ 284004 h 288290"/>
                      <a:gd name="connsiteX10" fmla="*/ 178860 w 238267"/>
                      <a:gd name="connsiteY10" fmla="*/ 264954 h 288290"/>
                      <a:gd name="connsiteX11" fmla="*/ 224580 w 238267"/>
                      <a:gd name="connsiteY11" fmla="*/ 203994 h 288290"/>
                      <a:gd name="connsiteX12" fmla="*/ 237915 w 238267"/>
                      <a:gd name="connsiteY12" fmla="*/ 143034 h 288290"/>
                      <a:gd name="connsiteX13" fmla="*/ 232200 w 238267"/>
                      <a:gd name="connsiteY13" fmla="*/ 87789 h 288290"/>
                      <a:gd name="connsiteX14" fmla="*/ 209340 w 238267"/>
                      <a:gd name="connsiteY14" fmla="*/ 55404 h 288290"/>
                      <a:gd name="connsiteX15" fmla="*/ 178860 w 238267"/>
                      <a:gd name="connsiteY15" fmla="*/ 26829 h 288290"/>
                      <a:gd name="connsiteX16" fmla="*/ 106470 w 238267"/>
                      <a:gd name="connsiteY16" fmla="*/ 159 h 28829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</a:cxnLst>
                    <a:rect l="l" t="t" r="r" b="b"/>
                    <a:pathLst>
                      <a:path w="238267" h="288290">
                        <a:moveTo>
                          <a:pt x="106470" y="159"/>
                        </a:moveTo>
                        <a:cubicBezTo>
                          <a:pt x="82340" y="2381"/>
                          <a:pt x="48368" y="28734"/>
                          <a:pt x="34080" y="40164"/>
                        </a:cubicBezTo>
                        <a:cubicBezTo>
                          <a:pt x="19792" y="51594"/>
                          <a:pt x="23920" y="61437"/>
                          <a:pt x="20745" y="68739"/>
                        </a:cubicBezTo>
                        <a:cubicBezTo>
                          <a:pt x="17570" y="76042"/>
                          <a:pt x="17887" y="73502"/>
                          <a:pt x="15030" y="83979"/>
                        </a:cubicBezTo>
                        <a:cubicBezTo>
                          <a:pt x="12172" y="94457"/>
                          <a:pt x="5822" y="115412"/>
                          <a:pt x="3600" y="131604"/>
                        </a:cubicBezTo>
                        <a:cubicBezTo>
                          <a:pt x="1378" y="147796"/>
                          <a:pt x="-2115" y="162084"/>
                          <a:pt x="1695" y="181134"/>
                        </a:cubicBezTo>
                        <a:cubicBezTo>
                          <a:pt x="5505" y="200184"/>
                          <a:pt x="15983" y="230029"/>
                          <a:pt x="26460" y="245904"/>
                        </a:cubicBezTo>
                        <a:cubicBezTo>
                          <a:pt x="36937" y="261779"/>
                          <a:pt x="52495" y="269399"/>
                          <a:pt x="64560" y="276384"/>
                        </a:cubicBezTo>
                        <a:cubicBezTo>
                          <a:pt x="76625" y="283369"/>
                          <a:pt x="86785" y="286544"/>
                          <a:pt x="98850" y="287814"/>
                        </a:cubicBezTo>
                        <a:cubicBezTo>
                          <a:pt x="110915" y="289084"/>
                          <a:pt x="123615" y="287814"/>
                          <a:pt x="136950" y="284004"/>
                        </a:cubicBezTo>
                        <a:cubicBezTo>
                          <a:pt x="150285" y="280194"/>
                          <a:pt x="164255" y="278289"/>
                          <a:pt x="178860" y="264954"/>
                        </a:cubicBezTo>
                        <a:cubicBezTo>
                          <a:pt x="193465" y="251619"/>
                          <a:pt x="214737" y="224314"/>
                          <a:pt x="224580" y="203994"/>
                        </a:cubicBezTo>
                        <a:cubicBezTo>
                          <a:pt x="234423" y="183674"/>
                          <a:pt x="236645" y="162402"/>
                          <a:pt x="237915" y="143034"/>
                        </a:cubicBezTo>
                        <a:cubicBezTo>
                          <a:pt x="239185" y="123667"/>
                          <a:pt x="236963" y="102394"/>
                          <a:pt x="232200" y="87789"/>
                        </a:cubicBezTo>
                        <a:cubicBezTo>
                          <a:pt x="227438" y="73184"/>
                          <a:pt x="218230" y="65564"/>
                          <a:pt x="209340" y="55404"/>
                        </a:cubicBezTo>
                        <a:cubicBezTo>
                          <a:pt x="200450" y="45244"/>
                          <a:pt x="189020" y="34131"/>
                          <a:pt x="178860" y="26829"/>
                        </a:cubicBezTo>
                        <a:cubicBezTo>
                          <a:pt x="168700" y="19527"/>
                          <a:pt x="130600" y="-2063"/>
                          <a:pt x="106470" y="159"/>
                        </a:cubicBezTo>
                        <a:close/>
                      </a:path>
                    </a:pathLst>
                  </a:custGeom>
                  <a:noFill/>
                  <a:ln w="9525">
                    <a:noFill/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5" name="任意多边形: 形状 254"/>
                  <p:cNvSpPr/>
                  <p:nvPr/>
                </p:nvSpPr>
                <p:spPr>
                  <a:xfrm>
                    <a:off x="846569" y="2828282"/>
                    <a:ext cx="160165" cy="233197"/>
                  </a:xfrm>
                  <a:custGeom>
                    <a:avLst/>
                    <a:gdLst>
                      <a:gd name="connsiteX0" fmla="*/ 41161 w 160165"/>
                      <a:gd name="connsiteY0" fmla="*/ 208288 h 233197"/>
                      <a:gd name="connsiteX1" fmla="*/ 1156 w 160165"/>
                      <a:gd name="connsiteY1" fmla="*/ 118753 h 233197"/>
                      <a:gd name="connsiteX2" fmla="*/ 14491 w 160165"/>
                      <a:gd name="connsiteY2" fmla="*/ 55888 h 233197"/>
                      <a:gd name="connsiteX3" fmla="*/ 52591 w 160165"/>
                      <a:gd name="connsiteY3" fmla="*/ 17788 h 233197"/>
                      <a:gd name="connsiteX4" fmla="*/ 104026 w 160165"/>
                      <a:gd name="connsiteY4" fmla="*/ 643 h 233197"/>
                      <a:gd name="connsiteX5" fmla="*/ 142126 w 160165"/>
                      <a:gd name="connsiteY5" fmla="*/ 38743 h 233197"/>
                      <a:gd name="connsiteX6" fmla="*/ 157366 w 160165"/>
                      <a:gd name="connsiteY6" fmla="*/ 90178 h 233197"/>
                      <a:gd name="connsiteX7" fmla="*/ 157366 w 160165"/>
                      <a:gd name="connsiteY7" fmla="*/ 147328 h 233197"/>
                      <a:gd name="connsiteX8" fmla="*/ 128791 w 160165"/>
                      <a:gd name="connsiteY8" fmla="*/ 194953 h 233197"/>
                      <a:gd name="connsiteX9" fmla="*/ 107836 w 160165"/>
                      <a:gd name="connsiteY9" fmla="*/ 225433 h 233197"/>
                      <a:gd name="connsiteX10" fmla="*/ 98311 w 160165"/>
                      <a:gd name="connsiteY10" fmla="*/ 233053 h 233197"/>
                      <a:gd name="connsiteX11" fmla="*/ 41161 w 160165"/>
                      <a:gd name="connsiteY11" fmla="*/ 208288 h 23319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</a:cxnLst>
                    <a:rect l="l" t="t" r="r" b="b"/>
                    <a:pathLst>
                      <a:path w="160165" h="233197">
                        <a:moveTo>
                          <a:pt x="41161" y="208288"/>
                        </a:moveTo>
                        <a:cubicBezTo>
                          <a:pt x="24969" y="189238"/>
                          <a:pt x="5601" y="144153"/>
                          <a:pt x="1156" y="118753"/>
                        </a:cubicBezTo>
                        <a:cubicBezTo>
                          <a:pt x="-3289" y="93353"/>
                          <a:pt x="5919" y="72715"/>
                          <a:pt x="14491" y="55888"/>
                        </a:cubicBezTo>
                        <a:cubicBezTo>
                          <a:pt x="23063" y="39061"/>
                          <a:pt x="37669" y="26995"/>
                          <a:pt x="52591" y="17788"/>
                        </a:cubicBezTo>
                        <a:cubicBezTo>
                          <a:pt x="67513" y="8581"/>
                          <a:pt x="89104" y="-2850"/>
                          <a:pt x="104026" y="643"/>
                        </a:cubicBezTo>
                        <a:cubicBezTo>
                          <a:pt x="118949" y="4135"/>
                          <a:pt x="133236" y="23820"/>
                          <a:pt x="142126" y="38743"/>
                        </a:cubicBezTo>
                        <a:cubicBezTo>
                          <a:pt x="151016" y="53665"/>
                          <a:pt x="154826" y="72081"/>
                          <a:pt x="157366" y="90178"/>
                        </a:cubicBezTo>
                        <a:cubicBezTo>
                          <a:pt x="159906" y="108275"/>
                          <a:pt x="162129" y="129865"/>
                          <a:pt x="157366" y="147328"/>
                        </a:cubicBezTo>
                        <a:cubicBezTo>
                          <a:pt x="152603" y="164791"/>
                          <a:pt x="137046" y="181935"/>
                          <a:pt x="128791" y="194953"/>
                        </a:cubicBezTo>
                        <a:cubicBezTo>
                          <a:pt x="120536" y="207971"/>
                          <a:pt x="112916" y="219083"/>
                          <a:pt x="107836" y="225433"/>
                        </a:cubicBezTo>
                        <a:cubicBezTo>
                          <a:pt x="102756" y="231783"/>
                          <a:pt x="107836" y="231783"/>
                          <a:pt x="98311" y="233053"/>
                        </a:cubicBezTo>
                        <a:cubicBezTo>
                          <a:pt x="88786" y="234323"/>
                          <a:pt x="57353" y="227338"/>
                          <a:pt x="41161" y="208288"/>
                        </a:cubicBezTo>
                        <a:close/>
                      </a:path>
                    </a:pathLst>
                  </a:custGeom>
                  <a:noFill/>
                  <a:ln w="9525">
                    <a:noFill/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38" name="组合 237"/>
                <p:cNvGrpSpPr/>
                <p:nvPr/>
              </p:nvGrpSpPr>
              <p:grpSpPr>
                <a:xfrm>
                  <a:off x="2843937" y="2394497"/>
                  <a:ext cx="624443" cy="991878"/>
                  <a:chOff x="846569" y="2828282"/>
                  <a:chExt cx="624443" cy="991878"/>
                </a:xfrm>
              </p:grpSpPr>
              <p:sp>
                <p:nvSpPr>
                  <p:cNvPr id="250" name="任意多边形: 形状 249"/>
                  <p:cNvSpPr/>
                  <p:nvPr/>
                </p:nvSpPr>
                <p:spPr>
                  <a:xfrm>
                    <a:off x="851974" y="3624470"/>
                    <a:ext cx="225942" cy="195690"/>
                  </a:xfrm>
                  <a:custGeom>
                    <a:avLst/>
                    <a:gdLst>
                      <a:gd name="connsiteX0" fmla="*/ 85286 w 225942"/>
                      <a:gd name="connsiteY0" fmla="*/ 110 h 195690"/>
                      <a:gd name="connsiteX1" fmla="*/ 29406 w 225942"/>
                      <a:gd name="connsiteY1" fmla="*/ 10270 h 195690"/>
                      <a:gd name="connsiteX2" fmla="*/ 19246 w 225942"/>
                      <a:gd name="connsiteY2" fmla="*/ 25510 h 195690"/>
                      <a:gd name="connsiteX3" fmla="*/ 9086 w 225942"/>
                      <a:gd name="connsiteY3" fmla="*/ 40750 h 195690"/>
                      <a:gd name="connsiteX4" fmla="*/ 1466 w 225942"/>
                      <a:gd name="connsiteY4" fmla="*/ 66150 h 195690"/>
                      <a:gd name="connsiteX5" fmla="*/ 1466 w 225942"/>
                      <a:gd name="connsiteY5" fmla="*/ 89010 h 195690"/>
                      <a:gd name="connsiteX6" fmla="*/ 16706 w 225942"/>
                      <a:gd name="connsiteY6" fmla="*/ 116950 h 195690"/>
                      <a:gd name="connsiteX7" fmla="*/ 39566 w 225942"/>
                      <a:gd name="connsiteY7" fmla="*/ 149970 h 195690"/>
                      <a:gd name="connsiteX8" fmla="*/ 85286 w 225942"/>
                      <a:gd name="connsiteY8" fmla="*/ 180450 h 195690"/>
                      <a:gd name="connsiteX9" fmla="*/ 136086 w 225942"/>
                      <a:gd name="connsiteY9" fmla="*/ 195690 h 195690"/>
                      <a:gd name="connsiteX10" fmla="*/ 179266 w 225942"/>
                      <a:gd name="connsiteY10" fmla="*/ 180450 h 195690"/>
                      <a:gd name="connsiteX11" fmla="*/ 207206 w 225942"/>
                      <a:gd name="connsiteY11" fmla="*/ 147430 h 195690"/>
                      <a:gd name="connsiteX12" fmla="*/ 224986 w 225942"/>
                      <a:gd name="connsiteY12" fmla="*/ 119490 h 195690"/>
                      <a:gd name="connsiteX13" fmla="*/ 219906 w 225942"/>
                      <a:gd name="connsiteY13" fmla="*/ 73770 h 195690"/>
                      <a:gd name="connsiteX14" fmla="*/ 189426 w 225942"/>
                      <a:gd name="connsiteY14" fmla="*/ 35670 h 195690"/>
                      <a:gd name="connsiteX15" fmla="*/ 161486 w 225942"/>
                      <a:gd name="connsiteY15" fmla="*/ 12810 h 195690"/>
                      <a:gd name="connsiteX16" fmla="*/ 136086 w 225942"/>
                      <a:gd name="connsiteY16" fmla="*/ 5190 h 195690"/>
                      <a:gd name="connsiteX17" fmla="*/ 85286 w 225942"/>
                      <a:gd name="connsiteY17" fmla="*/ 110 h 19569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</a:cxnLst>
                    <a:rect l="l" t="t" r="r" b="b"/>
                    <a:pathLst>
                      <a:path w="225942" h="195690">
                        <a:moveTo>
                          <a:pt x="85286" y="110"/>
                        </a:moveTo>
                        <a:cubicBezTo>
                          <a:pt x="67506" y="957"/>
                          <a:pt x="40413" y="6037"/>
                          <a:pt x="29406" y="10270"/>
                        </a:cubicBezTo>
                        <a:cubicBezTo>
                          <a:pt x="18399" y="14503"/>
                          <a:pt x="22633" y="20430"/>
                          <a:pt x="19246" y="25510"/>
                        </a:cubicBezTo>
                        <a:cubicBezTo>
                          <a:pt x="15859" y="30590"/>
                          <a:pt x="12049" y="33977"/>
                          <a:pt x="9086" y="40750"/>
                        </a:cubicBezTo>
                        <a:cubicBezTo>
                          <a:pt x="6123" y="47523"/>
                          <a:pt x="2736" y="58107"/>
                          <a:pt x="1466" y="66150"/>
                        </a:cubicBezTo>
                        <a:cubicBezTo>
                          <a:pt x="196" y="74193"/>
                          <a:pt x="-1074" y="80543"/>
                          <a:pt x="1466" y="89010"/>
                        </a:cubicBezTo>
                        <a:cubicBezTo>
                          <a:pt x="4006" y="97477"/>
                          <a:pt x="10356" y="106790"/>
                          <a:pt x="16706" y="116950"/>
                        </a:cubicBezTo>
                        <a:cubicBezTo>
                          <a:pt x="23056" y="127110"/>
                          <a:pt x="28136" y="139387"/>
                          <a:pt x="39566" y="149970"/>
                        </a:cubicBezTo>
                        <a:cubicBezTo>
                          <a:pt x="50996" y="160553"/>
                          <a:pt x="69199" y="172830"/>
                          <a:pt x="85286" y="180450"/>
                        </a:cubicBezTo>
                        <a:cubicBezTo>
                          <a:pt x="101373" y="188070"/>
                          <a:pt x="120423" y="195690"/>
                          <a:pt x="136086" y="195690"/>
                        </a:cubicBezTo>
                        <a:cubicBezTo>
                          <a:pt x="151749" y="195690"/>
                          <a:pt x="167413" y="188493"/>
                          <a:pt x="179266" y="180450"/>
                        </a:cubicBezTo>
                        <a:cubicBezTo>
                          <a:pt x="191119" y="172407"/>
                          <a:pt x="199586" y="157590"/>
                          <a:pt x="207206" y="147430"/>
                        </a:cubicBezTo>
                        <a:cubicBezTo>
                          <a:pt x="214826" y="137270"/>
                          <a:pt x="222869" y="131767"/>
                          <a:pt x="224986" y="119490"/>
                        </a:cubicBezTo>
                        <a:cubicBezTo>
                          <a:pt x="227103" y="107213"/>
                          <a:pt x="225833" y="87740"/>
                          <a:pt x="219906" y="73770"/>
                        </a:cubicBezTo>
                        <a:cubicBezTo>
                          <a:pt x="213979" y="59800"/>
                          <a:pt x="199163" y="45830"/>
                          <a:pt x="189426" y="35670"/>
                        </a:cubicBezTo>
                        <a:cubicBezTo>
                          <a:pt x="179689" y="25510"/>
                          <a:pt x="170376" y="17890"/>
                          <a:pt x="161486" y="12810"/>
                        </a:cubicBezTo>
                        <a:cubicBezTo>
                          <a:pt x="152596" y="7730"/>
                          <a:pt x="143283" y="6883"/>
                          <a:pt x="136086" y="5190"/>
                        </a:cubicBezTo>
                        <a:cubicBezTo>
                          <a:pt x="128889" y="3497"/>
                          <a:pt x="103066" y="-737"/>
                          <a:pt x="85286" y="110"/>
                        </a:cubicBezTo>
                        <a:close/>
                      </a:path>
                    </a:pathLst>
                  </a:custGeom>
                  <a:noFill/>
                  <a:ln w="9525">
                    <a:noFill/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1" name="任意多边形: 形状 250"/>
                  <p:cNvSpPr/>
                  <p:nvPr/>
                </p:nvSpPr>
                <p:spPr>
                  <a:xfrm>
                    <a:off x="1232745" y="3144996"/>
                    <a:ext cx="238267" cy="288290"/>
                  </a:xfrm>
                  <a:custGeom>
                    <a:avLst/>
                    <a:gdLst>
                      <a:gd name="connsiteX0" fmla="*/ 106470 w 238267"/>
                      <a:gd name="connsiteY0" fmla="*/ 159 h 288290"/>
                      <a:gd name="connsiteX1" fmla="*/ 34080 w 238267"/>
                      <a:gd name="connsiteY1" fmla="*/ 40164 h 288290"/>
                      <a:gd name="connsiteX2" fmla="*/ 20745 w 238267"/>
                      <a:gd name="connsiteY2" fmla="*/ 68739 h 288290"/>
                      <a:gd name="connsiteX3" fmla="*/ 15030 w 238267"/>
                      <a:gd name="connsiteY3" fmla="*/ 83979 h 288290"/>
                      <a:gd name="connsiteX4" fmla="*/ 3600 w 238267"/>
                      <a:gd name="connsiteY4" fmla="*/ 131604 h 288290"/>
                      <a:gd name="connsiteX5" fmla="*/ 1695 w 238267"/>
                      <a:gd name="connsiteY5" fmla="*/ 181134 h 288290"/>
                      <a:gd name="connsiteX6" fmla="*/ 26460 w 238267"/>
                      <a:gd name="connsiteY6" fmla="*/ 245904 h 288290"/>
                      <a:gd name="connsiteX7" fmla="*/ 64560 w 238267"/>
                      <a:gd name="connsiteY7" fmla="*/ 276384 h 288290"/>
                      <a:gd name="connsiteX8" fmla="*/ 98850 w 238267"/>
                      <a:gd name="connsiteY8" fmla="*/ 287814 h 288290"/>
                      <a:gd name="connsiteX9" fmla="*/ 136950 w 238267"/>
                      <a:gd name="connsiteY9" fmla="*/ 284004 h 288290"/>
                      <a:gd name="connsiteX10" fmla="*/ 178860 w 238267"/>
                      <a:gd name="connsiteY10" fmla="*/ 264954 h 288290"/>
                      <a:gd name="connsiteX11" fmla="*/ 224580 w 238267"/>
                      <a:gd name="connsiteY11" fmla="*/ 203994 h 288290"/>
                      <a:gd name="connsiteX12" fmla="*/ 237915 w 238267"/>
                      <a:gd name="connsiteY12" fmla="*/ 143034 h 288290"/>
                      <a:gd name="connsiteX13" fmla="*/ 232200 w 238267"/>
                      <a:gd name="connsiteY13" fmla="*/ 87789 h 288290"/>
                      <a:gd name="connsiteX14" fmla="*/ 209340 w 238267"/>
                      <a:gd name="connsiteY14" fmla="*/ 55404 h 288290"/>
                      <a:gd name="connsiteX15" fmla="*/ 178860 w 238267"/>
                      <a:gd name="connsiteY15" fmla="*/ 26829 h 288290"/>
                      <a:gd name="connsiteX16" fmla="*/ 106470 w 238267"/>
                      <a:gd name="connsiteY16" fmla="*/ 159 h 28829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</a:cxnLst>
                    <a:rect l="l" t="t" r="r" b="b"/>
                    <a:pathLst>
                      <a:path w="238267" h="288290">
                        <a:moveTo>
                          <a:pt x="106470" y="159"/>
                        </a:moveTo>
                        <a:cubicBezTo>
                          <a:pt x="82340" y="2381"/>
                          <a:pt x="48368" y="28734"/>
                          <a:pt x="34080" y="40164"/>
                        </a:cubicBezTo>
                        <a:cubicBezTo>
                          <a:pt x="19792" y="51594"/>
                          <a:pt x="23920" y="61437"/>
                          <a:pt x="20745" y="68739"/>
                        </a:cubicBezTo>
                        <a:cubicBezTo>
                          <a:pt x="17570" y="76042"/>
                          <a:pt x="17887" y="73502"/>
                          <a:pt x="15030" y="83979"/>
                        </a:cubicBezTo>
                        <a:cubicBezTo>
                          <a:pt x="12172" y="94457"/>
                          <a:pt x="5822" y="115412"/>
                          <a:pt x="3600" y="131604"/>
                        </a:cubicBezTo>
                        <a:cubicBezTo>
                          <a:pt x="1378" y="147796"/>
                          <a:pt x="-2115" y="162084"/>
                          <a:pt x="1695" y="181134"/>
                        </a:cubicBezTo>
                        <a:cubicBezTo>
                          <a:pt x="5505" y="200184"/>
                          <a:pt x="15983" y="230029"/>
                          <a:pt x="26460" y="245904"/>
                        </a:cubicBezTo>
                        <a:cubicBezTo>
                          <a:pt x="36937" y="261779"/>
                          <a:pt x="52495" y="269399"/>
                          <a:pt x="64560" y="276384"/>
                        </a:cubicBezTo>
                        <a:cubicBezTo>
                          <a:pt x="76625" y="283369"/>
                          <a:pt x="86785" y="286544"/>
                          <a:pt x="98850" y="287814"/>
                        </a:cubicBezTo>
                        <a:cubicBezTo>
                          <a:pt x="110915" y="289084"/>
                          <a:pt x="123615" y="287814"/>
                          <a:pt x="136950" y="284004"/>
                        </a:cubicBezTo>
                        <a:cubicBezTo>
                          <a:pt x="150285" y="280194"/>
                          <a:pt x="164255" y="278289"/>
                          <a:pt x="178860" y="264954"/>
                        </a:cubicBezTo>
                        <a:cubicBezTo>
                          <a:pt x="193465" y="251619"/>
                          <a:pt x="214737" y="224314"/>
                          <a:pt x="224580" y="203994"/>
                        </a:cubicBezTo>
                        <a:cubicBezTo>
                          <a:pt x="234423" y="183674"/>
                          <a:pt x="236645" y="162402"/>
                          <a:pt x="237915" y="143034"/>
                        </a:cubicBezTo>
                        <a:cubicBezTo>
                          <a:pt x="239185" y="123667"/>
                          <a:pt x="236963" y="102394"/>
                          <a:pt x="232200" y="87789"/>
                        </a:cubicBezTo>
                        <a:cubicBezTo>
                          <a:pt x="227438" y="73184"/>
                          <a:pt x="218230" y="65564"/>
                          <a:pt x="209340" y="55404"/>
                        </a:cubicBezTo>
                        <a:cubicBezTo>
                          <a:pt x="200450" y="45244"/>
                          <a:pt x="189020" y="34131"/>
                          <a:pt x="178860" y="26829"/>
                        </a:cubicBezTo>
                        <a:cubicBezTo>
                          <a:pt x="168700" y="19527"/>
                          <a:pt x="130600" y="-2063"/>
                          <a:pt x="106470" y="159"/>
                        </a:cubicBezTo>
                        <a:close/>
                      </a:path>
                    </a:pathLst>
                  </a:custGeom>
                  <a:noFill/>
                  <a:ln w="9525">
                    <a:noFill/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2" name="任意多边形: 形状 251"/>
                  <p:cNvSpPr/>
                  <p:nvPr/>
                </p:nvSpPr>
                <p:spPr>
                  <a:xfrm>
                    <a:off x="846569" y="2828282"/>
                    <a:ext cx="160165" cy="233197"/>
                  </a:xfrm>
                  <a:custGeom>
                    <a:avLst/>
                    <a:gdLst>
                      <a:gd name="connsiteX0" fmla="*/ 41161 w 160165"/>
                      <a:gd name="connsiteY0" fmla="*/ 208288 h 233197"/>
                      <a:gd name="connsiteX1" fmla="*/ 1156 w 160165"/>
                      <a:gd name="connsiteY1" fmla="*/ 118753 h 233197"/>
                      <a:gd name="connsiteX2" fmla="*/ 14491 w 160165"/>
                      <a:gd name="connsiteY2" fmla="*/ 55888 h 233197"/>
                      <a:gd name="connsiteX3" fmla="*/ 52591 w 160165"/>
                      <a:gd name="connsiteY3" fmla="*/ 17788 h 233197"/>
                      <a:gd name="connsiteX4" fmla="*/ 104026 w 160165"/>
                      <a:gd name="connsiteY4" fmla="*/ 643 h 233197"/>
                      <a:gd name="connsiteX5" fmla="*/ 142126 w 160165"/>
                      <a:gd name="connsiteY5" fmla="*/ 38743 h 233197"/>
                      <a:gd name="connsiteX6" fmla="*/ 157366 w 160165"/>
                      <a:gd name="connsiteY6" fmla="*/ 90178 h 233197"/>
                      <a:gd name="connsiteX7" fmla="*/ 157366 w 160165"/>
                      <a:gd name="connsiteY7" fmla="*/ 147328 h 233197"/>
                      <a:gd name="connsiteX8" fmla="*/ 128791 w 160165"/>
                      <a:gd name="connsiteY8" fmla="*/ 194953 h 233197"/>
                      <a:gd name="connsiteX9" fmla="*/ 107836 w 160165"/>
                      <a:gd name="connsiteY9" fmla="*/ 225433 h 233197"/>
                      <a:gd name="connsiteX10" fmla="*/ 98311 w 160165"/>
                      <a:gd name="connsiteY10" fmla="*/ 233053 h 233197"/>
                      <a:gd name="connsiteX11" fmla="*/ 41161 w 160165"/>
                      <a:gd name="connsiteY11" fmla="*/ 208288 h 23319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</a:cxnLst>
                    <a:rect l="l" t="t" r="r" b="b"/>
                    <a:pathLst>
                      <a:path w="160165" h="233197">
                        <a:moveTo>
                          <a:pt x="41161" y="208288"/>
                        </a:moveTo>
                        <a:cubicBezTo>
                          <a:pt x="24969" y="189238"/>
                          <a:pt x="5601" y="144153"/>
                          <a:pt x="1156" y="118753"/>
                        </a:cubicBezTo>
                        <a:cubicBezTo>
                          <a:pt x="-3289" y="93353"/>
                          <a:pt x="5919" y="72715"/>
                          <a:pt x="14491" y="55888"/>
                        </a:cubicBezTo>
                        <a:cubicBezTo>
                          <a:pt x="23063" y="39061"/>
                          <a:pt x="37669" y="26995"/>
                          <a:pt x="52591" y="17788"/>
                        </a:cubicBezTo>
                        <a:cubicBezTo>
                          <a:pt x="67513" y="8581"/>
                          <a:pt x="89104" y="-2850"/>
                          <a:pt x="104026" y="643"/>
                        </a:cubicBezTo>
                        <a:cubicBezTo>
                          <a:pt x="118949" y="4135"/>
                          <a:pt x="133236" y="23820"/>
                          <a:pt x="142126" y="38743"/>
                        </a:cubicBezTo>
                        <a:cubicBezTo>
                          <a:pt x="151016" y="53665"/>
                          <a:pt x="154826" y="72081"/>
                          <a:pt x="157366" y="90178"/>
                        </a:cubicBezTo>
                        <a:cubicBezTo>
                          <a:pt x="159906" y="108275"/>
                          <a:pt x="162129" y="129865"/>
                          <a:pt x="157366" y="147328"/>
                        </a:cubicBezTo>
                        <a:cubicBezTo>
                          <a:pt x="152603" y="164791"/>
                          <a:pt x="137046" y="181935"/>
                          <a:pt x="128791" y="194953"/>
                        </a:cubicBezTo>
                        <a:cubicBezTo>
                          <a:pt x="120536" y="207971"/>
                          <a:pt x="112916" y="219083"/>
                          <a:pt x="107836" y="225433"/>
                        </a:cubicBezTo>
                        <a:cubicBezTo>
                          <a:pt x="102756" y="231783"/>
                          <a:pt x="107836" y="231783"/>
                          <a:pt x="98311" y="233053"/>
                        </a:cubicBezTo>
                        <a:cubicBezTo>
                          <a:pt x="88786" y="234323"/>
                          <a:pt x="57353" y="227338"/>
                          <a:pt x="41161" y="208288"/>
                        </a:cubicBezTo>
                        <a:close/>
                      </a:path>
                    </a:pathLst>
                  </a:custGeom>
                  <a:noFill/>
                  <a:ln w="9525">
                    <a:noFill/>
                    <a:prstDash val="sysDot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39" name="任意多边形: 形状 238"/>
                <p:cNvSpPr/>
                <p:nvPr/>
              </p:nvSpPr>
              <p:spPr>
                <a:xfrm>
                  <a:off x="1711264" y="4001200"/>
                  <a:ext cx="212568" cy="247643"/>
                </a:xfrm>
                <a:custGeom>
                  <a:avLst/>
                  <a:gdLst>
                    <a:gd name="connsiteX0" fmla="*/ 46282 w 212568"/>
                    <a:gd name="connsiteY0" fmla="*/ 212555 h 247643"/>
                    <a:gd name="connsiteX1" fmla="*/ 13897 w 212568"/>
                    <a:gd name="connsiteY1" fmla="*/ 164930 h 247643"/>
                    <a:gd name="connsiteX2" fmla="*/ 562 w 212568"/>
                    <a:gd name="connsiteY2" fmla="*/ 96350 h 247643"/>
                    <a:gd name="connsiteX3" fmla="*/ 31042 w 212568"/>
                    <a:gd name="connsiteY3" fmla="*/ 31580 h 247643"/>
                    <a:gd name="connsiteX4" fmla="*/ 76762 w 212568"/>
                    <a:gd name="connsiteY4" fmla="*/ 3005 h 247643"/>
                    <a:gd name="connsiteX5" fmla="*/ 122482 w 212568"/>
                    <a:gd name="connsiteY5" fmla="*/ 3005 h 247643"/>
                    <a:gd name="connsiteX6" fmla="*/ 160582 w 212568"/>
                    <a:gd name="connsiteY6" fmla="*/ 22055 h 247643"/>
                    <a:gd name="connsiteX7" fmla="*/ 204397 w 212568"/>
                    <a:gd name="connsiteY7" fmla="*/ 81110 h 247643"/>
                    <a:gd name="connsiteX8" fmla="*/ 212017 w 212568"/>
                    <a:gd name="connsiteY8" fmla="*/ 134450 h 247643"/>
                    <a:gd name="connsiteX9" fmla="*/ 196777 w 212568"/>
                    <a:gd name="connsiteY9" fmla="*/ 199220 h 247643"/>
                    <a:gd name="connsiteX10" fmla="*/ 124387 w 212568"/>
                    <a:gd name="connsiteY10" fmla="*/ 246845 h 247643"/>
                    <a:gd name="connsiteX11" fmla="*/ 46282 w 212568"/>
                    <a:gd name="connsiteY11" fmla="*/ 212555 h 24764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</a:cxnLst>
                  <a:rect l="l" t="t" r="r" b="b"/>
                  <a:pathLst>
                    <a:path w="212568" h="247643">
                      <a:moveTo>
                        <a:pt x="46282" y="212555"/>
                      </a:moveTo>
                      <a:cubicBezTo>
                        <a:pt x="27867" y="198903"/>
                        <a:pt x="21517" y="184297"/>
                        <a:pt x="13897" y="164930"/>
                      </a:cubicBezTo>
                      <a:cubicBezTo>
                        <a:pt x="6277" y="145562"/>
                        <a:pt x="-2295" y="118575"/>
                        <a:pt x="562" y="96350"/>
                      </a:cubicBezTo>
                      <a:cubicBezTo>
                        <a:pt x="3419" y="74125"/>
                        <a:pt x="18342" y="47137"/>
                        <a:pt x="31042" y="31580"/>
                      </a:cubicBezTo>
                      <a:cubicBezTo>
                        <a:pt x="43742" y="16023"/>
                        <a:pt x="61522" y="7767"/>
                        <a:pt x="76762" y="3005"/>
                      </a:cubicBezTo>
                      <a:cubicBezTo>
                        <a:pt x="92002" y="-1757"/>
                        <a:pt x="108512" y="-170"/>
                        <a:pt x="122482" y="3005"/>
                      </a:cubicBezTo>
                      <a:cubicBezTo>
                        <a:pt x="136452" y="6180"/>
                        <a:pt x="146930" y="9038"/>
                        <a:pt x="160582" y="22055"/>
                      </a:cubicBezTo>
                      <a:cubicBezTo>
                        <a:pt x="174234" y="35072"/>
                        <a:pt x="195825" y="62378"/>
                        <a:pt x="204397" y="81110"/>
                      </a:cubicBezTo>
                      <a:cubicBezTo>
                        <a:pt x="212969" y="99842"/>
                        <a:pt x="213287" y="114765"/>
                        <a:pt x="212017" y="134450"/>
                      </a:cubicBezTo>
                      <a:cubicBezTo>
                        <a:pt x="210747" y="154135"/>
                        <a:pt x="211382" y="180488"/>
                        <a:pt x="196777" y="199220"/>
                      </a:cubicBezTo>
                      <a:cubicBezTo>
                        <a:pt x="182172" y="217952"/>
                        <a:pt x="145342" y="241130"/>
                        <a:pt x="124387" y="246845"/>
                      </a:cubicBezTo>
                      <a:cubicBezTo>
                        <a:pt x="103432" y="252560"/>
                        <a:pt x="64697" y="226207"/>
                        <a:pt x="46282" y="212555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0" name="任意多边形: 形状 239"/>
                <p:cNvSpPr/>
                <p:nvPr/>
              </p:nvSpPr>
              <p:spPr>
                <a:xfrm>
                  <a:off x="2349345" y="3589298"/>
                  <a:ext cx="235015" cy="240258"/>
                </a:xfrm>
                <a:custGeom>
                  <a:avLst/>
                  <a:gdLst>
                    <a:gd name="connsiteX0" fmla="*/ 41409 w 223120"/>
                    <a:gd name="connsiteY0" fmla="*/ 209872 h 249456"/>
                    <a:gd name="connsiteX1" fmla="*/ 3309 w 223120"/>
                    <a:gd name="connsiteY1" fmla="*/ 152722 h 249456"/>
                    <a:gd name="connsiteX2" fmla="*/ 5214 w 223120"/>
                    <a:gd name="connsiteY2" fmla="*/ 91762 h 249456"/>
                    <a:gd name="connsiteX3" fmla="*/ 31884 w 223120"/>
                    <a:gd name="connsiteY3" fmla="*/ 40327 h 249456"/>
                    <a:gd name="connsiteX4" fmla="*/ 102369 w 223120"/>
                    <a:gd name="connsiteY4" fmla="*/ 322 h 249456"/>
                    <a:gd name="connsiteX5" fmla="*/ 167139 w 223120"/>
                    <a:gd name="connsiteY5" fmla="*/ 23182 h 249456"/>
                    <a:gd name="connsiteX6" fmla="*/ 212859 w 223120"/>
                    <a:gd name="connsiteY6" fmla="*/ 53662 h 249456"/>
                    <a:gd name="connsiteX7" fmla="*/ 212859 w 223120"/>
                    <a:gd name="connsiteY7" fmla="*/ 65092 h 249456"/>
                    <a:gd name="connsiteX8" fmla="*/ 220479 w 223120"/>
                    <a:gd name="connsiteY8" fmla="*/ 236542 h 249456"/>
                    <a:gd name="connsiteX9" fmla="*/ 161424 w 223120"/>
                    <a:gd name="connsiteY9" fmla="*/ 236542 h 249456"/>
                    <a:gd name="connsiteX10" fmla="*/ 108084 w 223120"/>
                    <a:gd name="connsiteY10" fmla="*/ 230827 h 249456"/>
                    <a:gd name="connsiteX11" fmla="*/ 41409 w 223120"/>
                    <a:gd name="connsiteY11" fmla="*/ 209872 h 249456"/>
                    <a:gd name="connsiteX0-1" fmla="*/ 41409 w 234109"/>
                    <a:gd name="connsiteY0-2" fmla="*/ 209872 h 249456"/>
                    <a:gd name="connsiteX1-3" fmla="*/ 3309 w 234109"/>
                    <a:gd name="connsiteY1-4" fmla="*/ 152722 h 249456"/>
                    <a:gd name="connsiteX2-5" fmla="*/ 5214 w 234109"/>
                    <a:gd name="connsiteY2-6" fmla="*/ 91762 h 249456"/>
                    <a:gd name="connsiteX3-7" fmla="*/ 31884 w 234109"/>
                    <a:gd name="connsiteY3-8" fmla="*/ 40327 h 249456"/>
                    <a:gd name="connsiteX4-9" fmla="*/ 102369 w 234109"/>
                    <a:gd name="connsiteY4-10" fmla="*/ 322 h 249456"/>
                    <a:gd name="connsiteX5-11" fmla="*/ 167139 w 234109"/>
                    <a:gd name="connsiteY5-12" fmla="*/ 23182 h 249456"/>
                    <a:gd name="connsiteX6-13" fmla="*/ 212859 w 234109"/>
                    <a:gd name="connsiteY6-14" fmla="*/ 53662 h 249456"/>
                    <a:gd name="connsiteX7-15" fmla="*/ 233814 w 234109"/>
                    <a:gd name="connsiteY7-16" fmla="*/ 65092 h 249456"/>
                    <a:gd name="connsiteX8-17" fmla="*/ 220479 w 234109"/>
                    <a:gd name="connsiteY8-18" fmla="*/ 236542 h 249456"/>
                    <a:gd name="connsiteX9-19" fmla="*/ 161424 w 234109"/>
                    <a:gd name="connsiteY9-20" fmla="*/ 236542 h 249456"/>
                    <a:gd name="connsiteX10-21" fmla="*/ 108084 w 234109"/>
                    <a:gd name="connsiteY10-22" fmla="*/ 230827 h 249456"/>
                    <a:gd name="connsiteX11-23" fmla="*/ 41409 w 234109"/>
                    <a:gd name="connsiteY11-24" fmla="*/ 209872 h 249456"/>
                    <a:gd name="connsiteX0-25" fmla="*/ 41409 w 234015"/>
                    <a:gd name="connsiteY0-26" fmla="*/ 209872 h 249456"/>
                    <a:gd name="connsiteX1-27" fmla="*/ 3309 w 234015"/>
                    <a:gd name="connsiteY1-28" fmla="*/ 152722 h 249456"/>
                    <a:gd name="connsiteX2-29" fmla="*/ 5214 w 234015"/>
                    <a:gd name="connsiteY2-30" fmla="*/ 91762 h 249456"/>
                    <a:gd name="connsiteX3-31" fmla="*/ 31884 w 234015"/>
                    <a:gd name="connsiteY3-32" fmla="*/ 40327 h 249456"/>
                    <a:gd name="connsiteX4-33" fmla="*/ 102369 w 234015"/>
                    <a:gd name="connsiteY4-34" fmla="*/ 322 h 249456"/>
                    <a:gd name="connsiteX5-35" fmla="*/ 167139 w 234015"/>
                    <a:gd name="connsiteY5-36" fmla="*/ 23182 h 249456"/>
                    <a:gd name="connsiteX6-37" fmla="*/ 212859 w 234015"/>
                    <a:gd name="connsiteY6-38" fmla="*/ 53662 h 249456"/>
                    <a:gd name="connsiteX7-39" fmla="*/ 233814 w 234015"/>
                    <a:gd name="connsiteY7-40" fmla="*/ 65092 h 249456"/>
                    <a:gd name="connsiteX8-41" fmla="*/ 220479 w 234015"/>
                    <a:gd name="connsiteY8-42" fmla="*/ 236542 h 249456"/>
                    <a:gd name="connsiteX9-43" fmla="*/ 174759 w 234015"/>
                    <a:gd name="connsiteY9-44" fmla="*/ 236542 h 249456"/>
                    <a:gd name="connsiteX10-45" fmla="*/ 108084 w 234015"/>
                    <a:gd name="connsiteY10-46" fmla="*/ 230827 h 249456"/>
                    <a:gd name="connsiteX11-47" fmla="*/ 41409 w 234015"/>
                    <a:gd name="connsiteY11-48" fmla="*/ 209872 h 249456"/>
                    <a:gd name="connsiteX0-49" fmla="*/ 41409 w 235015"/>
                    <a:gd name="connsiteY0-50" fmla="*/ 209872 h 240021"/>
                    <a:gd name="connsiteX1-51" fmla="*/ 3309 w 235015"/>
                    <a:gd name="connsiteY1-52" fmla="*/ 152722 h 240021"/>
                    <a:gd name="connsiteX2-53" fmla="*/ 5214 w 235015"/>
                    <a:gd name="connsiteY2-54" fmla="*/ 91762 h 240021"/>
                    <a:gd name="connsiteX3-55" fmla="*/ 31884 w 235015"/>
                    <a:gd name="connsiteY3-56" fmla="*/ 40327 h 240021"/>
                    <a:gd name="connsiteX4-57" fmla="*/ 102369 w 235015"/>
                    <a:gd name="connsiteY4-58" fmla="*/ 322 h 240021"/>
                    <a:gd name="connsiteX5-59" fmla="*/ 167139 w 235015"/>
                    <a:gd name="connsiteY5-60" fmla="*/ 23182 h 240021"/>
                    <a:gd name="connsiteX6-61" fmla="*/ 212859 w 235015"/>
                    <a:gd name="connsiteY6-62" fmla="*/ 53662 h 240021"/>
                    <a:gd name="connsiteX7-63" fmla="*/ 233814 w 235015"/>
                    <a:gd name="connsiteY7-64" fmla="*/ 65092 h 240021"/>
                    <a:gd name="connsiteX8-65" fmla="*/ 226194 w 235015"/>
                    <a:gd name="connsiteY8-66" fmla="*/ 221302 h 240021"/>
                    <a:gd name="connsiteX9-67" fmla="*/ 174759 w 235015"/>
                    <a:gd name="connsiteY9-68" fmla="*/ 236542 h 240021"/>
                    <a:gd name="connsiteX10-69" fmla="*/ 108084 w 235015"/>
                    <a:gd name="connsiteY10-70" fmla="*/ 230827 h 240021"/>
                    <a:gd name="connsiteX11-71" fmla="*/ 41409 w 235015"/>
                    <a:gd name="connsiteY11-72" fmla="*/ 209872 h 240021"/>
                    <a:gd name="connsiteX0-73" fmla="*/ 41409 w 235015"/>
                    <a:gd name="connsiteY0-74" fmla="*/ 210109 h 240258"/>
                    <a:gd name="connsiteX1-75" fmla="*/ 3309 w 235015"/>
                    <a:gd name="connsiteY1-76" fmla="*/ 152959 h 240258"/>
                    <a:gd name="connsiteX2-77" fmla="*/ 5214 w 235015"/>
                    <a:gd name="connsiteY2-78" fmla="*/ 91999 h 240258"/>
                    <a:gd name="connsiteX3-79" fmla="*/ 31884 w 235015"/>
                    <a:gd name="connsiteY3-80" fmla="*/ 40564 h 240258"/>
                    <a:gd name="connsiteX4-81" fmla="*/ 102369 w 235015"/>
                    <a:gd name="connsiteY4-82" fmla="*/ 559 h 240258"/>
                    <a:gd name="connsiteX5-83" fmla="*/ 159519 w 235015"/>
                    <a:gd name="connsiteY5-84" fmla="*/ 19609 h 240258"/>
                    <a:gd name="connsiteX6-85" fmla="*/ 212859 w 235015"/>
                    <a:gd name="connsiteY6-86" fmla="*/ 53899 h 240258"/>
                    <a:gd name="connsiteX7-87" fmla="*/ 233814 w 235015"/>
                    <a:gd name="connsiteY7-88" fmla="*/ 65329 h 240258"/>
                    <a:gd name="connsiteX8-89" fmla="*/ 226194 w 235015"/>
                    <a:gd name="connsiteY8-90" fmla="*/ 221539 h 240258"/>
                    <a:gd name="connsiteX9-91" fmla="*/ 174759 w 235015"/>
                    <a:gd name="connsiteY9-92" fmla="*/ 236779 h 240258"/>
                    <a:gd name="connsiteX10-93" fmla="*/ 108084 w 235015"/>
                    <a:gd name="connsiteY10-94" fmla="*/ 231064 h 240258"/>
                    <a:gd name="connsiteX11-95" fmla="*/ 41409 w 235015"/>
                    <a:gd name="connsiteY11-96" fmla="*/ 210109 h 240258"/>
                  </a:gdLst>
                  <a:ahLst/>
                  <a:cxnLst>
                    <a:cxn ang="0">
                      <a:pos x="connsiteX0-1" y="connsiteY0-2"/>
                    </a:cxn>
                    <a:cxn ang="0">
                      <a:pos x="connsiteX1-3" y="connsiteY1-4"/>
                    </a:cxn>
                    <a:cxn ang="0">
                      <a:pos x="connsiteX2-5" y="connsiteY2-6"/>
                    </a:cxn>
                    <a:cxn ang="0">
                      <a:pos x="connsiteX3-7" y="connsiteY3-8"/>
                    </a:cxn>
                    <a:cxn ang="0">
                      <a:pos x="connsiteX4-9" y="connsiteY4-10"/>
                    </a:cxn>
                    <a:cxn ang="0">
                      <a:pos x="connsiteX5-11" y="connsiteY5-12"/>
                    </a:cxn>
                    <a:cxn ang="0">
                      <a:pos x="connsiteX6-13" y="connsiteY6-14"/>
                    </a:cxn>
                    <a:cxn ang="0">
                      <a:pos x="connsiteX7-15" y="connsiteY7-16"/>
                    </a:cxn>
                    <a:cxn ang="0">
                      <a:pos x="connsiteX8-17" y="connsiteY8-18"/>
                    </a:cxn>
                    <a:cxn ang="0">
                      <a:pos x="connsiteX9-19" y="connsiteY9-20"/>
                    </a:cxn>
                    <a:cxn ang="0">
                      <a:pos x="connsiteX10-21" y="connsiteY10-22"/>
                    </a:cxn>
                    <a:cxn ang="0">
                      <a:pos x="connsiteX11-23" y="connsiteY11-24"/>
                    </a:cxn>
                  </a:cxnLst>
                  <a:rect l="l" t="t" r="r" b="b"/>
                  <a:pathLst>
                    <a:path w="235015" h="240258">
                      <a:moveTo>
                        <a:pt x="41409" y="210109"/>
                      </a:moveTo>
                      <a:cubicBezTo>
                        <a:pt x="23946" y="197091"/>
                        <a:pt x="9341" y="172644"/>
                        <a:pt x="3309" y="152959"/>
                      </a:cubicBezTo>
                      <a:cubicBezTo>
                        <a:pt x="-2724" y="133274"/>
                        <a:pt x="451" y="110731"/>
                        <a:pt x="5214" y="91999"/>
                      </a:cubicBezTo>
                      <a:cubicBezTo>
                        <a:pt x="9976" y="73266"/>
                        <a:pt x="15691" y="55804"/>
                        <a:pt x="31884" y="40564"/>
                      </a:cubicBezTo>
                      <a:cubicBezTo>
                        <a:pt x="48077" y="25324"/>
                        <a:pt x="81097" y="4051"/>
                        <a:pt x="102369" y="559"/>
                      </a:cubicBezTo>
                      <a:cubicBezTo>
                        <a:pt x="123641" y="-2933"/>
                        <a:pt x="141104" y="10719"/>
                        <a:pt x="159519" y="19609"/>
                      </a:cubicBezTo>
                      <a:cubicBezTo>
                        <a:pt x="177934" y="28499"/>
                        <a:pt x="200477" y="46279"/>
                        <a:pt x="212859" y="53899"/>
                      </a:cubicBezTo>
                      <a:cubicBezTo>
                        <a:pt x="225241" y="61519"/>
                        <a:pt x="231592" y="37389"/>
                        <a:pt x="233814" y="65329"/>
                      </a:cubicBezTo>
                      <a:cubicBezTo>
                        <a:pt x="236037" y="93269"/>
                        <a:pt x="236036" y="192964"/>
                        <a:pt x="226194" y="221539"/>
                      </a:cubicBezTo>
                      <a:cubicBezTo>
                        <a:pt x="216352" y="250114"/>
                        <a:pt x="193491" y="237731"/>
                        <a:pt x="174759" y="236779"/>
                      </a:cubicBezTo>
                      <a:cubicBezTo>
                        <a:pt x="156027" y="235827"/>
                        <a:pt x="130309" y="235509"/>
                        <a:pt x="108084" y="231064"/>
                      </a:cubicBezTo>
                      <a:cubicBezTo>
                        <a:pt x="85859" y="226619"/>
                        <a:pt x="58872" y="223127"/>
                        <a:pt x="41409" y="210109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1" name="任意多边形: 形状 240"/>
                <p:cNvSpPr/>
                <p:nvPr/>
              </p:nvSpPr>
              <p:spPr>
                <a:xfrm>
                  <a:off x="2436377" y="3945281"/>
                  <a:ext cx="156766" cy="170219"/>
                </a:xfrm>
                <a:custGeom>
                  <a:avLst/>
                  <a:gdLst>
                    <a:gd name="connsiteX0" fmla="*/ 97250 w 156766"/>
                    <a:gd name="connsiteY0" fmla="*/ 176072 h 188001"/>
                    <a:gd name="connsiteX1" fmla="*/ 22955 w 156766"/>
                    <a:gd name="connsiteY1" fmla="*/ 128447 h 188001"/>
                    <a:gd name="connsiteX2" fmla="*/ 2000 w 156766"/>
                    <a:gd name="connsiteY2" fmla="*/ 71297 h 188001"/>
                    <a:gd name="connsiteX3" fmla="*/ 5810 w 156766"/>
                    <a:gd name="connsiteY3" fmla="*/ 31292 h 188001"/>
                    <a:gd name="connsiteX4" fmla="*/ 45815 w 156766"/>
                    <a:gd name="connsiteY4" fmla="*/ 2717 h 188001"/>
                    <a:gd name="connsiteX5" fmla="*/ 95345 w 156766"/>
                    <a:gd name="connsiteY5" fmla="*/ 4622 h 188001"/>
                    <a:gd name="connsiteX6" fmla="*/ 137255 w 156766"/>
                    <a:gd name="connsiteY6" fmla="*/ 33197 h 188001"/>
                    <a:gd name="connsiteX7" fmla="*/ 146780 w 156766"/>
                    <a:gd name="connsiteY7" fmla="*/ 67487 h 188001"/>
                    <a:gd name="connsiteX8" fmla="*/ 156305 w 156766"/>
                    <a:gd name="connsiteY8" fmla="*/ 99872 h 188001"/>
                    <a:gd name="connsiteX9" fmla="*/ 154400 w 156766"/>
                    <a:gd name="connsiteY9" fmla="*/ 164642 h 188001"/>
                    <a:gd name="connsiteX10" fmla="*/ 146780 w 156766"/>
                    <a:gd name="connsiteY10" fmla="*/ 187502 h 188001"/>
                    <a:gd name="connsiteX11" fmla="*/ 97250 w 156766"/>
                    <a:gd name="connsiteY11" fmla="*/ 176072 h 188001"/>
                    <a:gd name="connsiteX0-1" fmla="*/ 97250 w 156766"/>
                    <a:gd name="connsiteY0-2" fmla="*/ 176072 h 177045"/>
                    <a:gd name="connsiteX1-3" fmla="*/ 22955 w 156766"/>
                    <a:gd name="connsiteY1-4" fmla="*/ 128447 h 177045"/>
                    <a:gd name="connsiteX2-5" fmla="*/ 2000 w 156766"/>
                    <a:gd name="connsiteY2-6" fmla="*/ 71297 h 177045"/>
                    <a:gd name="connsiteX3-7" fmla="*/ 5810 w 156766"/>
                    <a:gd name="connsiteY3-8" fmla="*/ 31292 h 177045"/>
                    <a:gd name="connsiteX4-9" fmla="*/ 45815 w 156766"/>
                    <a:gd name="connsiteY4-10" fmla="*/ 2717 h 177045"/>
                    <a:gd name="connsiteX5-11" fmla="*/ 95345 w 156766"/>
                    <a:gd name="connsiteY5-12" fmla="*/ 4622 h 177045"/>
                    <a:gd name="connsiteX6-13" fmla="*/ 137255 w 156766"/>
                    <a:gd name="connsiteY6-14" fmla="*/ 33197 h 177045"/>
                    <a:gd name="connsiteX7-15" fmla="*/ 146780 w 156766"/>
                    <a:gd name="connsiteY7-16" fmla="*/ 67487 h 177045"/>
                    <a:gd name="connsiteX8-17" fmla="*/ 156305 w 156766"/>
                    <a:gd name="connsiteY8-18" fmla="*/ 99872 h 177045"/>
                    <a:gd name="connsiteX9-19" fmla="*/ 154400 w 156766"/>
                    <a:gd name="connsiteY9-20" fmla="*/ 164642 h 177045"/>
                    <a:gd name="connsiteX10-21" fmla="*/ 150590 w 156766"/>
                    <a:gd name="connsiteY10-22" fmla="*/ 160832 h 177045"/>
                    <a:gd name="connsiteX11-23" fmla="*/ 97250 w 156766"/>
                    <a:gd name="connsiteY11-24" fmla="*/ 176072 h 177045"/>
                    <a:gd name="connsiteX0-25" fmla="*/ 89630 w 156766"/>
                    <a:gd name="connsiteY0-26" fmla="*/ 166547 h 170219"/>
                    <a:gd name="connsiteX1-27" fmla="*/ 22955 w 156766"/>
                    <a:gd name="connsiteY1-28" fmla="*/ 128447 h 170219"/>
                    <a:gd name="connsiteX2-29" fmla="*/ 2000 w 156766"/>
                    <a:gd name="connsiteY2-30" fmla="*/ 71297 h 170219"/>
                    <a:gd name="connsiteX3-31" fmla="*/ 5810 w 156766"/>
                    <a:gd name="connsiteY3-32" fmla="*/ 31292 h 170219"/>
                    <a:gd name="connsiteX4-33" fmla="*/ 45815 w 156766"/>
                    <a:gd name="connsiteY4-34" fmla="*/ 2717 h 170219"/>
                    <a:gd name="connsiteX5-35" fmla="*/ 95345 w 156766"/>
                    <a:gd name="connsiteY5-36" fmla="*/ 4622 h 170219"/>
                    <a:gd name="connsiteX6-37" fmla="*/ 137255 w 156766"/>
                    <a:gd name="connsiteY6-38" fmla="*/ 33197 h 170219"/>
                    <a:gd name="connsiteX7-39" fmla="*/ 146780 w 156766"/>
                    <a:gd name="connsiteY7-40" fmla="*/ 67487 h 170219"/>
                    <a:gd name="connsiteX8-41" fmla="*/ 156305 w 156766"/>
                    <a:gd name="connsiteY8-42" fmla="*/ 99872 h 170219"/>
                    <a:gd name="connsiteX9-43" fmla="*/ 154400 w 156766"/>
                    <a:gd name="connsiteY9-44" fmla="*/ 164642 h 170219"/>
                    <a:gd name="connsiteX10-45" fmla="*/ 150590 w 156766"/>
                    <a:gd name="connsiteY10-46" fmla="*/ 160832 h 170219"/>
                    <a:gd name="connsiteX11-47" fmla="*/ 89630 w 156766"/>
                    <a:gd name="connsiteY11-48" fmla="*/ 166547 h 170219"/>
                  </a:gdLst>
                  <a:ahLst/>
                  <a:cxnLst>
                    <a:cxn ang="0">
                      <a:pos x="connsiteX0-1" y="connsiteY0-2"/>
                    </a:cxn>
                    <a:cxn ang="0">
                      <a:pos x="connsiteX1-3" y="connsiteY1-4"/>
                    </a:cxn>
                    <a:cxn ang="0">
                      <a:pos x="connsiteX2-5" y="connsiteY2-6"/>
                    </a:cxn>
                    <a:cxn ang="0">
                      <a:pos x="connsiteX3-7" y="connsiteY3-8"/>
                    </a:cxn>
                    <a:cxn ang="0">
                      <a:pos x="connsiteX4-9" y="connsiteY4-10"/>
                    </a:cxn>
                    <a:cxn ang="0">
                      <a:pos x="connsiteX5-11" y="connsiteY5-12"/>
                    </a:cxn>
                    <a:cxn ang="0">
                      <a:pos x="connsiteX6-13" y="connsiteY6-14"/>
                    </a:cxn>
                    <a:cxn ang="0">
                      <a:pos x="connsiteX7-15" y="connsiteY7-16"/>
                    </a:cxn>
                    <a:cxn ang="0">
                      <a:pos x="connsiteX8-17" y="connsiteY8-18"/>
                    </a:cxn>
                    <a:cxn ang="0">
                      <a:pos x="connsiteX9-19" y="connsiteY9-20"/>
                    </a:cxn>
                    <a:cxn ang="0">
                      <a:pos x="connsiteX10-21" y="connsiteY10-22"/>
                    </a:cxn>
                    <a:cxn ang="0">
                      <a:pos x="connsiteX11-23" y="connsiteY11-24"/>
                    </a:cxn>
                  </a:cxnLst>
                  <a:rect l="l" t="t" r="r" b="b"/>
                  <a:pathLst>
                    <a:path w="156766" h="170219">
                      <a:moveTo>
                        <a:pt x="89630" y="166547"/>
                      </a:moveTo>
                      <a:cubicBezTo>
                        <a:pt x="68358" y="161150"/>
                        <a:pt x="37560" y="144322"/>
                        <a:pt x="22955" y="128447"/>
                      </a:cubicBezTo>
                      <a:cubicBezTo>
                        <a:pt x="8350" y="112572"/>
                        <a:pt x="4857" y="87489"/>
                        <a:pt x="2000" y="71297"/>
                      </a:cubicBezTo>
                      <a:cubicBezTo>
                        <a:pt x="-857" y="55105"/>
                        <a:pt x="-1493" y="42722"/>
                        <a:pt x="5810" y="31292"/>
                      </a:cubicBezTo>
                      <a:cubicBezTo>
                        <a:pt x="13112" y="19862"/>
                        <a:pt x="30893" y="7162"/>
                        <a:pt x="45815" y="2717"/>
                      </a:cubicBezTo>
                      <a:cubicBezTo>
                        <a:pt x="60737" y="-1728"/>
                        <a:pt x="80105" y="-458"/>
                        <a:pt x="95345" y="4622"/>
                      </a:cubicBezTo>
                      <a:cubicBezTo>
                        <a:pt x="110585" y="9702"/>
                        <a:pt x="128683" y="22720"/>
                        <a:pt x="137255" y="33197"/>
                      </a:cubicBezTo>
                      <a:cubicBezTo>
                        <a:pt x="145827" y="43674"/>
                        <a:pt x="143605" y="56374"/>
                        <a:pt x="146780" y="67487"/>
                      </a:cubicBezTo>
                      <a:cubicBezTo>
                        <a:pt x="149955" y="78600"/>
                        <a:pt x="155035" y="83679"/>
                        <a:pt x="156305" y="99872"/>
                      </a:cubicBezTo>
                      <a:cubicBezTo>
                        <a:pt x="157575" y="116064"/>
                        <a:pt x="155987" y="150037"/>
                        <a:pt x="154400" y="164642"/>
                      </a:cubicBezTo>
                      <a:cubicBezTo>
                        <a:pt x="152813" y="179247"/>
                        <a:pt x="161385" y="160515"/>
                        <a:pt x="150590" y="160832"/>
                      </a:cubicBezTo>
                      <a:cubicBezTo>
                        <a:pt x="139795" y="161150"/>
                        <a:pt x="110903" y="171945"/>
                        <a:pt x="89630" y="166547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2" name="任意多边形: 形状 241"/>
                <p:cNvSpPr/>
                <p:nvPr/>
              </p:nvSpPr>
              <p:spPr>
                <a:xfrm>
                  <a:off x="2805934" y="3991346"/>
                  <a:ext cx="212568" cy="247643"/>
                </a:xfrm>
                <a:custGeom>
                  <a:avLst/>
                  <a:gdLst>
                    <a:gd name="connsiteX0" fmla="*/ 46282 w 212568"/>
                    <a:gd name="connsiteY0" fmla="*/ 212555 h 247643"/>
                    <a:gd name="connsiteX1" fmla="*/ 13897 w 212568"/>
                    <a:gd name="connsiteY1" fmla="*/ 164930 h 247643"/>
                    <a:gd name="connsiteX2" fmla="*/ 562 w 212568"/>
                    <a:gd name="connsiteY2" fmla="*/ 96350 h 247643"/>
                    <a:gd name="connsiteX3" fmla="*/ 31042 w 212568"/>
                    <a:gd name="connsiteY3" fmla="*/ 31580 h 247643"/>
                    <a:gd name="connsiteX4" fmla="*/ 76762 w 212568"/>
                    <a:gd name="connsiteY4" fmla="*/ 3005 h 247643"/>
                    <a:gd name="connsiteX5" fmla="*/ 122482 w 212568"/>
                    <a:gd name="connsiteY5" fmla="*/ 3005 h 247643"/>
                    <a:gd name="connsiteX6" fmla="*/ 160582 w 212568"/>
                    <a:gd name="connsiteY6" fmla="*/ 22055 h 247643"/>
                    <a:gd name="connsiteX7" fmla="*/ 204397 w 212568"/>
                    <a:gd name="connsiteY7" fmla="*/ 81110 h 247643"/>
                    <a:gd name="connsiteX8" fmla="*/ 212017 w 212568"/>
                    <a:gd name="connsiteY8" fmla="*/ 134450 h 247643"/>
                    <a:gd name="connsiteX9" fmla="*/ 196777 w 212568"/>
                    <a:gd name="connsiteY9" fmla="*/ 199220 h 247643"/>
                    <a:gd name="connsiteX10" fmla="*/ 124387 w 212568"/>
                    <a:gd name="connsiteY10" fmla="*/ 246845 h 247643"/>
                    <a:gd name="connsiteX11" fmla="*/ 46282 w 212568"/>
                    <a:gd name="connsiteY11" fmla="*/ 212555 h 24764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</a:cxnLst>
                  <a:rect l="l" t="t" r="r" b="b"/>
                  <a:pathLst>
                    <a:path w="212568" h="247643">
                      <a:moveTo>
                        <a:pt x="46282" y="212555"/>
                      </a:moveTo>
                      <a:cubicBezTo>
                        <a:pt x="27867" y="198903"/>
                        <a:pt x="21517" y="184297"/>
                        <a:pt x="13897" y="164930"/>
                      </a:cubicBezTo>
                      <a:cubicBezTo>
                        <a:pt x="6277" y="145562"/>
                        <a:pt x="-2295" y="118575"/>
                        <a:pt x="562" y="96350"/>
                      </a:cubicBezTo>
                      <a:cubicBezTo>
                        <a:pt x="3419" y="74125"/>
                        <a:pt x="18342" y="47137"/>
                        <a:pt x="31042" y="31580"/>
                      </a:cubicBezTo>
                      <a:cubicBezTo>
                        <a:pt x="43742" y="16023"/>
                        <a:pt x="61522" y="7767"/>
                        <a:pt x="76762" y="3005"/>
                      </a:cubicBezTo>
                      <a:cubicBezTo>
                        <a:pt x="92002" y="-1757"/>
                        <a:pt x="108512" y="-170"/>
                        <a:pt x="122482" y="3005"/>
                      </a:cubicBezTo>
                      <a:cubicBezTo>
                        <a:pt x="136452" y="6180"/>
                        <a:pt x="146930" y="9038"/>
                        <a:pt x="160582" y="22055"/>
                      </a:cubicBezTo>
                      <a:cubicBezTo>
                        <a:pt x="174234" y="35072"/>
                        <a:pt x="195825" y="62378"/>
                        <a:pt x="204397" y="81110"/>
                      </a:cubicBezTo>
                      <a:cubicBezTo>
                        <a:pt x="212969" y="99842"/>
                        <a:pt x="213287" y="114765"/>
                        <a:pt x="212017" y="134450"/>
                      </a:cubicBezTo>
                      <a:cubicBezTo>
                        <a:pt x="210747" y="154135"/>
                        <a:pt x="211382" y="180488"/>
                        <a:pt x="196777" y="199220"/>
                      </a:cubicBezTo>
                      <a:cubicBezTo>
                        <a:pt x="182172" y="217952"/>
                        <a:pt x="145342" y="241130"/>
                        <a:pt x="124387" y="246845"/>
                      </a:cubicBezTo>
                      <a:cubicBezTo>
                        <a:pt x="103432" y="252560"/>
                        <a:pt x="64697" y="226207"/>
                        <a:pt x="46282" y="212555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3" name="任意多边形: 形状 242"/>
                <p:cNvSpPr/>
                <p:nvPr/>
              </p:nvSpPr>
              <p:spPr>
                <a:xfrm>
                  <a:off x="3444015" y="3579443"/>
                  <a:ext cx="235015" cy="240258"/>
                </a:xfrm>
                <a:custGeom>
                  <a:avLst/>
                  <a:gdLst>
                    <a:gd name="connsiteX0" fmla="*/ 41409 w 223120"/>
                    <a:gd name="connsiteY0" fmla="*/ 209872 h 249456"/>
                    <a:gd name="connsiteX1" fmla="*/ 3309 w 223120"/>
                    <a:gd name="connsiteY1" fmla="*/ 152722 h 249456"/>
                    <a:gd name="connsiteX2" fmla="*/ 5214 w 223120"/>
                    <a:gd name="connsiteY2" fmla="*/ 91762 h 249456"/>
                    <a:gd name="connsiteX3" fmla="*/ 31884 w 223120"/>
                    <a:gd name="connsiteY3" fmla="*/ 40327 h 249456"/>
                    <a:gd name="connsiteX4" fmla="*/ 102369 w 223120"/>
                    <a:gd name="connsiteY4" fmla="*/ 322 h 249456"/>
                    <a:gd name="connsiteX5" fmla="*/ 167139 w 223120"/>
                    <a:gd name="connsiteY5" fmla="*/ 23182 h 249456"/>
                    <a:gd name="connsiteX6" fmla="*/ 212859 w 223120"/>
                    <a:gd name="connsiteY6" fmla="*/ 53662 h 249456"/>
                    <a:gd name="connsiteX7" fmla="*/ 212859 w 223120"/>
                    <a:gd name="connsiteY7" fmla="*/ 65092 h 249456"/>
                    <a:gd name="connsiteX8" fmla="*/ 220479 w 223120"/>
                    <a:gd name="connsiteY8" fmla="*/ 236542 h 249456"/>
                    <a:gd name="connsiteX9" fmla="*/ 161424 w 223120"/>
                    <a:gd name="connsiteY9" fmla="*/ 236542 h 249456"/>
                    <a:gd name="connsiteX10" fmla="*/ 108084 w 223120"/>
                    <a:gd name="connsiteY10" fmla="*/ 230827 h 249456"/>
                    <a:gd name="connsiteX11" fmla="*/ 41409 w 223120"/>
                    <a:gd name="connsiteY11" fmla="*/ 209872 h 249456"/>
                    <a:gd name="connsiteX0-1" fmla="*/ 41409 w 234109"/>
                    <a:gd name="connsiteY0-2" fmla="*/ 209872 h 249456"/>
                    <a:gd name="connsiteX1-3" fmla="*/ 3309 w 234109"/>
                    <a:gd name="connsiteY1-4" fmla="*/ 152722 h 249456"/>
                    <a:gd name="connsiteX2-5" fmla="*/ 5214 w 234109"/>
                    <a:gd name="connsiteY2-6" fmla="*/ 91762 h 249456"/>
                    <a:gd name="connsiteX3-7" fmla="*/ 31884 w 234109"/>
                    <a:gd name="connsiteY3-8" fmla="*/ 40327 h 249456"/>
                    <a:gd name="connsiteX4-9" fmla="*/ 102369 w 234109"/>
                    <a:gd name="connsiteY4-10" fmla="*/ 322 h 249456"/>
                    <a:gd name="connsiteX5-11" fmla="*/ 167139 w 234109"/>
                    <a:gd name="connsiteY5-12" fmla="*/ 23182 h 249456"/>
                    <a:gd name="connsiteX6-13" fmla="*/ 212859 w 234109"/>
                    <a:gd name="connsiteY6-14" fmla="*/ 53662 h 249456"/>
                    <a:gd name="connsiteX7-15" fmla="*/ 233814 w 234109"/>
                    <a:gd name="connsiteY7-16" fmla="*/ 65092 h 249456"/>
                    <a:gd name="connsiteX8-17" fmla="*/ 220479 w 234109"/>
                    <a:gd name="connsiteY8-18" fmla="*/ 236542 h 249456"/>
                    <a:gd name="connsiteX9-19" fmla="*/ 161424 w 234109"/>
                    <a:gd name="connsiteY9-20" fmla="*/ 236542 h 249456"/>
                    <a:gd name="connsiteX10-21" fmla="*/ 108084 w 234109"/>
                    <a:gd name="connsiteY10-22" fmla="*/ 230827 h 249456"/>
                    <a:gd name="connsiteX11-23" fmla="*/ 41409 w 234109"/>
                    <a:gd name="connsiteY11-24" fmla="*/ 209872 h 249456"/>
                    <a:gd name="connsiteX0-25" fmla="*/ 41409 w 234015"/>
                    <a:gd name="connsiteY0-26" fmla="*/ 209872 h 249456"/>
                    <a:gd name="connsiteX1-27" fmla="*/ 3309 w 234015"/>
                    <a:gd name="connsiteY1-28" fmla="*/ 152722 h 249456"/>
                    <a:gd name="connsiteX2-29" fmla="*/ 5214 w 234015"/>
                    <a:gd name="connsiteY2-30" fmla="*/ 91762 h 249456"/>
                    <a:gd name="connsiteX3-31" fmla="*/ 31884 w 234015"/>
                    <a:gd name="connsiteY3-32" fmla="*/ 40327 h 249456"/>
                    <a:gd name="connsiteX4-33" fmla="*/ 102369 w 234015"/>
                    <a:gd name="connsiteY4-34" fmla="*/ 322 h 249456"/>
                    <a:gd name="connsiteX5-35" fmla="*/ 167139 w 234015"/>
                    <a:gd name="connsiteY5-36" fmla="*/ 23182 h 249456"/>
                    <a:gd name="connsiteX6-37" fmla="*/ 212859 w 234015"/>
                    <a:gd name="connsiteY6-38" fmla="*/ 53662 h 249456"/>
                    <a:gd name="connsiteX7-39" fmla="*/ 233814 w 234015"/>
                    <a:gd name="connsiteY7-40" fmla="*/ 65092 h 249456"/>
                    <a:gd name="connsiteX8-41" fmla="*/ 220479 w 234015"/>
                    <a:gd name="connsiteY8-42" fmla="*/ 236542 h 249456"/>
                    <a:gd name="connsiteX9-43" fmla="*/ 174759 w 234015"/>
                    <a:gd name="connsiteY9-44" fmla="*/ 236542 h 249456"/>
                    <a:gd name="connsiteX10-45" fmla="*/ 108084 w 234015"/>
                    <a:gd name="connsiteY10-46" fmla="*/ 230827 h 249456"/>
                    <a:gd name="connsiteX11-47" fmla="*/ 41409 w 234015"/>
                    <a:gd name="connsiteY11-48" fmla="*/ 209872 h 249456"/>
                    <a:gd name="connsiteX0-49" fmla="*/ 41409 w 235015"/>
                    <a:gd name="connsiteY0-50" fmla="*/ 209872 h 240021"/>
                    <a:gd name="connsiteX1-51" fmla="*/ 3309 w 235015"/>
                    <a:gd name="connsiteY1-52" fmla="*/ 152722 h 240021"/>
                    <a:gd name="connsiteX2-53" fmla="*/ 5214 w 235015"/>
                    <a:gd name="connsiteY2-54" fmla="*/ 91762 h 240021"/>
                    <a:gd name="connsiteX3-55" fmla="*/ 31884 w 235015"/>
                    <a:gd name="connsiteY3-56" fmla="*/ 40327 h 240021"/>
                    <a:gd name="connsiteX4-57" fmla="*/ 102369 w 235015"/>
                    <a:gd name="connsiteY4-58" fmla="*/ 322 h 240021"/>
                    <a:gd name="connsiteX5-59" fmla="*/ 167139 w 235015"/>
                    <a:gd name="connsiteY5-60" fmla="*/ 23182 h 240021"/>
                    <a:gd name="connsiteX6-61" fmla="*/ 212859 w 235015"/>
                    <a:gd name="connsiteY6-62" fmla="*/ 53662 h 240021"/>
                    <a:gd name="connsiteX7-63" fmla="*/ 233814 w 235015"/>
                    <a:gd name="connsiteY7-64" fmla="*/ 65092 h 240021"/>
                    <a:gd name="connsiteX8-65" fmla="*/ 226194 w 235015"/>
                    <a:gd name="connsiteY8-66" fmla="*/ 221302 h 240021"/>
                    <a:gd name="connsiteX9-67" fmla="*/ 174759 w 235015"/>
                    <a:gd name="connsiteY9-68" fmla="*/ 236542 h 240021"/>
                    <a:gd name="connsiteX10-69" fmla="*/ 108084 w 235015"/>
                    <a:gd name="connsiteY10-70" fmla="*/ 230827 h 240021"/>
                    <a:gd name="connsiteX11-71" fmla="*/ 41409 w 235015"/>
                    <a:gd name="connsiteY11-72" fmla="*/ 209872 h 240021"/>
                    <a:gd name="connsiteX0-73" fmla="*/ 41409 w 235015"/>
                    <a:gd name="connsiteY0-74" fmla="*/ 210109 h 240258"/>
                    <a:gd name="connsiteX1-75" fmla="*/ 3309 w 235015"/>
                    <a:gd name="connsiteY1-76" fmla="*/ 152959 h 240258"/>
                    <a:gd name="connsiteX2-77" fmla="*/ 5214 w 235015"/>
                    <a:gd name="connsiteY2-78" fmla="*/ 91999 h 240258"/>
                    <a:gd name="connsiteX3-79" fmla="*/ 31884 w 235015"/>
                    <a:gd name="connsiteY3-80" fmla="*/ 40564 h 240258"/>
                    <a:gd name="connsiteX4-81" fmla="*/ 102369 w 235015"/>
                    <a:gd name="connsiteY4-82" fmla="*/ 559 h 240258"/>
                    <a:gd name="connsiteX5-83" fmla="*/ 159519 w 235015"/>
                    <a:gd name="connsiteY5-84" fmla="*/ 19609 h 240258"/>
                    <a:gd name="connsiteX6-85" fmla="*/ 212859 w 235015"/>
                    <a:gd name="connsiteY6-86" fmla="*/ 53899 h 240258"/>
                    <a:gd name="connsiteX7-87" fmla="*/ 233814 w 235015"/>
                    <a:gd name="connsiteY7-88" fmla="*/ 65329 h 240258"/>
                    <a:gd name="connsiteX8-89" fmla="*/ 226194 w 235015"/>
                    <a:gd name="connsiteY8-90" fmla="*/ 221539 h 240258"/>
                    <a:gd name="connsiteX9-91" fmla="*/ 174759 w 235015"/>
                    <a:gd name="connsiteY9-92" fmla="*/ 236779 h 240258"/>
                    <a:gd name="connsiteX10-93" fmla="*/ 108084 w 235015"/>
                    <a:gd name="connsiteY10-94" fmla="*/ 231064 h 240258"/>
                    <a:gd name="connsiteX11-95" fmla="*/ 41409 w 235015"/>
                    <a:gd name="connsiteY11-96" fmla="*/ 210109 h 240258"/>
                  </a:gdLst>
                  <a:ahLst/>
                  <a:cxnLst>
                    <a:cxn ang="0">
                      <a:pos x="connsiteX0-1" y="connsiteY0-2"/>
                    </a:cxn>
                    <a:cxn ang="0">
                      <a:pos x="connsiteX1-3" y="connsiteY1-4"/>
                    </a:cxn>
                    <a:cxn ang="0">
                      <a:pos x="connsiteX2-5" y="connsiteY2-6"/>
                    </a:cxn>
                    <a:cxn ang="0">
                      <a:pos x="connsiteX3-7" y="connsiteY3-8"/>
                    </a:cxn>
                    <a:cxn ang="0">
                      <a:pos x="connsiteX4-9" y="connsiteY4-10"/>
                    </a:cxn>
                    <a:cxn ang="0">
                      <a:pos x="connsiteX5-11" y="connsiteY5-12"/>
                    </a:cxn>
                    <a:cxn ang="0">
                      <a:pos x="connsiteX6-13" y="connsiteY6-14"/>
                    </a:cxn>
                    <a:cxn ang="0">
                      <a:pos x="connsiteX7-15" y="connsiteY7-16"/>
                    </a:cxn>
                    <a:cxn ang="0">
                      <a:pos x="connsiteX8-17" y="connsiteY8-18"/>
                    </a:cxn>
                    <a:cxn ang="0">
                      <a:pos x="connsiteX9-19" y="connsiteY9-20"/>
                    </a:cxn>
                    <a:cxn ang="0">
                      <a:pos x="connsiteX10-21" y="connsiteY10-22"/>
                    </a:cxn>
                    <a:cxn ang="0">
                      <a:pos x="connsiteX11-23" y="connsiteY11-24"/>
                    </a:cxn>
                  </a:cxnLst>
                  <a:rect l="l" t="t" r="r" b="b"/>
                  <a:pathLst>
                    <a:path w="235015" h="240258">
                      <a:moveTo>
                        <a:pt x="41409" y="210109"/>
                      </a:moveTo>
                      <a:cubicBezTo>
                        <a:pt x="23946" y="197091"/>
                        <a:pt x="9341" y="172644"/>
                        <a:pt x="3309" y="152959"/>
                      </a:cubicBezTo>
                      <a:cubicBezTo>
                        <a:pt x="-2724" y="133274"/>
                        <a:pt x="451" y="110731"/>
                        <a:pt x="5214" y="91999"/>
                      </a:cubicBezTo>
                      <a:cubicBezTo>
                        <a:pt x="9976" y="73266"/>
                        <a:pt x="15691" y="55804"/>
                        <a:pt x="31884" y="40564"/>
                      </a:cubicBezTo>
                      <a:cubicBezTo>
                        <a:pt x="48077" y="25324"/>
                        <a:pt x="81097" y="4051"/>
                        <a:pt x="102369" y="559"/>
                      </a:cubicBezTo>
                      <a:cubicBezTo>
                        <a:pt x="123641" y="-2933"/>
                        <a:pt x="141104" y="10719"/>
                        <a:pt x="159519" y="19609"/>
                      </a:cubicBezTo>
                      <a:cubicBezTo>
                        <a:pt x="177934" y="28499"/>
                        <a:pt x="200477" y="46279"/>
                        <a:pt x="212859" y="53899"/>
                      </a:cubicBezTo>
                      <a:cubicBezTo>
                        <a:pt x="225241" y="61519"/>
                        <a:pt x="231592" y="37389"/>
                        <a:pt x="233814" y="65329"/>
                      </a:cubicBezTo>
                      <a:cubicBezTo>
                        <a:pt x="236037" y="93269"/>
                        <a:pt x="236036" y="192964"/>
                        <a:pt x="226194" y="221539"/>
                      </a:cubicBezTo>
                      <a:cubicBezTo>
                        <a:pt x="216352" y="250114"/>
                        <a:pt x="193491" y="237731"/>
                        <a:pt x="174759" y="236779"/>
                      </a:cubicBezTo>
                      <a:cubicBezTo>
                        <a:pt x="156027" y="235827"/>
                        <a:pt x="130309" y="235509"/>
                        <a:pt x="108084" y="231064"/>
                      </a:cubicBezTo>
                      <a:cubicBezTo>
                        <a:pt x="85859" y="226619"/>
                        <a:pt x="58872" y="223127"/>
                        <a:pt x="41409" y="210109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4" name="任意多边形: 形状 243"/>
                <p:cNvSpPr/>
                <p:nvPr/>
              </p:nvSpPr>
              <p:spPr>
                <a:xfrm>
                  <a:off x="3531047" y="3935428"/>
                  <a:ext cx="156766" cy="170219"/>
                </a:xfrm>
                <a:custGeom>
                  <a:avLst/>
                  <a:gdLst>
                    <a:gd name="connsiteX0" fmla="*/ 97250 w 156766"/>
                    <a:gd name="connsiteY0" fmla="*/ 176072 h 188001"/>
                    <a:gd name="connsiteX1" fmla="*/ 22955 w 156766"/>
                    <a:gd name="connsiteY1" fmla="*/ 128447 h 188001"/>
                    <a:gd name="connsiteX2" fmla="*/ 2000 w 156766"/>
                    <a:gd name="connsiteY2" fmla="*/ 71297 h 188001"/>
                    <a:gd name="connsiteX3" fmla="*/ 5810 w 156766"/>
                    <a:gd name="connsiteY3" fmla="*/ 31292 h 188001"/>
                    <a:gd name="connsiteX4" fmla="*/ 45815 w 156766"/>
                    <a:gd name="connsiteY4" fmla="*/ 2717 h 188001"/>
                    <a:gd name="connsiteX5" fmla="*/ 95345 w 156766"/>
                    <a:gd name="connsiteY5" fmla="*/ 4622 h 188001"/>
                    <a:gd name="connsiteX6" fmla="*/ 137255 w 156766"/>
                    <a:gd name="connsiteY6" fmla="*/ 33197 h 188001"/>
                    <a:gd name="connsiteX7" fmla="*/ 146780 w 156766"/>
                    <a:gd name="connsiteY7" fmla="*/ 67487 h 188001"/>
                    <a:gd name="connsiteX8" fmla="*/ 156305 w 156766"/>
                    <a:gd name="connsiteY8" fmla="*/ 99872 h 188001"/>
                    <a:gd name="connsiteX9" fmla="*/ 154400 w 156766"/>
                    <a:gd name="connsiteY9" fmla="*/ 164642 h 188001"/>
                    <a:gd name="connsiteX10" fmla="*/ 146780 w 156766"/>
                    <a:gd name="connsiteY10" fmla="*/ 187502 h 188001"/>
                    <a:gd name="connsiteX11" fmla="*/ 97250 w 156766"/>
                    <a:gd name="connsiteY11" fmla="*/ 176072 h 188001"/>
                    <a:gd name="connsiteX0-1" fmla="*/ 97250 w 156766"/>
                    <a:gd name="connsiteY0-2" fmla="*/ 176072 h 177045"/>
                    <a:gd name="connsiteX1-3" fmla="*/ 22955 w 156766"/>
                    <a:gd name="connsiteY1-4" fmla="*/ 128447 h 177045"/>
                    <a:gd name="connsiteX2-5" fmla="*/ 2000 w 156766"/>
                    <a:gd name="connsiteY2-6" fmla="*/ 71297 h 177045"/>
                    <a:gd name="connsiteX3-7" fmla="*/ 5810 w 156766"/>
                    <a:gd name="connsiteY3-8" fmla="*/ 31292 h 177045"/>
                    <a:gd name="connsiteX4-9" fmla="*/ 45815 w 156766"/>
                    <a:gd name="connsiteY4-10" fmla="*/ 2717 h 177045"/>
                    <a:gd name="connsiteX5-11" fmla="*/ 95345 w 156766"/>
                    <a:gd name="connsiteY5-12" fmla="*/ 4622 h 177045"/>
                    <a:gd name="connsiteX6-13" fmla="*/ 137255 w 156766"/>
                    <a:gd name="connsiteY6-14" fmla="*/ 33197 h 177045"/>
                    <a:gd name="connsiteX7-15" fmla="*/ 146780 w 156766"/>
                    <a:gd name="connsiteY7-16" fmla="*/ 67487 h 177045"/>
                    <a:gd name="connsiteX8-17" fmla="*/ 156305 w 156766"/>
                    <a:gd name="connsiteY8-18" fmla="*/ 99872 h 177045"/>
                    <a:gd name="connsiteX9-19" fmla="*/ 154400 w 156766"/>
                    <a:gd name="connsiteY9-20" fmla="*/ 164642 h 177045"/>
                    <a:gd name="connsiteX10-21" fmla="*/ 150590 w 156766"/>
                    <a:gd name="connsiteY10-22" fmla="*/ 160832 h 177045"/>
                    <a:gd name="connsiteX11-23" fmla="*/ 97250 w 156766"/>
                    <a:gd name="connsiteY11-24" fmla="*/ 176072 h 177045"/>
                    <a:gd name="connsiteX0-25" fmla="*/ 89630 w 156766"/>
                    <a:gd name="connsiteY0-26" fmla="*/ 166547 h 170219"/>
                    <a:gd name="connsiteX1-27" fmla="*/ 22955 w 156766"/>
                    <a:gd name="connsiteY1-28" fmla="*/ 128447 h 170219"/>
                    <a:gd name="connsiteX2-29" fmla="*/ 2000 w 156766"/>
                    <a:gd name="connsiteY2-30" fmla="*/ 71297 h 170219"/>
                    <a:gd name="connsiteX3-31" fmla="*/ 5810 w 156766"/>
                    <a:gd name="connsiteY3-32" fmla="*/ 31292 h 170219"/>
                    <a:gd name="connsiteX4-33" fmla="*/ 45815 w 156766"/>
                    <a:gd name="connsiteY4-34" fmla="*/ 2717 h 170219"/>
                    <a:gd name="connsiteX5-35" fmla="*/ 95345 w 156766"/>
                    <a:gd name="connsiteY5-36" fmla="*/ 4622 h 170219"/>
                    <a:gd name="connsiteX6-37" fmla="*/ 137255 w 156766"/>
                    <a:gd name="connsiteY6-38" fmla="*/ 33197 h 170219"/>
                    <a:gd name="connsiteX7-39" fmla="*/ 146780 w 156766"/>
                    <a:gd name="connsiteY7-40" fmla="*/ 67487 h 170219"/>
                    <a:gd name="connsiteX8-41" fmla="*/ 156305 w 156766"/>
                    <a:gd name="connsiteY8-42" fmla="*/ 99872 h 170219"/>
                    <a:gd name="connsiteX9-43" fmla="*/ 154400 w 156766"/>
                    <a:gd name="connsiteY9-44" fmla="*/ 164642 h 170219"/>
                    <a:gd name="connsiteX10-45" fmla="*/ 150590 w 156766"/>
                    <a:gd name="connsiteY10-46" fmla="*/ 160832 h 170219"/>
                    <a:gd name="connsiteX11-47" fmla="*/ 89630 w 156766"/>
                    <a:gd name="connsiteY11-48" fmla="*/ 166547 h 170219"/>
                  </a:gdLst>
                  <a:ahLst/>
                  <a:cxnLst>
                    <a:cxn ang="0">
                      <a:pos x="connsiteX0-1" y="connsiteY0-2"/>
                    </a:cxn>
                    <a:cxn ang="0">
                      <a:pos x="connsiteX1-3" y="connsiteY1-4"/>
                    </a:cxn>
                    <a:cxn ang="0">
                      <a:pos x="connsiteX2-5" y="connsiteY2-6"/>
                    </a:cxn>
                    <a:cxn ang="0">
                      <a:pos x="connsiteX3-7" y="connsiteY3-8"/>
                    </a:cxn>
                    <a:cxn ang="0">
                      <a:pos x="connsiteX4-9" y="connsiteY4-10"/>
                    </a:cxn>
                    <a:cxn ang="0">
                      <a:pos x="connsiteX5-11" y="connsiteY5-12"/>
                    </a:cxn>
                    <a:cxn ang="0">
                      <a:pos x="connsiteX6-13" y="connsiteY6-14"/>
                    </a:cxn>
                    <a:cxn ang="0">
                      <a:pos x="connsiteX7-15" y="connsiteY7-16"/>
                    </a:cxn>
                    <a:cxn ang="0">
                      <a:pos x="connsiteX8-17" y="connsiteY8-18"/>
                    </a:cxn>
                    <a:cxn ang="0">
                      <a:pos x="connsiteX9-19" y="connsiteY9-20"/>
                    </a:cxn>
                    <a:cxn ang="0">
                      <a:pos x="connsiteX10-21" y="connsiteY10-22"/>
                    </a:cxn>
                    <a:cxn ang="0">
                      <a:pos x="connsiteX11-23" y="connsiteY11-24"/>
                    </a:cxn>
                  </a:cxnLst>
                  <a:rect l="l" t="t" r="r" b="b"/>
                  <a:pathLst>
                    <a:path w="156766" h="170219">
                      <a:moveTo>
                        <a:pt x="89630" y="166547"/>
                      </a:moveTo>
                      <a:cubicBezTo>
                        <a:pt x="68358" y="161150"/>
                        <a:pt x="37560" y="144322"/>
                        <a:pt x="22955" y="128447"/>
                      </a:cubicBezTo>
                      <a:cubicBezTo>
                        <a:pt x="8350" y="112572"/>
                        <a:pt x="4857" y="87489"/>
                        <a:pt x="2000" y="71297"/>
                      </a:cubicBezTo>
                      <a:cubicBezTo>
                        <a:pt x="-857" y="55105"/>
                        <a:pt x="-1493" y="42722"/>
                        <a:pt x="5810" y="31292"/>
                      </a:cubicBezTo>
                      <a:cubicBezTo>
                        <a:pt x="13112" y="19862"/>
                        <a:pt x="30893" y="7162"/>
                        <a:pt x="45815" y="2717"/>
                      </a:cubicBezTo>
                      <a:cubicBezTo>
                        <a:pt x="60737" y="-1728"/>
                        <a:pt x="80105" y="-458"/>
                        <a:pt x="95345" y="4622"/>
                      </a:cubicBezTo>
                      <a:cubicBezTo>
                        <a:pt x="110585" y="9702"/>
                        <a:pt x="128683" y="22720"/>
                        <a:pt x="137255" y="33197"/>
                      </a:cubicBezTo>
                      <a:cubicBezTo>
                        <a:pt x="145827" y="43674"/>
                        <a:pt x="143605" y="56374"/>
                        <a:pt x="146780" y="67487"/>
                      </a:cubicBezTo>
                      <a:cubicBezTo>
                        <a:pt x="149955" y="78600"/>
                        <a:pt x="155035" y="83679"/>
                        <a:pt x="156305" y="99872"/>
                      </a:cubicBezTo>
                      <a:cubicBezTo>
                        <a:pt x="157575" y="116064"/>
                        <a:pt x="155987" y="150037"/>
                        <a:pt x="154400" y="164642"/>
                      </a:cubicBezTo>
                      <a:cubicBezTo>
                        <a:pt x="152813" y="179247"/>
                        <a:pt x="161385" y="160515"/>
                        <a:pt x="150590" y="160832"/>
                      </a:cubicBezTo>
                      <a:cubicBezTo>
                        <a:pt x="139795" y="161150"/>
                        <a:pt x="110903" y="171945"/>
                        <a:pt x="89630" y="166547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5" name="任意多边形: 形状 244"/>
                <p:cNvSpPr/>
                <p:nvPr/>
              </p:nvSpPr>
              <p:spPr>
                <a:xfrm>
                  <a:off x="1271137" y="3584491"/>
                  <a:ext cx="235015" cy="240258"/>
                </a:xfrm>
                <a:custGeom>
                  <a:avLst/>
                  <a:gdLst>
                    <a:gd name="connsiteX0" fmla="*/ 41409 w 223120"/>
                    <a:gd name="connsiteY0" fmla="*/ 209872 h 249456"/>
                    <a:gd name="connsiteX1" fmla="*/ 3309 w 223120"/>
                    <a:gd name="connsiteY1" fmla="*/ 152722 h 249456"/>
                    <a:gd name="connsiteX2" fmla="*/ 5214 w 223120"/>
                    <a:gd name="connsiteY2" fmla="*/ 91762 h 249456"/>
                    <a:gd name="connsiteX3" fmla="*/ 31884 w 223120"/>
                    <a:gd name="connsiteY3" fmla="*/ 40327 h 249456"/>
                    <a:gd name="connsiteX4" fmla="*/ 102369 w 223120"/>
                    <a:gd name="connsiteY4" fmla="*/ 322 h 249456"/>
                    <a:gd name="connsiteX5" fmla="*/ 167139 w 223120"/>
                    <a:gd name="connsiteY5" fmla="*/ 23182 h 249456"/>
                    <a:gd name="connsiteX6" fmla="*/ 212859 w 223120"/>
                    <a:gd name="connsiteY6" fmla="*/ 53662 h 249456"/>
                    <a:gd name="connsiteX7" fmla="*/ 212859 w 223120"/>
                    <a:gd name="connsiteY7" fmla="*/ 65092 h 249456"/>
                    <a:gd name="connsiteX8" fmla="*/ 220479 w 223120"/>
                    <a:gd name="connsiteY8" fmla="*/ 236542 h 249456"/>
                    <a:gd name="connsiteX9" fmla="*/ 161424 w 223120"/>
                    <a:gd name="connsiteY9" fmla="*/ 236542 h 249456"/>
                    <a:gd name="connsiteX10" fmla="*/ 108084 w 223120"/>
                    <a:gd name="connsiteY10" fmla="*/ 230827 h 249456"/>
                    <a:gd name="connsiteX11" fmla="*/ 41409 w 223120"/>
                    <a:gd name="connsiteY11" fmla="*/ 209872 h 249456"/>
                    <a:gd name="connsiteX0-1" fmla="*/ 41409 w 234109"/>
                    <a:gd name="connsiteY0-2" fmla="*/ 209872 h 249456"/>
                    <a:gd name="connsiteX1-3" fmla="*/ 3309 w 234109"/>
                    <a:gd name="connsiteY1-4" fmla="*/ 152722 h 249456"/>
                    <a:gd name="connsiteX2-5" fmla="*/ 5214 w 234109"/>
                    <a:gd name="connsiteY2-6" fmla="*/ 91762 h 249456"/>
                    <a:gd name="connsiteX3-7" fmla="*/ 31884 w 234109"/>
                    <a:gd name="connsiteY3-8" fmla="*/ 40327 h 249456"/>
                    <a:gd name="connsiteX4-9" fmla="*/ 102369 w 234109"/>
                    <a:gd name="connsiteY4-10" fmla="*/ 322 h 249456"/>
                    <a:gd name="connsiteX5-11" fmla="*/ 167139 w 234109"/>
                    <a:gd name="connsiteY5-12" fmla="*/ 23182 h 249456"/>
                    <a:gd name="connsiteX6-13" fmla="*/ 212859 w 234109"/>
                    <a:gd name="connsiteY6-14" fmla="*/ 53662 h 249456"/>
                    <a:gd name="connsiteX7-15" fmla="*/ 233814 w 234109"/>
                    <a:gd name="connsiteY7-16" fmla="*/ 65092 h 249456"/>
                    <a:gd name="connsiteX8-17" fmla="*/ 220479 w 234109"/>
                    <a:gd name="connsiteY8-18" fmla="*/ 236542 h 249456"/>
                    <a:gd name="connsiteX9-19" fmla="*/ 161424 w 234109"/>
                    <a:gd name="connsiteY9-20" fmla="*/ 236542 h 249456"/>
                    <a:gd name="connsiteX10-21" fmla="*/ 108084 w 234109"/>
                    <a:gd name="connsiteY10-22" fmla="*/ 230827 h 249456"/>
                    <a:gd name="connsiteX11-23" fmla="*/ 41409 w 234109"/>
                    <a:gd name="connsiteY11-24" fmla="*/ 209872 h 249456"/>
                    <a:gd name="connsiteX0-25" fmla="*/ 41409 w 234015"/>
                    <a:gd name="connsiteY0-26" fmla="*/ 209872 h 249456"/>
                    <a:gd name="connsiteX1-27" fmla="*/ 3309 w 234015"/>
                    <a:gd name="connsiteY1-28" fmla="*/ 152722 h 249456"/>
                    <a:gd name="connsiteX2-29" fmla="*/ 5214 w 234015"/>
                    <a:gd name="connsiteY2-30" fmla="*/ 91762 h 249456"/>
                    <a:gd name="connsiteX3-31" fmla="*/ 31884 w 234015"/>
                    <a:gd name="connsiteY3-32" fmla="*/ 40327 h 249456"/>
                    <a:gd name="connsiteX4-33" fmla="*/ 102369 w 234015"/>
                    <a:gd name="connsiteY4-34" fmla="*/ 322 h 249456"/>
                    <a:gd name="connsiteX5-35" fmla="*/ 167139 w 234015"/>
                    <a:gd name="connsiteY5-36" fmla="*/ 23182 h 249456"/>
                    <a:gd name="connsiteX6-37" fmla="*/ 212859 w 234015"/>
                    <a:gd name="connsiteY6-38" fmla="*/ 53662 h 249456"/>
                    <a:gd name="connsiteX7-39" fmla="*/ 233814 w 234015"/>
                    <a:gd name="connsiteY7-40" fmla="*/ 65092 h 249456"/>
                    <a:gd name="connsiteX8-41" fmla="*/ 220479 w 234015"/>
                    <a:gd name="connsiteY8-42" fmla="*/ 236542 h 249456"/>
                    <a:gd name="connsiteX9-43" fmla="*/ 174759 w 234015"/>
                    <a:gd name="connsiteY9-44" fmla="*/ 236542 h 249456"/>
                    <a:gd name="connsiteX10-45" fmla="*/ 108084 w 234015"/>
                    <a:gd name="connsiteY10-46" fmla="*/ 230827 h 249456"/>
                    <a:gd name="connsiteX11-47" fmla="*/ 41409 w 234015"/>
                    <a:gd name="connsiteY11-48" fmla="*/ 209872 h 249456"/>
                    <a:gd name="connsiteX0-49" fmla="*/ 41409 w 235015"/>
                    <a:gd name="connsiteY0-50" fmla="*/ 209872 h 240021"/>
                    <a:gd name="connsiteX1-51" fmla="*/ 3309 w 235015"/>
                    <a:gd name="connsiteY1-52" fmla="*/ 152722 h 240021"/>
                    <a:gd name="connsiteX2-53" fmla="*/ 5214 w 235015"/>
                    <a:gd name="connsiteY2-54" fmla="*/ 91762 h 240021"/>
                    <a:gd name="connsiteX3-55" fmla="*/ 31884 w 235015"/>
                    <a:gd name="connsiteY3-56" fmla="*/ 40327 h 240021"/>
                    <a:gd name="connsiteX4-57" fmla="*/ 102369 w 235015"/>
                    <a:gd name="connsiteY4-58" fmla="*/ 322 h 240021"/>
                    <a:gd name="connsiteX5-59" fmla="*/ 167139 w 235015"/>
                    <a:gd name="connsiteY5-60" fmla="*/ 23182 h 240021"/>
                    <a:gd name="connsiteX6-61" fmla="*/ 212859 w 235015"/>
                    <a:gd name="connsiteY6-62" fmla="*/ 53662 h 240021"/>
                    <a:gd name="connsiteX7-63" fmla="*/ 233814 w 235015"/>
                    <a:gd name="connsiteY7-64" fmla="*/ 65092 h 240021"/>
                    <a:gd name="connsiteX8-65" fmla="*/ 226194 w 235015"/>
                    <a:gd name="connsiteY8-66" fmla="*/ 221302 h 240021"/>
                    <a:gd name="connsiteX9-67" fmla="*/ 174759 w 235015"/>
                    <a:gd name="connsiteY9-68" fmla="*/ 236542 h 240021"/>
                    <a:gd name="connsiteX10-69" fmla="*/ 108084 w 235015"/>
                    <a:gd name="connsiteY10-70" fmla="*/ 230827 h 240021"/>
                    <a:gd name="connsiteX11-71" fmla="*/ 41409 w 235015"/>
                    <a:gd name="connsiteY11-72" fmla="*/ 209872 h 240021"/>
                    <a:gd name="connsiteX0-73" fmla="*/ 41409 w 235015"/>
                    <a:gd name="connsiteY0-74" fmla="*/ 210109 h 240258"/>
                    <a:gd name="connsiteX1-75" fmla="*/ 3309 w 235015"/>
                    <a:gd name="connsiteY1-76" fmla="*/ 152959 h 240258"/>
                    <a:gd name="connsiteX2-77" fmla="*/ 5214 w 235015"/>
                    <a:gd name="connsiteY2-78" fmla="*/ 91999 h 240258"/>
                    <a:gd name="connsiteX3-79" fmla="*/ 31884 w 235015"/>
                    <a:gd name="connsiteY3-80" fmla="*/ 40564 h 240258"/>
                    <a:gd name="connsiteX4-81" fmla="*/ 102369 w 235015"/>
                    <a:gd name="connsiteY4-82" fmla="*/ 559 h 240258"/>
                    <a:gd name="connsiteX5-83" fmla="*/ 159519 w 235015"/>
                    <a:gd name="connsiteY5-84" fmla="*/ 19609 h 240258"/>
                    <a:gd name="connsiteX6-85" fmla="*/ 212859 w 235015"/>
                    <a:gd name="connsiteY6-86" fmla="*/ 53899 h 240258"/>
                    <a:gd name="connsiteX7-87" fmla="*/ 233814 w 235015"/>
                    <a:gd name="connsiteY7-88" fmla="*/ 65329 h 240258"/>
                    <a:gd name="connsiteX8-89" fmla="*/ 226194 w 235015"/>
                    <a:gd name="connsiteY8-90" fmla="*/ 221539 h 240258"/>
                    <a:gd name="connsiteX9-91" fmla="*/ 174759 w 235015"/>
                    <a:gd name="connsiteY9-92" fmla="*/ 236779 h 240258"/>
                    <a:gd name="connsiteX10-93" fmla="*/ 108084 w 235015"/>
                    <a:gd name="connsiteY10-94" fmla="*/ 231064 h 240258"/>
                    <a:gd name="connsiteX11-95" fmla="*/ 41409 w 235015"/>
                    <a:gd name="connsiteY11-96" fmla="*/ 210109 h 240258"/>
                  </a:gdLst>
                  <a:ahLst/>
                  <a:cxnLst>
                    <a:cxn ang="0">
                      <a:pos x="connsiteX0-1" y="connsiteY0-2"/>
                    </a:cxn>
                    <a:cxn ang="0">
                      <a:pos x="connsiteX1-3" y="connsiteY1-4"/>
                    </a:cxn>
                    <a:cxn ang="0">
                      <a:pos x="connsiteX2-5" y="connsiteY2-6"/>
                    </a:cxn>
                    <a:cxn ang="0">
                      <a:pos x="connsiteX3-7" y="connsiteY3-8"/>
                    </a:cxn>
                    <a:cxn ang="0">
                      <a:pos x="connsiteX4-9" y="connsiteY4-10"/>
                    </a:cxn>
                    <a:cxn ang="0">
                      <a:pos x="connsiteX5-11" y="connsiteY5-12"/>
                    </a:cxn>
                    <a:cxn ang="0">
                      <a:pos x="connsiteX6-13" y="connsiteY6-14"/>
                    </a:cxn>
                    <a:cxn ang="0">
                      <a:pos x="connsiteX7-15" y="connsiteY7-16"/>
                    </a:cxn>
                    <a:cxn ang="0">
                      <a:pos x="connsiteX8-17" y="connsiteY8-18"/>
                    </a:cxn>
                    <a:cxn ang="0">
                      <a:pos x="connsiteX9-19" y="connsiteY9-20"/>
                    </a:cxn>
                    <a:cxn ang="0">
                      <a:pos x="connsiteX10-21" y="connsiteY10-22"/>
                    </a:cxn>
                    <a:cxn ang="0">
                      <a:pos x="connsiteX11-23" y="connsiteY11-24"/>
                    </a:cxn>
                  </a:cxnLst>
                  <a:rect l="l" t="t" r="r" b="b"/>
                  <a:pathLst>
                    <a:path w="235015" h="240258">
                      <a:moveTo>
                        <a:pt x="41409" y="210109"/>
                      </a:moveTo>
                      <a:cubicBezTo>
                        <a:pt x="23946" y="197091"/>
                        <a:pt x="9341" y="172644"/>
                        <a:pt x="3309" y="152959"/>
                      </a:cubicBezTo>
                      <a:cubicBezTo>
                        <a:pt x="-2724" y="133274"/>
                        <a:pt x="451" y="110731"/>
                        <a:pt x="5214" y="91999"/>
                      </a:cubicBezTo>
                      <a:cubicBezTo>
                        <a:pt x="9976" y="73266"/>
                        <a:pt x="15691" y="55804"/>
                        <a:pt x="31884" y="40564"/>
                      </a:cubicBezTo>
                      <a:cubicBezTo>
                        <a:pt x="48077" y="25324"/>
                        <a:pt x="81097" y="4051"/>
                        <a:pt x="102369" y="559"/>
                      </a:cubicBezTo>
                      <a:cubicBezTo>
                        <a:pt x="123641" y="-2933"/>
                        <a:pt x="141104" y="10719"/>
                        <a:pt x="159519" y="19609"/>
                      </a:cubicBezTo>
                      <a:cubicBezTo>
                        <a:pt x="177934" y="28499"/>
                        <a:pt x="200477" y="46279"/>
                        <a:pt x="212859" y="53899"/>
                      </a:cubicBezTo>
                      <a:cubicBezTo>
                        <a:pt x="225241" y="61519"/>
                        <a:pt x="231592" y="37389"/>
                        <a:pt x="233814" y="65329"/>
                      </a:cubicBezTo>
                      <a:cubicBezTo>
                        <a:pt x="236037" y="93269"/>
                        <a:pt x="236036" y="192964"/>
                        <a:pt x="226194" y="221539"/>
                      </a:cubicBezTo>
                      <a:cubicBezTo>
                        <a:pt x="216352" y="250114"/>
                        <a:pt x="193491" y="237731"/>
                        <a:pt x="174759" y="236779"/>
                      </a:cubicBezTo>
                      <a:cubicBezTo>
                        <a:pt x="156027" y="235827"/>
                        <a:pt x="130309" y="235509"/>
                        <a:pt x="108084" y="231064"/>
                      </a:cubicBezTo>
                      <a:cubicBezTo>
                        <a:pt x="85859" y="226619"/>
                        <a:pt x="58872" y="223127"/>
                        <a:pt x="41409" y="210109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6" name="任意多边形: 形状 245"/>
                <p:cNvSpPr/>
                <p:nvPr/>
              </p:nvSpPr>
              <p:spPr>
                <a:xfrm>
                  <a:off x="1358171" y="3940476"/>
                  <a:ext cx="156766" cy="170219"/>
                </a:xfrm>
                <a:custGeom>
                  <a:avLst/>
                  <a:gdLst>
                    <a:gd name="connsiteX0" fmla="*/ 97250 w 156766"/>
                    <a:gd name="connsiteY0" fmla="*/ 176072 h 188001"/>
                    <a:gd name="connsiteX1" fmla="*/ 22955 w 156766"/>
                    <a:gd name="connsiteY1" fmla="*/ 128447 h 188001"/>
                    <a:gd name="connsiteX2" fmla="*/ 2000 w 156766"/>
                    <a:gd name="connsiteY2" fmla="*/ 71297 h 188001"/>
                    <a:gd name="connsiteX3" fmla="*/ 5810 w 156766"/>
                    <a:gd name="connsiteY3" fmla="*/ 31292 h 188001"/>
                    <a:gd name="connsiteX4" fmla="*/ 45815 w 156766"/>
                    <a:gd name="connsiteY4" fmla="*/ 2717 h 188001"/>
                    <a:gd name="connsiteX5" fmla="*/ 95345 w 156766"/>
                    <a:gd name="connsiteY5" fmla="*/ 4622 h 188001"/>
                    <a:gd name="connsiteX6" fmla="*/ 137255 w 156766"/>
                    <a:gd name="connsiteY6" fmla="*/ 33197 h 188001"/>
                    <a:gd name="connsiteX7" fmla="*/ 146780 w 156766"/>
                    <a:gd name="connsiteY7" fmla="*/ 67487 h 188001"/>
                    <a:gd name="connsiteX8" fmla="*/ 156305 w 156766"/>
                    <a:gd name="connsiteY8" fmla="*/ 99872 h 188001"/>
                    <a:gd name="connsiteX9" fmla="*/ 154400 w 156766"/>
                    <a:gd name="connsiteY9" fmla="*/ 164642 h 188001"/>
                    <a:gd name="connsiteX10" fmla="*/ 146780 w 156766"/>
                    <a:gd name="connsiteY10" fmla="*/ 187502 h 188001"/>
                    <a:gd name="connsiteX11" fmla="*/ 97250 w 156766"/>
                    <a:gd name="connsiteY11" fmla="*/ 176072 h 188001"/>
                    <a:gd name="connsiteX0-1" fmla="*/ 97250 w 156766"/>
                    <a:gd name="connsiteY0-2" fmla="*/ 176072 h 177045"/>
                    <a:gd name="connsiteX1-3" fmla="*/ 22955 w 156766"/>
                    <a:gd name="connsiteY1-4" fmla="*/ 128447 h 177045"/>
                    <a:gd name="connsiteX2-5" fmla="*/ 2000 w 156766"/>
                    <a:gd name="connsiteY2-6" fmla="*/ 71297 h 177045"/>
                    <a:gd name="connsiteX3-7" fmla="*/ 5810 w 156766"/>
                    <a:gd name="connsiteY3-8" fmla="*/ 31292 h 177045"/>
                    <a:gd name="connsiteX4-9" fmla="*/ 45815 w 156766"/>
                    <a:gd name="connsiteY4-10" fmla="*/ 2717 h 177045"/>
                    <a:gd name="connsiteX5-11" fmla="*/ 95345 w 156766"/>
                    <a:gd name="connsiteY5-12" fmla="*/ 4622 h 177045"/>
                    <a:gd name="connsiteX6-13" fmla="*/ 137255 w 156766"/>
                    <a:gd name="connsiteY6-14" fmla="*/ 33197 h 177045"/>
                    <a:gd name="connsiteX7-15" fmla="*/ 146780 w 156766"/>
                    <a:gd name="connsiteY7-16" fmla="*/ 67487 h 177045"/>
                    <a:gd name="connsiteX8-17" fmla="*/ 156305 w 156766"/>
                    <a:gd name="connsiteY8-18" fmla="*/ 99872 h 177045"/>
                    <a:gd name="connsiteX9-19" fmla="*/ 154400 w 156766"/>
                    <a:gd name="connsiteY9-20" fmla="*/ 164642 h 177045"/>
                    <a:gd name="connsiteX10-21" fmla="*/ 150590 w 156766"/>
                    <a:gd name="connsiteY10-22" fmla="*/ 160832 h 177045"/>
                    <a:gd name="connsiteX11-23" fmla="*/ 97250 w 156766"/>
                    <a:gd name="connsiteY11-24" fmla="*/ 176072 h 177045"/>
                    <a:gd name="connsiteX0-25" fmla="*/ 89630 w 156766"/>
                    <a:gd name="connsiteY0-26" fmla="*/ 166547 h 170219"/>
                    <a:gd name="connsiteX1-27" fmla="*/ 22955 w 156766"/>
                    <a:gd name="connsiteY1-28" fmla="*/ 128447 h 170219"/>
                    <a:gd name="connsiteX2-29" fmla="*/ 2000 w 156766"/>
                    <a:gd name="connsiteY2-30" fmla="*/ 71297 h 170219"/>
                    <a:gd name="connsiteX3-31" fmla="*/ 5810 w 156766"/>
                    <a:gd name="connsiteY3-32" fmla="*/ 31292 h 170219"/>
                    <a:gd name="connsiteX4-33" fmla="*/ 45815 w 156766"/>
                    <a:gd name="connsiteY4-34" fmla="*/ 2717 h 170219"/>
                    <a:gd name="connsiteX5-35" fmla="*/ 95345 w 156766"/>
                    <a:gd name="connsiteY5-36" fmla="*/ 4622 h 170219"/>
                    <a:gd name="connsiteX6-37" fmla="*/ 137255 w 156766"/>
                    <a:gd name="connsiteY6-38" fmla="*/ 33197 h 170219"/>
                    <a:gd name="connsiteX7-39" fmla="*/ 146780 w 156766"/>
                    <a:gd name="connsiteY7-40" fmla="*/ 67487 h 170219"/>
                    <a:gd name="connsiteX8-41" fmla="*/ 156305 w 156766"/>
                    <a:gd name="connsiteY8-42" fmla="*/ 99872 h 170219"/>
                    <a:gd name="connsiteX9-43" fmla="*/ 154400 w 156766"/>
                    <a:gd name="connsiteY9-44" fmla="*/ 164642 h 170219"/>
                    <a:gd name="connsiteX10-45" fmla="*/ 150590 w 156766"/>
                    <a:gd name="connsiteY10-46" fmla="*/ 160832 h 170219"/>
                    <a:gd name="connsiteX11-47" fmla="*/ 89630 w 156766"/>
                    <a:gd name="connsiteY11-48" fmla="*/ 166547 h 170219"/>
                  </a:gdLst>
                  <a:ahLst/>
                  <a:cxnLst>
                    <a:cxn ang="0">
                      <a:pos x="connsiteX0-1" y="connsiteY0-2"/>
                    </a:cxn>
                    <a:cxn ang="0">
                      <a:pos x="connsiteX1-3" y="connsiteY1-4"/>
                    </a:cxn>
                    <a:cxn ang="0">
                      <a:pos x="connsiteX2-5" y="connsiteY2-6"/>
                    </a:cxn>
                    <a:cxn ang="0">
                      <a:pos x="connsiteX3-7" y="connsiteY3-8"/>
                    </a:cxn>
                    <a:cxn ang="0">
                      <a:pos x="connsiteX4-9" y="connsiteY4-10"/>
                    </a:cxn>
                    <a:cxn ang="0">
                      <a:pos x="connsiteX5-11" y="connsiteY5-12"/>
                    </a:cxn>
                    <a:cxn ang="0">
                      <a:pos x="connsiteX6-13" y="connsiteY6-14"/>
                    </a:cxn>
                    <a:cxn ang="0">
                      <a:pos x="connsiteX7-15" y="connsiteY7-16"/>
                    </a:cxn>
                    <a:cxn ang="0">
                      <a:pos x="connsiteX8-17" y="connsiteY8-18"/>
                    </a:cxn>
                    <a:cxn ang="0">
                      <a:pos x="connsiteX9-19" y="connsiteY9-20"/>
                    </a:cxn>
                    <a:cxn ang="0">
                      <a:pos x="connsiteX10-21" y="connsiteY10-22"/>
                    </a:cxn>
                    <a:cxn ang="0">
                      <a:pos x="connsiteX11-23" y="connsiteY11-24"/>
                    </a:cxn>
                  </a:cxnLst>
                  <a:rect l="l" t="t" r="r" b="b"/>
                  <a:pathLst>
                    <a:path w="156766" h="170219">
                      <a:moveTo>
                        <a:pt x="89630" y="166547"/>
                      </a:moveTo>
                      <a:cubicBezTo>
                        <a:pt x="68358" y="161150"/>
                        <a:pt x="37560" y="144322"/>
                        <a:pt x="22955" y="128447"/>
                      </a:cubicBezTo>
                      <a:cubicBezTo>
                        <a:pt x="8350" y="112572"/>
                        <a:pt x="4857" y="87489"/>
                        <a:pt x="2000" y="71297"/>
                      </a:cubicBezTo>
                      <a:cubicBezTo>
                        <a:pt x="-857" y="55105"/>
                        <a:pt x="-1493" y="42722"/>
                        <a:pt x="5810" y="31292"/>
                      </a:cubicBezTo>
                      <a:cubicBezTo>
                        <a:pt x="13112" y="19862"/>
                        <a:pt x="30893" y="7162"/>
                        <a:pt x="45815" y="2717"/>
                      </a:cubicBezTo>
                      <a:cubicBezTo>
                        <a:pt x="60737" y="-1728"/>
                        <a:pt x="80105" y="-458"/>
                        <a:pt x="95345" y="4622"/>
                      </a:cubicBezTo>
                      <a:cubicBezTo>
                        <a:pt x="110585" y="9702"/>
                        <a:pt x="128683" y="22720"/>
                        <a:pt x="137255" y="33197"/>
                      </a:cubicBezTo>
                      <a:cubicBezTo>
                        <a:pt x="145827" y="43674"/>
                        <a:pt x="143605" y="56374"/>
                        <a:pt x="146780" y="67487"/>
                      </a:cubicBezTo>
                      <a:cubicBezTo>
                        <a:pt x="149955" y="78600"/>
                        <a:pt x="155035" y="83679"/>
                        <a:pt x="156305" y="99872"/>
                      </a:cubicBezTo>
                      <a:cubicBezTo>
                        <a:pt x="157575" y="116064"/>
                        <a:pt x="155987" y="150037"/>
                        <a:pt x="154400" y="164642"/>
                      </a:cubicBezTo>
                      <a:cubicBezTo>
                        <a:pt x="152813" y="179247"/>
                        <a:pt x="161385" y="160515"/>
                        <a:pt x="150590" y="160832"/>
                      </a:cubicBezTo>
                      <a:cubicBezTo>
                        <a:pt x="139795" y="161150"/>
                        <a:pt x="110903" y="171945"/>
                        <a:pt x="89630" y="166547"/>
                      </a:cubicBezTo>
                      <a:close/>
                    </a:path>
                  </a:pathLst>
                </a:custGeom>
                <a:noFill/>
                <a:ln w="9525">
                  <a:noFill/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47" name="直接连接符 246"/>
                <p:cNvCxnSpPr/>
                <p:nvPr/>
              </p:nvCxnSpPr>
              <p:spPr>
                <a:xfrm>
                  <a:off x="1508760" y="3591203"/>
                  <a:ext cx="0" cy="561697"/>
                </a:xfrm>
                <a:prstGeom prst="line">
                  <a:avLst/>
                </a:prstGeom>
                <a:ln w="28575">
                  <a:noFill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8" name="直接连接符 247"/>
                <p:cNvCxnSpPr/>
                <p:nvPr/>
              </p:nvCxnSpPr>
              <p:spPr>
                <a:xfrm>
                  <a:off x="2590442" y="3603546"/>
                  <a:ext cx="0" cy="566280"/>
                </a:xfrm>
                <a:prstGeom prst="line">
                  <a:avLst/>
                </a:prstGeom>
                <a:ln w="28575">
                  <a:noFill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9" name="直接连接符 248"/>
                <p:cNvCxnSpPr/>
                <p:nvPr/>
              </p:nvCxnSpPr>
              <p:spPr>
                <a:xfrm>
                  <a:off x="3671410" y="3603546"/>
                  <a:ext cx="0" cy="561697"/>
                </a:xfrm>
                <a:prstGeom prst="line">
                  <a:avLst/>
                </a:prstGeom>
                <a:ln w="12700">
                  <a:noFill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23" name="直接连接符 222"/>
              <p:cNvCxnSpPr/>
              <p:nvPr/>
            </p:nvCxnSpPr>
            <p:spPr>
              <a:xfrm>
                <a:off x="5791427" y="6062360"/>
                <a:ext cx="648066" cy="612489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直接连接符 223"/>
              <p:cNvCxnSpPr/>
              <p:nvPr/>
            </p:nvCxnSpPr>
            <p:spPr>
              <a:xfrm>
                <a:off x="5791427" y="5920897"/>
                <a:ext cx="632848" cy="450262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直接连接符 224"/>
              <p:cNvCxnSpPr/>
              <p:nvPr/>
            </p:nvCxnSpPr>
            <p:spPr>
              <a:xfrm>
                <a:off x="5805651" y="7252537"/>
                <a:ext cx="648066" cy="53779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直接连接符 225"/>
              <p:cNvCxnSpPr/>
              <p:nvPr/>
            </p:nvCxnSpPr>
            <p:spPr>
              <a:xfrm>
                <a:off x="5835813" y="7132993"/>
                <a:ext cx="603680" cy="325456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0" name="文本框 219"/>
            <p:cNvSpPr txBox="1"/>
            <p:nvPr/>
          </p:nvSpPr>
          <p:spPr>
            <a:xfrm>
              <a:off x="419289" y="4414443"/>
              <a:ext cx="238282" cy="1232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l-GR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CN" altLang="en-US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直接连接符 220"/>
            <p:cNvCxnSpPr/>
            <p:nvPr/>
          </p:nvCxnSpPr>
          <p:spPr>
            <a:xfrm>
              <a:off x="464535" y="4507250"/>
              <a:ext cx="15796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6" name="组合 255"/>
          <p:cNvGrpSpPr/>
          <p:nvPr/>
        </p:nvGrpSpPr>
        <p:grpSpPr>
          <a:xfrm>
            <a:off x="3048321" y="5402870"/>
            <a:ext cx="1705353" cy="1809167"/>
            <a:chOff x="3038097" y="3261271"/>
            <a:chExt cx="1705353" cy="1809167"/>
          </a:xfrm>
        </p:grpSpPr>
        <p:grpSp>
          <p:nvGrpSpPr>
            <p:cNvPr id="257" name="组合 256"/>
            <p:cNvGrpSpPr/>
            <p:nvPr/>
          </p:nvGrpSpPr>
          <p:grpSpPr>
            <a:xfrm>
              <a:off x="3124093" y="3367120"/>
              <a:ext cx="1619357" cy="1703318"/>
              <a:chOff x="3050433" y="3329375"/>
              <a:chExt cx="1619357" cy="1703318"/>
            </a:xfrm>
          </p:grpSpPr>
          <p:graphicFrame>
            <p:nvGraphicFramePr>
              <p:cNvPr id="259" name="对象 258"/>
              <p:cNvGraphicFramePr>
                <a:graphicFrameLocks noChangeAspect="1"/>
              </p:cNvGraphicFramePr>
              <p:nvPr/>
            </p:nvGraphicFramePr>
            <p:xfrm>
              <a:off x="3396615" y="3397568"/>
              <a:ext cx="1273175" cy="16351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37" name="Prism 7" r:id="rId31" imgW="1280160" imgH="1645920" progId="Prism7.Document">
                      <p:embed/>
                    </p:oleObj>
                  </mc:Choice>
                  <mc:Fallback>
                    <p:oleObj name="Prism 7" r:id="rId31" imgW="1280160" imgH="1645920" progId="Prism7.Document">
                      <p:embed/>
                      <p:pic>
                        <p:nvPicPr>
                          <p:cNvPr id="0" name="对象 258"/>
                          <p:cNvPicPr/>
                          <p:nvPr/>
                        </p:nvPicPr>
                        <p:blipFill>
                          <a:blip r:embed="rId32"/>
                          <a:stretch>
                            <a:fillRect/>
                          </a:stretch>
                        </p:blipFill>
                        <p:spPr>
                          <a:xfrm>
                            <a:off x="3396615" y="3397568"/>
                            <a:ext cx="1273175" cy="16351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60" name="文本框 259"/>
              <p:cNvSpPr txBox="1"/>
              <p:nvPr/>
            </p:nvSpPr>
            <p:spPr>
              <a:xfrm rot="16200000">
                <a:off x="2530314" y="3961875"/>
                <a:ext cx="1455736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luorescence of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erroOrange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colocalizing 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with LysoTracker</a:t>
                </a:r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）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文本框 260"/>
              <p:cNvSpPr txBox="1"/>
              <p:nvPr/>
            </p:nvSpPr>
            <p:spPr>
              <a:xfrm>
                <a:off x="3999028" y="3513855"/>
                <a:ext cx="37701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2" name="组合 261"/>
              <p:cNvGrpSpPr/>
              <p:nvPr/>
            </p:nvGrpSpPr>
            <p:grpSpPr>
              <a:xfrm>
                <a:off x="3969930" y="3643088"/>
                <a:ext cx="348856" cy="45719"/>
                <a:chOff x="5949207" y="2323506"/>
                <a:chExt cx="159269" cy="36000"/>
              </a:xfrm>
            </p:grpSpPr>
            <p:cxnSp>
              <p:nvCxnSpPr>
                <p:cNvPr id="270" name="直接连接符 269"/>
                <p:cNvCxnSpPr/>
                <p:nvPr/>
              </p:nvCxnSpPr>
              <p:spPr>
                <a:xfrm flipV="1">
                  <a:off x="5949294" y="2323617"/>
                  <a:ext cx="158400" cy="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71" name="直接连接符 270"/>
                <p:cNvCxnSpPr/>
                <p:nvPr/>
              </p:nvCxnSpPr>
              <p:spPr>
                <a:xfrm flipV="1">
                  <a:off x="6108476" y="2323506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72" name="直接连接符 271"/>
                <p:cNvCxnSpPr/>
                <p:nvPr/>
              </p:nvCxnSpPr>
              <p:spPr>
                <a:xfrm flipV="1">
                  <a:off x="5949207" y="2323506"/>
                  <a:ext cx="0" cy="36000"/>
                </a:xfrm>
                <a:prstGeom prst="line">
                  <a:avLst/>
                </a:prstGeom>
                <a:ln w="31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63" name="组合 262"/>
              <p:cNvGrpSpPr/>
              <p:nvPr/>
            </p:nvGrpSpPr>
            <p:grpSpPr>
              <a:xfrm>
                <a:off x="3853263" y="3329375"/>
                <a:ext cx="683097" cy="200055"/>
                <a:chOff x="2537139" y="3321135"/>
                <a:chExt cx="683097" cy="200055"/>
              </a:xfrm>
            </p:grpSpPr>
            <p:grpSp>
              <p:nvGrpSpPr>
                <p:cNvPr id="264" name="组合 263"/>
                <p:cNvGrpSpPr/>
                <p:nvPr/>
              </p:nvGrpSpPr>
              <p:grpSpPr>
                <a:xfrm rot="5400000">
                  <a:off x="2865152" y="3166106"/>
                  <a:ext cx="200055" cy="510113"/>
                  <a:chOff x="5781730" y="3926113"/>
                  <a:chExt cx="199545" cy="508827"/>
                </a:xfrm>
              </p:grpSpPr>
              <p:sp>
                <p:nvSpPr>
                  <p:cNvPr id="268" name="文本框 267"/>
                  <p:cNvSpPr txBox="1"/>
                  <p:nvPr/>
                </p:nvSpPr>
                <p:spPr>
                  <a:xfrm rot="16200000">
                    <a:off x="5629506" y="4078337"/>
                    <a:ext cx="503993" cy="19954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 mg/ml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9" name="矩形 268"/>
                  <p:cNvSpPr/>
                  <p:nvPr/>
                </p:nvSpPr>
                <p:spPr>
                  <a:xfrm>
                    <a:off x="5871801" y="4380053"/>
                    <a:ext cx="45602" cy="54887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65" name="组合 264"/>
                <p:cNvGrpSpPr/>
                <p:nvPr/>
              </p:nvGrpSpPr>
              <p:grpSpPr>
                <a:xfrm rot="5400000">
                  <a:off x="2556714" y="3301560"/>
                  <a:ext cx="200055" cy="239205"/>
                  <a:chOff x="5781730" y="4196338"/>
                  <a:chExt cx="199545" cy="238602"/>
                </a:xfrm>
              </p:grpSpPr>
              <p:sp>
                <p:nvSpPr>
                  <p:cNvPr id="266" name="文本框 265"/>
                  <p:cNvSpPr txBox="1"/>
                  <p:nvPr/>
                </p:nvSpPr>
                <p:spPr>
                  <a:xfrm rot="16200000">
                    <a:off x="5764618" y="4213450"/>
                    <a:ext cx="233769" cy="19954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7" name="矩形 266"/>
                  <p:cNvSpPr/>
                  <p:nvPr/>
                </p:nvSpPr>
                <p:spPr>
                  <a:xfrm>
                    <a:off x="5871801" y="4380053"/>
                    <a:ext cx="45602" cy="54887"/>
                  </a:xfrm>
                  <a:prstGeom prst="rect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258" name="文本框 257"/>
            <p:cNvSpPr txBox="1"/>
            <p:nvPr/>
          </p:nvSpPr>
          <p:spPr>
            <a:xfrm>
              <a:off x="3038097" y="3261271"/>
              <a:ext cx="1847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3" name="文本框 272"/>
          <p:cNvSpPr txBox="1"/>
          <p:nvPr/>
        </p:nvSpPr>
        <p:spPr>
          <a:xfrm>
            <a:off x="3149756" y="5293487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文本框 273"/>
          <p:cNvSpPr txBox="1"/>
          <p:nvPr/>
        </p:nvSpPr>
        <p:spPr>
          <a:xfrm>
            <a:off x="168008" y="5293487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5" name="组合 274"/>
          <p:cNvGrpSpPr/>
          <p:nvPr/>
        </p:nvGrpSpPr>
        <p:grpSpPr>
          <a:xfrm>
            <a:off x="4807407" y="5328843"/>
            <a:ext cx="1777684" cy="1690831"/>
            <a:chOff x="4783454" y="3164100"/>
            <a:chExt cx="1777684" cy="1690831"/>
          </a:xfrm>
        </p:grpSpPr>
        <p:grpSp>
          <p:nvGrpSpPr>
            <p:cNvPr id="276" name="组合 275"/>
            <p:cNvGrpSpPr/>
            <p:nvPr/>
          </p:nvGrpSpPr>
          <p:grpSpPr>
            <a:xfrm>
              <a:off x="4788160" y="3164100"/>
              <a:ext cx="1772978" cy="908407"/>
              <a:chOff x="4876075" y="3446512"/>
              <a:chExt cx="1772978" cy="999248"/>
            </a:xfrm>
          </p:grpSpPr>
          <p:grpSp>
            <p:nvGrpSpPr>
              <p:cNvPr id="298" name="组合 297"/>
              <p:cNvGrpSpPr/>
              <p:nvPr/>
            </p:nvGrpSpPr>
            <p:grpSpPr>
              <a:xfrm>
                <a:off x="6291263" y="3573394"/>
                <a:ext cx="357790" cy="809753"/>
                <a:chOff x="6291263" y="3573394"/>
                <a:chExt cx="357790" cy="809753"/>
              </a:xfrm>
            </p:grpSpPr>
            <p:grpSp>
              <p:nvGrpSpPr>
                <p:cNvPr id="310" name="组合 309"/>
                <p:cNvGrpSpPr/>
                <p:nvPr/>
              </p:nvGrpSpPr>
              <p:grpSpPr>
                <a:xfrm>
                  <a:off x="6310293" y="3717822"/>
                  <a:ext cx="296281" cy="665325"/>
                  <a:chOff x="6310293" y="3717822"/>
                  <a:chExt cx="296281" cy="665325"/>
                </a:xfrm>
              </p:grpSpPr>
              <p:cxnSp>
                <p:nvCxnSpPr>
                  <p:cNvPr id="312" name="直接连接符 311"/>
                  <p:cNvCxnSpPr/>
                  <p:nvPr/>
                </p:nvCxnSpPr>
                <p:spPr>
                  <a:xfrm>
                    <a:off x="6321318" y="4250333"/>
                    <a:ext cx="7587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3" name="直接连接符 312"/>
                  <p:cNvCxnSpPr/>
                  <p:nvPr/>
                </p:nvCxnSpPr>
                <p:spPr>
                  <a:xfrm>
                    <a:off x="6314478" y="4064913"/>
                    <a:ext cx="7587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4" name="直接连接符 313"/>
                  <p:cNvCxnSpPr/>
                  <p:nvPr/>
                </p:nvCxnSpPr>
                <p:spPr>
                  <a:xfrm>
                    <a:off x="6310293" y="3829935"/>
                    <a:ext cx="7587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5" name="文本框 314"/>
                  <p:cNvSpPr txBox="1"/>
                  <p:nvPr/>
                </p:nvSpPr>
                <p:spPr>
                  <a:xfrm>
                    <a:off x="6322521" y="3953909"/>
                    <a:ext cx="284053" cy="22006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1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6" name="文本框 315"/>
                  <p:cNvSpPr txBox="1"/>
                  <p:nvPr/>
                </p:nvSpPr>
                <p:spPr>
                  <a:xfrm>
                    <a:off x="6314600" y="3717822"/>
                    <a:ext cx="284053" cy="22006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0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7" name="文本框 316"/>
                  <p:cNvSpPr txBox="1"/>
                  <p:nvPr/>
                </p:nvSpPr>
                <p:spPr>
                  <a:xfrm>
                    <a:off x="6318237" y="4163087"/>
                    <a:ext cx="284053" cy="22006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5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11" name="文本框 310"/>
                <p:cNvSpPr txBox="1"/>
                <p:nvPr/>
              </p:nvSpPr>
              <p:spPr>
                <a:xfrm>
                  <a:off x="6291263" y="3573394"/>
                  <a:ext cx="357790" cy="2200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zh-CN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99" name="组合 298"/>
              <p:cNvGrpSpPr/>
              <p:nvPr/>
            </p:nvGrpSpPr>
            <p:grpSpPr>
              <a:xfrm>
                <a:off x="4943350" y="3446512"/>
                <a:ext cx="1435008" cy="999248"/>
                <a:chOff x="2559388" y="2305827"/>
                <a:chExt cx="1736359" cy="1099173"/>
              </a:xfrm>
            </p:grpSpPr>
            <p:pic>
              <p:nvPicPr>
                <p:cNvPr id="303" name="图片 302"/>
                <p:cNvPicPr>
                  <a:picLocks noChangeAspect="1"/>
                </p:cNvPicPr>
                <p:nvPr/>
              </p:nvPicPr>
              <p:blipFill rotWithShape="1">
                <a:blip r:embed="rId33"/>
                <a:srcRect r="3653"/>
                <a:stretch>
                  <a:fillRect/>
                </a:stretch>
              </p:blipFill>
              <p:spPr>
                <a:xfrm>
                  <a:off x="2998797" y="2859375"/>
                  <a:ext cx="1258666" cy="545625"/>
                </a:xfrm>
                <a:prstGeom prst="rect">
                  <a:avLst/>
                </a:prstGeom>
              </p:spPr>
            </p:pic>
            <p:sp>
              <p:nvSpPr>
                <p:cNvPr id="304" name="矩形 303"/>
                <p:cNvSpPr/>
                <p:nvPr/>
              </p:nvSpPr>
              <p:spPr>
                <a:xfrm>
                  <a:off x="3030905" y="2878766"/>
                  <a:ext cx="1226556" cy="21075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5" name="矩形 304"/>
                <p:cNvSpPr/>
                <p:nvPr/>
              </p:nvSpPr>
              <p:spPr>
                <a:xfrm>
                  <a:off x="3030905" y="3141327"/>
                  <a:ext cx="1226556" cy="21075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6" name="文本框 305"/>
                <p:cNvSpPr txBox="1"/>
                <p:nvPr/>
              </p:nvSpPr>
              <p:spPr>
                <a:xfrm>
                  <a:off x="2559388" y="2423336"/>
                  <a:ext cx="1736359" cy="242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uaier</a:t>
                  </a: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0    5   10    0    5   10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7" name="文本框 306"/>
                <p:cNvSpPr txBox="1"/>
                <p:nvPr/>
              </p:nvSpPr>
              <p:spPr>
                <a:xfrm>
                  <a:off x="2603375" y="2305827"/>
                  <a:ext cx="1658774" cy="24206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afA1     -     -    -      +   +    +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308" name="图片 307"/>
                <p:cNvPicPr>
                  <a:picLocks noChangeAspect="1"/>
                </p:cNvPicPr>
                <p:nvPr/>
              </p:nvPicPr>
              <p:blipFill rotWithShape="1">
                <a:blip r:embed="rId34">
                  <a:extLst>
                    <a:ext uri="{BEBA8EAE-BF5A-486C-A8C5-ECC9F3942E4B}">
                      <a14:imgProps xmlns:a14="http://schemas.microsoft.com/office/drawing/2010/main">
                        <a14:imgLayer r:embed="rId35">
                          <a14:imgEffect>
                            <a14:brightnessContrast contrast="20000"/>
                          </a14:imgEffect>
                          <a14:imgEffect>
                            <a14:sharpenSoften amount="36000"/>
                          </a14:imgEffect>
                        </a14:imgLayer>
                      </a14:imgProps>
                    </a:ext>
                  </a:extLst>
                </a:blip>
                <a:srcRect r="1851"/>
                <a:stretch>
                  <a:fillRect/>
                </a:stretch>
              </p:blipFill>
              <p:spPr>
                <a:xfrm>
                  <a:off x="3019365" y="2614858"/>
                  <a:ext cx="1238098" cy="241499"/>
                </a:xfrm>
                <a:prstGeom prst="rect">
                  <a:avLst/>
                </a:prstGeom>
              </p:spPr>
            </p:pic>
            <p:sp>
              <p:nvSpPr>
                <p:cNvPr id="309" name="矩形 308"/>
                <p:cNvSpPr/>
                <p:nvPr/>
              </p:nvSpPr>
              <p:spPr>
                <a:xfrm>
                  <a:off x="3030905" y="2622363"/>
                  <a:ext cx="1226556" cy="21075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00" name="文本框 299"/>
              <p:cNvSpPr txBox="1"/>
              <p:nvPr/>
            </p:nvSpPr>
            <p:spPr>
              <a:xfrm>
                <a:off x="4972601" y="3979542"/>
                <a:ext cx="407484" cy="2200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TH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文本框 300"/>
              <p:cNvSpPr txBox="1"/>
              <p:nvPr/>
            </p:nvSpPr>
            <p:spPr>
              <a:xfrm>
                <a:off x="4916665" y="4190206"/>
                <a:ext cx="455574" cy="2200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文本框 301"/>
              <p:cNvSpPr txBox="1"/>
              <p:nvPr/>
            </p:nvSpPr>
            <p:spPr>
              <a:xfrm>
                <a:off x="4876075" y="3734274"/>
                <a:ext cx="492443" cy="2200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COA4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7" name="组合 276"/>
            <p:cNvGrpSpPr/>
            <p:nvPr/>
          </p:nvGrpSpPr>
          <p:grpSpPr>
            <a:xfrm>
              <a:off x="4783454" y="3978083"/>
              <a:ext cx="1777684" cy="876848"/>
              <a:chOff x="3336937" y="3566253"/>
              <a:chExt cx="1777684" cy="964532"/>
            </a:xfrm>
          </p:grpSpPr>
          <p:grpSp>
            <p:nvGrpSpPr>
              <p:cNvPr id="278" name="组合 277"/>
              <p:cNvGrpSpPr/>
              <p:nvPr/>
            </p:nvGrpSpPr>
            <p:grpSpPr>
              <a:xfrm>
                <a:off x="4756831" y="3685045"/>
                <a:ext cx="357790" cy="809753"/>
                <a:chOff x="6291263" y="3573394"/>
                <a:chExt cx="357790" cy="809753"/>
              </a:xfrm>
            </p:grpSpPr>
            <p:grpSp>
              <p:nvGrpSpPr>
                <p:cNvPr id="290" name="组合 289"/>
                <p:cNvGrpSpPr/>
                <p:nvPr/>
              </p:nvGrpSpPr>
              <p:grpSpPr>
                <a:xfrm>
                  <a:off x="6310293" y="3717822"/>
                  <a:ext cx="296281" cy="665325"/>
                  <a:chOff x="6310293" y="3717822"/>
                  <a:chExt cx="296281" cy="665325"/>
                </a:xfrm>
              </p:grpSpPr>
              <p:cxnSp>
                <p:nvCxnSpPr>
                  <p:cNvPr id="292" name="直接连接符 291"/>
                  <p:cNvCxnSpPr/>
                  <p:nvPr/>
                </p:nvCxnSpPr>
                <p:spPr>
                  <a:xfrm>
                    <a:off x="6321318" y="4250333"/>
                    <a:ext cx="7587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3" name="直接连接符 292"/>
                  <p:cNvCxnSpPr/>
                  <p:nvPr/>
                </p:nvCxnSpPr>
                <p:spPr>
                  <a:xfrm>
                    <a:off x="6314478" y="4064913"/>
                    <a:ext cx="7587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4" name="直接连接符 293"/>
                  <p:cNvCxnSpPr/>
                  <p:nvPr/>
                </p:nvCxnSpPr>
                <p:spPr>
                  <a:xfrm>
                    <a:off x="6310293" y="3829935"/>
                    <a:ext cx="7587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95" name="文本框 294"/>
                  <p:cNvSpPr txBox="1"/>
                  <p:nvPr/>
                </p:nvSpPr>
                <p:spPr>
                  <a:xfrm>
                    <a:off x="6322521" y="3953909"/>
                    <a:ext cx="284053" cy="22006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1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6" name="文本框 295"/>
                  <p:cNvSpPr txBox="1"/>
                  <p:nvPr/>
                </p:nvSpPr>
                <p:spPr>
                  <a:xfrm>
                    <a:off x="6314600" y="3717822"/>
                    <a:ext cx="284053" cy="22006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0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7" name="文本框 296"/>
                  <p:cNvSpPr txBox="1"/>
                  <p:nvPr/>
                </p:nvSpPr>
                <p:spPr>
                  <a:xfrm>
                    <a:off x="6318237" y="4163087"/>
                    <a:ext cx="284053" cy="22006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zh-CN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5</a:t>
                    </a:r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91" name="文本框 290"/>
                <p:cNvSpPr txBox="1"/>
                <p:nvPr/>
              </p:nvSpPr>
              <p:spPr>
                <a:xfrm>
                  <a:off x="6291263" y="3573394"/>
                  <a:ext cx="357790" cy="2200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zh-CN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9" name="组合 278"/>
              <p:cNvGrpSpPr/>
              <p:nvPr/>
            </p:nvGrpSpPr>
            <p:grpSpPr>
              <a:xfrm>
                <a:off x="3336937" y="3566253"/>
                <a:ext cx="1571980" cy="964532"/>
                <a:chOff x="485271" y="4470227"/>
                <a:chExt cx="1902097" cy="1060985"/>
              </a:xfrm>
            </p:grpSpPr>
            <p:pic>
              <p:nvPicPr>
                <p:cNvPr id="280" name="图片 279"/>
                <p:cNvPicPr>
                  <a:picLocks noChangeAspect="1"/>
                </p:cNvPicPr>
                <p:nvPr/>
              </p:nvPicPr>
              <p:blipFill rotWithShape="1">
                <a:blip r:embed="rId36">
                  <a:extLst>
                    <a:ext uri="{BEBA8EAE-BF5A-486C-A8C5-ECC9F3942E4B}">
                      <a14:imgProps xmlns:a14="http://schemas.microsoft.com/office/drawing/2010/main">
                        <a14:imgLayer r:embed="rId37">
                          <a14:imgEffect>
                            <a14:brightnessContrast contrast="20000"/>
                          </a14:imgEffect>
                          <a14:imgEffect>
                            <a14:sharpenSoften amount="36000"/>
                          </a14:imgEffect>
                        </a14:imgLayer>
                      </a14:imgProps>
                    </a:ext>
                  </a:extLst>
                </a:blip>
                <a:srcRect l="1" r="3240"/>
                <a:stretch>
                  <a:fillRect/>
                </a:stretch>
              </p:blipFill>
              <p:spPr>
                <a:xfrm>
                  <a:off x="1028897" y="4737096"/>
                  <a:ext cx="1246965" cy="270355"/>
                </a:xfrm>
                <a:prstGeom prst="rect">
                  <a:avLst/>
                </a:prstGeom>
              </p:spPr>
            </p:pic>
            <p:pic>
              <p:nvPicPr>
                <p:cNvPr id="281" name="图片 280"/>
                <p:cNvPicPr>
                  <a:picLocks noChangeAspect="1"/>
                </p:cNvPicPr>
                <p:nvPr/>
              </p:nvPicPr>
              <p:blipFill rotWithShape="1">
                <a:blip r:embed="rId38"/>
                <a:srcRect r="3915"/>
                <a:stretch>
                  <a:fillRect/>
                </a:stretch>
              </p:blipFill>
              <p:spPr>
                <a:xfrm>
                  <a:off x="1020611" y="4982836"/>
                  <a:ext cx="1255251" cy="545626"/>
                </a:xfrm>
                <a:prstGeom prst="rect">
                  <a:avLst/>
                </a:prstGeom>
              </p:spPr>
            </p:pic>
            <p:sp>
              <p:nvSpPr>
                <p:cNvPr id="282" name="文本框 281"/>
                <p:cNvSpPr txBox="1"/>
                <p:nvPr/>
              </p:nvSpPr>
              <p:spPr>
                <a:xfrm>
                  <a:off x="552084" y="4581937"/>
                  <a:ext cx="1835284" cy="2420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uaier</a:t>
                  </a: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0    5    10   0    5   10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3" name="文本框 282"/>
                <p:cNvSpPr txBox="1"/>
                <p:nvPr/>
              </p:nvSpPr>
              <p:spPr>
                <a:xfrm>
                  <a:off x="605422" y="5045124"/>
                  <a:ext cx="493056" cy="2420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TH1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4" name="文本框 283"/>
                <p:cNvSpPr txBox="1"/>
                <p:nvPr/>
              </p:nvSpPr>
              <p:spPr>
                <a:xfrm>
                  <a:off x="537739" y="5289146"/>
                  <a:ext cx="551245" cy="2420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actin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5" name="文本框 284"/>
                <p:cNvSpPr txBox="1"/>
                <p:nvPr/>
              </p:nvSpPr>
              <p:spPr>
                <a:xfrm>
                  <a:off x="485271" y="4470227"/>
                  <a:ext cx="1779033" cy="2420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3-MA       -     -     -     +    +   +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6" name="矩形 285"/>
                <p:cNvSpPr/>
                <p:nvPr/>
              </p:nvSpPr>
              <p:spPr>
                <a:xfrm>
                  <a:off x="1049305" y="5035687"/>
                  <a:ext cx="1226556" cy="21075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7" name="矩形 286"/>
                <p:cNvSpPr/>
                <p:nvPr/>
              </p:nvSpPr>
              <p:spPr>
                <a:xfrm>
                  <a:off x="1049305" y="5298251"/>
                  <a:ext cx="1226556" cy="21075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8" name="矩形 287"/>
                <p:cNvSpPr/>
                <p:nvPr/>
              </p:nvSpPr>
              <p:spPr>
                <a:xfrm>
                  <a:off x="1049305" y="4776960"/>
                  <a:ext cx="1226556" cy="21075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9" name="文本框 288"/>
                <p:cNvSpPr txBox="1"/>
                <p:nvPr/>
              </p:nvSpPr>
              <p:spPr>
                <a:xfrm>
                  <a:off x="488625" y="4787621"/>
                  <a:ext cx="595856" cy="2420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OA4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318" name="文本框 317"/>
          <p:cNvSpPr txBox="1"/>
          <p:nvPr/>
        </p:nvSpPr>
        <p:spPr>
          <a:xfrm>
            <a:off x="5538927" y="6964525"/>
            <a:ext cx="578485" cy="20005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  <a:sym typeface="+mn-ea"/>
              </a:rPr>
              <a:t>(mg/ml)</a:t>
            </a:r>
            <a:endParaRPr lang="en-US" altLang="zh-CN" sz="700" dirty="0" err="1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319" name="文本框 318"/>
          <p:cNvSpPr txBox="1"/>
          <p:nvPr/>
        </p:nvSpPr>
        <p:spPr>
          <a:xfrm>
            <a:off x="4547748" y="529348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文本框 319"/>
          <p:cNvSpPr txBox="1"/>
          <p:nvPr/>
        </p:nvSpPr>
        <p:spPr>
          <a:xfrm>
            <a:off x="144393" y="7209043"/>
            <a:ext cx="222681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21" name="对象 320"/>
          <p:cNvGraphicFramePr/>
          <p:nvPr/>
        </p:nvGraphicFramePr>
        <p:xfrm>
          <a:off x="504825" y="7289800"/>
          <a:ext cx="1209675" cy="1349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2" name="Prism 9" r:id="rId39" imgW="1409700" imgH="1539240" progId="Prism9.Document">
                  <p:embed/>
                </p:oleObj>
              </mc:Choice>
              <mc:Fallback>
                <p:oleObj name="Prism 9" r:id="rId39" imgW="1409700" imgH="1539240" progId="Prism9.Document">
                  <p:embed/>
                  <p:pic>
                    <p:nvPicPr>
                      <p:cNvPr id="0" name="对象 320"/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504825" y="7289800"/>
                        <a:ext cx="1209675" cy="1349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3" name="文本框 322"/>
          <p:cNvSpPr txBox="1"/>
          <p:nvPr/>
        </p:nvSpPr>
        <p:spPr>
          <a:xfrm rot="16200000">
            <a:off x="44563" y="7655596"/>
            <a:ext cx="78899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200" b="0" i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NCOA4/β-actin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</p:txBody>
      </p:sp>
      <p:grpSp>
        <p:nvGrpSpPr>
          <p:cNvPr id="324" name="组合 323"/>
          <p:cNvGrpSpPr/>
          <p:nvPr/>
        </p:nvGrpSpPr>
        <p:grpSpPr>
          <a:xfrm>
            <a:off x="796617" y="7832772"/>
            <a:ext cx="144000" cy="36000"/>
            <a:chOff x="5133996" y="3642301"/>
            <a:chExt cx="194874" cy="35014"/>
          </a:xfrm>
        </p:grpSpPr>
        <p:cxnSp>
          <p:nvCxnSpPr>
            <p:cNvPr id="325" name="直接连接符 324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6" name="直接连接符 325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7" name="直接连接符 326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8" name="文本框 327"/>
          <p:cNvSpPr txBox="1"/>
          <p:nvPr/>
        </p:nvSpPr>
        <p:spPr>
          <a:xfrm>
            <a:off x="721959" y="7716031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文本框 328"/>
          <p:cNvSpPr txBox="1"/>
          <p:nvPr/>
        </p:nvSpPr>
        <p:spPr>
          <a:xfrm>
            <a:off x="808793" y="7578769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0" name="组合 329"/>
          <p:cNvGrpSpPr/>
          <p:nvPr/>
        </p:nvGrpSpPr>
        <p:grpSpPr>
          <a:xfrm>
            <a:off x="797426" y="7698031"/>
            <a:ext cx="288000" cy="36000"/>
            <a:chOff x="5133996" y="3642301"/>
            <a:chExt cx="194874" cy="35014"/>
          </a:xfrm>
        </p:grpSpPr>
        <p:cxnSp>
          <p:nvCxnSpPr>
            <p:cNvPr id="331" name="直接连接符 330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2" name="直接连接符 331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3" name="直接连接符 332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34" name="文本框 333"/>
          <p:cNvSpPr txBox="1"/>
          <p:nvPr/>
        </p:nvSpPr>
        <p:spPr>
          <a:xfrm rot="16200000">
            <a:off x="1654469" y="7655596"/>
            <a:ext cx="7040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200" b="0" i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FTH1/β-actin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</p:txBody>
      </p:sp>
      <p:graphicFrame>
        <p:nvGraphicFramePr>
          <p:cNvPr id="346" name="对象 345"/>
          <p:cNvGraphicFramePr/>
          <p:nvPr/>
        </p:nvGraphicFramePr>
        <p:xfrm>
          <a:off x="2035175" y="7326313"/>
          <a:ext cx="1316038" cy="1276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5" name="Prism 7" r:id="rId41" imgW="1533525" imgH="1466850" progId="Prism7.Document">
                  <p:embed/>
                </p:oleObj>
              </mc:Choice>
              <mc:Fallback>
                <p:oleObj name="Prism 7" r:id="rId41" imgW="1533525" imgH="1466850" progId="Prism7.Document">
                  <p:embed/>
                  <p:pic>
                    <p:nvPicPr>
                      <p:cNvPr id="0" name="对象 345"/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2035175" y="7326313"/>
                        <a:ext cx="1316038" cy="1276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7" name="对象 346"/>
          <p:cNvGraphicFramePr/>
          <p:nvPr/>
        </p:nvGraphicFramePr>
        <p:xfrm>
          <a:off x="3667125" y="7323138"/>
          <a:ext cx="1230313" cy="1239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6" name="Prism 7" r:id="rId43" imgW="1438275" imgH="1419225" progId="Prism7.Document">
                  <p:embed/>
                </p:oleObj>
              </mc:Choice>
              <mc:Fallback>
                <p:oleObj name="Prism 7" r:id="rId43" imgW="1438275" imgH="1419225" progId="Prism7.Document">
                  <p:embed/>
                  <p:pic>
                    <p:nvPicPr>
                      <p:cNvPr id="0" name="对象 346"/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3667125" y="7323138"/>
                        <a:ext cx="1230313" cy="1239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8" name="文本框 347"/>
          <p:cNvSpPr txBox="1"/>
          <p:nvPr/>
        </p:nvSpPr>
        <p:spPr>
          <a:xfrm rot="16200000">
            <a:off x="3216998" y="7649940"/>
            <a:ext cx="78899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200" b="0" i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NCOA4/β-actin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</p:txBody>
      </p:sp>
      <p:sp>
        <p:nvSpPr>
          <p:cNvPr id="360" name="文本框 359"/>
          <p:cNvSpPr txBox="1"/>
          <p:nvPr/>
        </p:nvSpPr>
        <p:spPr>
          <a:xfrm rot="16200000">
            <a:off x="4759669" y="7649940"/>
            <a:ext cx="7040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200" b="0" i="0">
                <a:solidFill>
                  <a:srgbClr val="44444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defTabSz="458470"/>
            <a:r>
              <a:rPr lang="en-US" altLang="zh-CN" sz="700" dirty="0">
                <a:solidFill>
                  <a:prstClr val="black"/>
                </a:solidFill>
                <a:ea typeface="等线" panose="02010600030101010101" pitchFamily="2" charset="-122"/>
              </a:rPr>
              <a:t>FTH1/β-actin</a:t>
            </a:r>
            <a:endParaRPr lang="en-US" altLang="zh-CN" sz="700" dirty="0">
              <a:solidFill>
                <a:prstClr val="black"/>
              </a:solidFill>
              <a:ea typeface="等线" panose="02010600030101010101" pitchFamily="2" charset="-122"/>
            </a:endParaRPr>
          </a:p>
        </p:txBody>
      </p:sp>
      <p:graphicFrame>
        <p:nvGraphicFramePr>
          <p:cNvPr id="371" name="对象 370"/>
          <p:cNvGraphicFramePr/>
          <p:nvPr/>
        </p:nvGraphicFramePr>
        <p:xfrm>
          <a:off x="5148263" y="7318375"/>
          <a:ext cx="1295400" cy="1241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7" name="Prism 7" r:id="rId45" imgW="1514475" imgH="1419225" progId="Prism7.Document">
                  <p:embed/>
                </p:oleObj>
              </mc:Choice>
              <mc:Fallback>
                <p:oleObj name="Prism 7" r:id="rId45" imgW="1514475" imgH="1419225" progId="Prism7.Document">
                  <p:embed/>
                  <p:pic>
                    <p:nvPicPr>
                      <p:cNvPr id="0" name="对象 370"/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5148263" y="7318375"/>
                        <a:ext cx="1295400" cy="1241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38" name="直接连接符 337"/>
          <p:cNvCxnSpPr/>
          <p:nvPr/>
        </p:nvCxnSpPr>
        <p:spPr>
          <a:xfrm flipV="1">
            <a:off x="1363655" y="7536598"/>
            <a:ext cx="180000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39" name="组合 338"/>
          <p:cNvGrpSpPr/>
          <p:nvPr/>
        </p:nvGrpSpPr>
        <p:grpSpPr>
          <a:xfrm>
            <a:off x="1234504" y="7484632"/>
            <a:ext cx="216000" cy="36000"/>
            <a:chOff x="5133996" y="3642301"/>
            <a:chExt cx="194874" cy="35014"/>
          </a:xfrm>
        </p:grpSpPr>
        <p:cxnSp>
          <p:nvCxnSpPr>
            <p:cNvPr id="340" name="直接连接符 339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1" name="直接连接符 340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2" name="直接连接符 341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43" name="文本框 342"/>
          <p:cNvSpPr txBox="1"/>
          <p:nvPr/>
        </p:nvSpPr>
        <p:spPr>
          <a:xfrm>
            <a:off x="1202311" y="7316240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3" name="组合 382"/>
          <p:cNvGrpSpPr/>
          <p:nvPr/>
        </p:nvGrpSpPr>
        <p:grpSpPr>
          <a:xfrm>
            <a:off x="2406513" y="7610558"/>
            <a:ext cx="144000" cy="36000"/>
            <a:chOff x="5133996" y="3642301"/>
            <a:chExt cx="194874" cy="35014"/>
          </a:xfrm>
        </p:grpSpPr>
        <p:cxnSp>
          <p:nvCxnSpPr>
            <p:cNvPr id="384" name="直接连接符 383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5" name="直接连接符 384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6" name="直接连接符 385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87" name="文本框 386"/>
          <p:cNvSpPr txBox="1"/>
          <p:nvPr/>
        </p:nvSpPr>
        <p:spPr>
          <a:xfrm>
            <a:off x="2331855" y="7493817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8" name="文本框 387"/>
          <p:cNvSpPr txBox="1"/>
          <p:nvPr/>
        </p:nvSpPr>
        <p:spPr>
          <a:xfrm>
            <a:off x="2418689" y="7411325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9" name="组合 388"/>
          <p:cNvGrpSpPr/>
          <p:nvPr/>
        </p:nvGrpSpPr>
        <p:grpSpPr>
          <a:xfrm>
            <a:off x="2407322" y="7530587"/>
            <a:ext cx="288000" cy="36000"/>
            <a:chOff x="5133996" y="3642301"/>
            <a:chExt cx="194874" cy="35014"/>
          </a:xfrm>
        </p:grpSpPr>
        <p:cxnSp>
          <p:nvCxnSpPr>
            <p:cNvPr id="390" name="直接连接符 389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1" name="直接连接符 390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2" name="直接连接符 391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9" name="组合 408"/>
          <p:cNvGrpSpPr/>
          <p:nvPr/>
        </p:nvGrpSpPr>
        <p:grpSpPr>
          <a:xfrm>
            <a:off x="2858384" y="7693050"/>
            <a:ext cx="144000" cy="36000"/>
            <a:chOff x="5133996" y="3642301"/>
            <a:chExt cx="194874" cy="35014"/>
          </a:xfrm>
        </p:grpSpPr>
        <p:cxnSp>
          <p:nvCxnSpPr>
            <p:cNvPr id="410" name="直接连接符 409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1" name="直接连接符 410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2" name="直接连接符 411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13" name="文本框 412"/>
          <p:cNvSpPr txBox="1"/>
          <p:nvPr/>
        </p:nvSpPr>
        <p:spPr>
          <a:xfrm>
            <a:off x="2815476" y="7576309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" name="文本框 413"/>
          <p:cNvSpPr txBox="1"/>
          <p:nvPr/>
        </p:nvSpPr>
        <p:spPr>
          <a:xfrm>
            <a:off x="2899135" y="7493817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5" name="组合 414"/>
          <p:cNvGrpSpPr/>
          <p:nvPr/>
        </p:nvGrpSpPr>
        <p:grpSpPr>
          <a:xfrm>
            <a:off x="2859193" y="7613079"/>
            <a:ext cx="288000" cy="36000"/>
            <a:chOff x="5133996" y="3642301"/>
            <a:chExt cx="194874" cy="35014"/>
          </a:xfrm>
        </p:grpSpPr>
        <p:cxnSp>
          <p:nvCxnSpPr>
            <p:cNvPr id="416" name="直接连接符 415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7" name="直接连接符 416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8" name="直接连接符 417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19" name="组合 418"/>
          <p:cNvGrpSpPr/>
          <p:nvPr/>
        </p:nvGrpSpPr>
        <p:grpSpPr>
          <a:xfrm>
            <a:off x="3973108" y="7723895"/>
            <a:ext cx="144000" cy="36000"/>
            <a:chOff x="5133996" y="3642301"/>
            <a:chExt cx="194874" cy="35014"/>
          </a:xfrm>
        </p:grpSpPr>
        <p:cxnSp>
          <p:nvCxnSpPr>
            <p:cNvPr id="420" name="直接连接符 419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1" name="直接连接符 420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2" name="直接连接符 421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23" name="文本框 422"/>
          <p:cNvSpPr txBox="1"/>
          <p:nvPr/>
        </p:nvSpPr>
        <p:spPr>
          <a:xfrm>
            <a:off x="3898450" y="7607154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4" name="文本框 423"/>
          <p:cNvSpPr txBox="1"/>
          <p:nvPr/>
        </p:nvSpPr>
        <p:spPr>
          <a:xfrm>
            <a:off x="3950597" y="7323820"/>
            <a:ext cx="3736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5" name="组合 424"/>
          <p:cNvGrpSpPr/>
          <p:nvPr/>
        </p:nvGrpSpPr>
        <p:grpSpPr>
          <a:xfrm>
            <a:off x="3973917" y="7458184"/>
            <a:ext cx="288000" cy="36000"/>
            <a:chOff x="5133996" y="3642301"/>
            <a:chExt cx="194874" cy="35014"/>
          </a:xfrm>
        </p:grpSpPr>
        <p:cxnSp>
          <p:nvCxnSpPr>
            <p:cNvPr id="426" name="直接连接符 425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7" name="直接连接符 426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8" name="直接连接符 427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439" name="直接连接符 438"/>
          <p:cNvCxnSpPr/>
          <p:nvPr/>
        </p:nvCxnSpPr>
        <p:spPr>
          <a:xfrm flipV="1">
            <a:off x="4544924" y="7810468"/>
            <a:ext cx="180000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40" name="组合 439"/>
          <p:cNvGrpSpPr/>
          <p:nvPr/>
        </p:nvGrpSpPr>
        <p:grpSpPr>
          <a:xfrm>
            <a:off x="4415773" y="7758502"/>
            <a:ext cx="216000" cy="36000"/>
            <a:chOff x="5133996" y="3642301"/>
            <a:chExt cx="194874" cy="35014"/>
          </a:xfrm>
        </p:grpSpPr>
        <p:cxnSp>
          <p:nvCxnSpPr>
            <p:cNvPr id="441" name="直接连接符 440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2" name="直接连接符 441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3" name="直接连接符 442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44" name="文本框 443"/>
          <p:cNvSpPr txBox="1"/>
          <p:nvPr/>
        </p:nvSpPr>
        <p:spPr>
          <a:xfrm>
            <a:off x="4383580" y="7590110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5" name="组合 444"/>
          <p:cNvGrpSpPr/>
          <p:nvPr/>
        </p:nvGrpSpPr>
        <p:grpSpPr>
          <a:xfrm>
            <a:off x="5514983" y="7627602"/>
            <a:ext cx="144000" cy="36000"/>
            <a:chOff x="5133996" y="3642301"/>
            <a:chExt cx="194874" cy="35014"/>
          </a:xfrm>
        </p:grpSpPr>
        <p:cxnSp>
          <p:nvCxnSpPr>
            <p:cNvPr id="446" name="直接连接符 445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7" name="直接连接符 446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8" name="直接连接符 447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49" name="文本框 448"/>
          <p:cNvSpPr txBox="1"/>
          <p:nvPr/>
        </p:nvSpPr>
        <p:spPr>
          <a:xfrm>
            <a:off x="5440325" y="7510861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0" name="文本框 449"/>
          <p:cNvSpPr txBox="1"/>
          <p:nvPr/>
        </p:nvSpPr>
        <p:spPr>
          <a:xfrm>
            <a:off x="5494345" y="7391710"/>
            <a:ext cx="3736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51" name="组合 450"/>
          <p:cNvGrpSpPr/>
          <p:nvPr/>
        </p:nvGrpSpPr>
        <p:grpSpPr>
          <a:xfrm>
            <a:off x="5517665" y="7526074"/>
            <a:ext cx="288000" cy="36000"/>
            <a:chOff x="5133996" y="3642301"/>
            <a:chExt cx="194874" cy="35014"/>
          </a:xfrm>
        </p:grpSpPr>
        <p:cxnSp>
          <p:nvCxnSpPr>
            <p:cNvPr id="452" name="直接连接符 451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3" name="直接连接符 452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4" name="直接连接符 453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455" name="直接连接符 454"/>
          <p:cNvCxnSpPr/>
          <p:nvPr/>
        </p:nvCxnSpPr>
        <p:spPr>
          <a:xfrm flipV="1">
            <a:off x="6089756" y="7510955"/>
            <a:ext cx="180000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56" name="组合 455"/>
          <p:cNvGrpSpPr/>
          <p:nvPr/>
        </p:nvGrpSpPr>
        <p:grpSpPr>
          <a:xfrm>
            <a:off x="5960605" y="7458989"/>
            <a:ext cx="216000" cy="36000"/>
            <a:chOff x="5133996" y="3642301"/>
            <a:chExt cx="194874" cy="35014"/>
          </a:xfrm>
        </p:grpSpPr>
        <p:cxnSp>
          <p:nvCxnSpPr>
            <p:cNvPr id="457" name="直接连接符 456"/>
            <p:cNvCxnSpPr/>
            <p:nvPr/>
          </p:nvCxnSpPr>
          <p:spPr>
            <a:xfrm flipV="1">
              <a:off x="5134102" y="3642780"/>
              <a:ext cx="19381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8" name="直接连接符 457"/>
            <p:cNvCxnSpPr/>
            <p:nvPr/>
          </p:nvCxnSpPr>
          <p:spPr>
            <a:xfrm flipV="1">
              <a:off x="5328870" y="3642303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9" name="直接连接符 458"/>
            <p:cNvCxnSpPr/>
            <p:nvPr/>
          </p:nvCxnSpPr>
          <p:spPr>
            <a:xfrm flipV="1">
              <a:off x="5133996" y="3642301"/>
              <a:ext cx="0" cy="35012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60" name="文本框 459"/>
          <p:cNvSpPr txBox="1"/>
          <p:nvPr/>
        </p:nvSpPr>
        <p:spPr>
          <a:xfrm>
            <a:off x="5928412" y="7290597"/>
            <a:ext cx="315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1" name="文本框 460"/>
          <p:cNvSpPr txBox="1"/>
          <p:nvPr/>
        </p:nvSpPr>
        <p:spPr>
          <a:xfrm>
            <a:off x="317337" y="8085527"/>
            <a:ext cx="4908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(mg/ml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2" name="文本框 461"/>
          <p:cNvSpPr txBox="1"/>
          <p:nvPr/>
        </p:nvSpPr>
        <p:spPr>
          <a:xfrm>
            <a:off x="1947065" y="8085527"/>
            <a:ext cx="4908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(mg/ml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3" name="文本框 462"/>
          <p:cNvSpPr txBox="1"/>
          <p:nvPr/>
        </p:nvSpPr>
        <p:spPr>
          <a:xfrm>
            <a:off x="3499451" y="8085527"/>
            <a:ext cx="4908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(mg/ml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4" name="文本框 463"/>
          <p:cNvSpPr txBox="1"/>
          <p:nvPr/>
        </p:nvSpPr>
        <p:spPr>
          <a:xfrm>
            <a:off x="5043087" y="8085527"/>
            <a:ext cx="4908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 err="1">
                <a:latin typeface="Arial" panose="020B0604020202020204" pitchFamily="34" charset="0"/>
                <a:cs typeface="Arial" panose="020B0604020202020204" pitchFamily="34" charset="0"/>
              </a:rPr>
              <a:t>Huaier</a:t>
            </a:r>
            <a:endParaRPr lang="en-US" altLang="zh-CN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(mg/ml)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1023</Words>
  <Application>WPS 演示</Application>
  <PresentationFormat>A4 纸张(210x297 毫米)</PresentationFormat>
  <Paragraphs>263</Paragraphs>
  <Slides>1</Slides>
  <Notes>2</Notes>
  <HiddenSlides>0</HiddenSlides>
  <MMClips>0</MMClips>
  <ScaleCrop>false</ScaleCrop>
  <HeadingPairs>
    <vt:vector size="8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2</vt:i4>
      </vt:variant>
      <vt:variant>
        <vt:lpstr>幻灯片标题</vt:lpstr>
      </vt:variant>
      <vt:variant>
        <vt:i4>1</vt:i4>
      </vt:variant>
    </vt:vector>
  </HeadingPairs>
  <TitlesOfParts>
    <vt:vector size="23" baseType="lpstr">
      <vt:lpstr>Arial</vt:lpstr>
      <vt:lpstr>宋体</vt:lpstr>
      <vt:lpstr>Wingdings</vt:lpstr>
      <vt:lpstr>等线</vt:lpstr>
      <vt:lpstr>微软雅黑</vt:lpstr>
      <vt:lpstr>Arial Unicode MS</vt:lpstr>
      <vt:lpstr>等线 Light</vt:lpstr>
      <vt:lpstr>Calibri Light</vt:lpstr>
      <vt:lpstr>Calibri</vt:lpstr>
      <vt:lpstr>Office 主题​​</vt:lpstr>
      <vt:lpstr>Prism7.Document</vt:lpstr>
      <vt:lpstr>Prism7.Document</vt:lpstr>
      <vt:lpstr>Prism7.Document</vt:lpstr>
      <vt:lpstr>Prism7.Document</vt:lpstr>
      <vt:lpstr>Prism7.Document</vt:lpstr>
      <vt:lpstr>Prism7.Document</vt:lpstr>
      <vt:lpstr>Prism7.Document</vt:lpstr>
      <vt:lpstr>Prism7.Document</vt:lpstr>
      <vt:lpstr>Prism7.Document</vt:lpstr>
      <vt:lpstr>Prism7.Document</vt:lpstr>
      <vt:lpstr>Prism7.Document</vt:lpstr>
      <vt:lpstr>Prism9.Document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 star</dc:creator>
  <cp:lastModifiedBy>星星</cp:lastModifiedBy>
  <cp:revision>181</cp:revision>
  <cp:lastPrinted>2023-08-28T08:32:00Z</cp:lastPrinted>
  <dcterms:created xsi:type="dcterms:W3CDTF">2023-03-09T04:00:00Z</dcterms:created>
  <dcterms:modified xsi:type="dcterms:W3CDTF">2025-06-10T01:49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78C81CABE7344A08EE65F877D03DE87_13</vt:lpwstr>
  </property>
  <property fmtid="{D5CDD505-2E9C-101B-9397-08002B2CF9AE}" pid="3" name="KSOProductBuildVer">
    <vt:lpwstr>2052-12.1.0.21541</vt:lpwstr>
  </property>
</Properties>
</file>